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F9783-2D31-481C-9EBC-CA716D5B76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8867C-C2FC-4496-95D8-A30C9B183E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C872A-D6DF-49A5-A8A7-7EE8226D9D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CF974-E00F-477A-AEC7-4B752E17C2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100B3-9832-4384-9C2D-72C85B5304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466A84-7BE0-42CD-879C-0CD2E695DC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DB8CB-9CA6-43A2-910B-556E46CAF6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9DC8B-8D37-40EE-919E-06E8B16EB2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BF383-90AB-4132-9615-2EE6CE7675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B5055-5855-42A9-8E3F-49C043951B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A4B66-9624-4573-9D29-D9F9DCDEA9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2916C-CD2D-4A33-8012-925A217A51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1896A8-C226-43F8-8E7D-31833BC4D42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14"/>
          <p:cNvGrpSpPr/>
          <p:nvPr/>
        </p:nvGrpSpPr>
        <p:grpSpPr>
          <a:xfrm>
            <a:off x="1108080" y="1095120"/>
            <a:ext cx="5276160" cy="2764440"/>
            <a:chOff x="1108080" y="1095120"/>
            <a:chExt cx="5276160" cy="2764440"/>
          </a:xfrm>
        </p:grpSpPr>
        <p:sp>
          <p:nvSpPr>
            <p:cNvPr id="42" name="Line 915"/>
            <p:cNvSpPr/>
            <p:nvPr/>
          </p:nvSpPr>
          <p:spPr>
            <a:xfrm>
              <a:off x="1125000" y="3336840"/>
              <a:ext cx="5145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Line 916"/>
            <p:cNvSpPr/>
            <p:nvPr/>
          </p:nvSpPr>
          <p:spPr>
            <a:xfrm flipV="1">
              <a:off x="11368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Line 917"/>
            <p:cNvSpPr/>
            <p:nvPr/>
          </p:nvSpPr>
          <p:spPr>
            <a:xfrm flipV="1">
              <a:off x="12452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Line 918"/>
            <p:cNvSpPr/>
            <p:nvPr/>
          </p:nvSpPr>
          <p:spPr>
            <a:xfrm flipV="1">
              <a:off x="13532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919"/>
            <p:cNvSpPr/>
            <p:nvPr/>
          </p:nvSpPr>
          <p:spPr>
            <a:xfrm flipV="1">
              <a:off x="14616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Line 920"/>
            <p:cNvSpPr/>
            <p:nvPr/>
          </p:nvSpPr>
          <p:spPr>
            <a:xfrm flipV="1">
              <a:off x="15699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Line 921"/>
            <p:cNvSpPr/>
            <p:nvPr/>
          </p:nvSpPr>
          <p:spPr>
            <a:xfrm flipV="1">
              <a:off x="16779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Line 922"/>
            <p:cNvSpPr/>
            <p:nvPr/>
          </p:nvSpPr>
          <p:spPr>
            <a:xfrm flipV="1">
              <a:off x="17866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Line 923"/>
            <p:cNvSpPr/>
            <p:nvPr/>
          </p:nvSpPr>
          <p:spPr>
            <a:xfrm flipV="1">
              <a:off x="18932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Line 924"/>
            <p:cNvSpPr/>
            <p:nvPr/>
          </p:nvSpPr>
          <p:spPr>
            <a:xfrm flipV="1">
              <a:off x="20030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Line 925"/>
            <p:cNvSpPr/>
            <p:nvPr/>
          </p:nvSpPr>
          <p:spPr>
            <a:xfrm flipV="1">
              <a:off x="21096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926"/>
            <p:cNvSpPr/>
            <p:nvPr/>
          </p:nvSpPr>
          <p:spPr>
            <a:xfrm flipV="1">
              <a:off x="22176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Line 927"/>
            <p:cNvSpPr/>
            <p:nvPr/>
          </p:nvSpPr>
          <p:spPr>
            <a:xfrm flipV="1">
              <a:off x="232632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928"/>
            <p:cNvSpPr/>
            <p:nvPr/>
          </p:nvSpPr>
          <p:spPr>
            <a:xfrm flipV="1">
              <a:off x="24346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Line 929"/>
            <p:cNvSpPr/>
            <p:nvPr/>
          </p:nvSpPr>
          <p:spPr>
            <a:xfrm flipV="1">
              <a:off x="25426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Line 930"/>
            <p:cNvSpPr/>
            <p:nvPr/>
          </p:nvSpPr>
          <p:spPr>
            <a:xfrm flipV="1">
              <a:off x="26510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Line 931"/>
            <p:cNvSpPr/>
            <p:nvPr/>
          </p:nvSpPr>
          <p:spPr>
            <a:xfrm flipV="1">
              <a:off x="27590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932"/>
            <p:cNvSpPr/>
            <p:nvPr/>
          </p:nvSpPr>
          <p:spPr>
            <a:xfrm flipV="1">
              <a:off x="28674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Line 933"/>
            <p:cNvSpPr/>
            <p:nvPr/>
          </p:nvSpPr>
          <p:spPr>
            <a:xfrm flipV="1">
              <a:off x="297432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Line 934"/>
            <p:cNvSpPr/>
            <p:nvPr/>
          </p:nvSpPr>
          <p:spPr>
            <a:xfrm flipV="1">
              <a:off x="30837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Line 935"/>
            <p:cNvSpPr/>
            <p:nvPr/>
          </p:nvSpPr>
          <p:spPr>
            <a:xfrm flipV="1">
              <a:off x="31906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Line 936"/>
            <p:cNvSpPr/>
            <p:nvPr/>
          </p:nvSpPr>
          <p:spPr>
            <a:xfrm flipV="1">
              <a:off x="32990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Line 937"/>
            <p:cNvSpPr/>
            <p:nvPr/>
          </p:nvSpPr>
          <p:spPr>
            <a:xfrm flipV="1">
              <a:off x="34070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Line 938"/>
            <p:cNvSpPr/>
            <p:nvPr/>
          </p:nvSpPr>
          <p:spPr>
            <a:xfrm flipV="1">
              <a:off x="35154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Line 939"/>
            <p:cNvSpPr/>
            <p:nvPr/>
          </p:nvSpPr>
          <p:spPr>
            <a:xfrm flipV="1">
              <a:off x="36234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Line 940"/>
            <p:cNvSpPr/>
            <p:nvPr/>
          </p:nvSpPr>
          <p:spPr>
            <a:xfrm flipV="1">
              <a:off x="37317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Line 941"/>
            <p:cNvSpPr/>
            <p:nvPr/>
          </p:nvSpPr>
          <p:spPr>
            <a:xfrm flipV="1">
              <a:off x="384012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Line 942"/>
            <p:cNvSpPr/>
            <p:nvPr/>
          </p:nvSpPr>
          <p:spPr>
            <a:xfrm flipV="1">
              <a:off x="394812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Line 943"/>
            <p:cNvSpPr/>
            <p:nvPr/>
          </p:nvSpPr>
          <p:spPr>
            <a:xfrm flipV="1">
              <a:off x="40568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Line 944"/>
            <p:cNvSpPr/>
            <p:nvPr/>
          </p:nvSpPr>
          <p:spPr>
            <a:xfrm flipV="1">
              <a:off x="41648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Line 945"/>
            <p:cNvSpPr/>
            <p:nvPr/>
          </p:nvSpPr>
          <p:spPr>
            <a:xfrm flipV="1">
              <a:off x="42714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Line 946"/>
            <p:cNvSpPr/>
            <p:nvPr/>
          </p:nvSpPr>
          <p:spPr>
            <a:xfrm flipV="1">
              <a:off x="43797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Line 947"/>
            <p:cNvSpPr/>
            <p:nvPr/>
          </p:nvSpPr>
          <p:spPr>
            <a:xfrm flipV="1">
              <a:off x="448812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Line 948"/>
            <p:cNvSpPr/>
            <p:nvPr/>
          </p:nvSpPr>
          <p:spPr>
            <a:xfrm flipV="1">
              <a:off x="45964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Line 949"/>
            <p:cNvSpPr/>
            <p:nvPr/>
          </p:nvSpPr>
          <p:spPr>
            <a:xfrm flipV="1">
              <a:off x="47048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Line 950"/>
            <p:cNvSpPr/>
            <p:nvPr/>
          </p:nvSpPr>
          <p:spPr>
            <a:xfrm flipV="1">
              <a:off x="48128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Line 951"/>
            <p:cNvSpPr/>
            <p:nvPr/>
          </p:nvSpPr>
          <p:spPr>
            <a:xfrm flipV="1">
              <a:off x="49212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952"/>
            <p:cNvSpPr/>
            <p:nvPr/>
          </p:nvSpPr>
          <p:spPr>
            <a:xfrm flipV="1">
              <a:off x="50292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Line 953"/>
            <p:cNvSpPr/>
            <p:nvPr/>
          </p:nvSpPr>
          <p:spPr>
            <a:xfrm flipV="1">
              <a:off x="51375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Line 954"/>
            <p:cNvSpPr/>
            <p:nvPr/>
          </p:nvSpPr>
          <p:spPr>
            <a:xfrm flipV="1">
              <a:off x="524592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Line 955"/>
            <p:cNvSpPr/>
            <p:nvPr/>
          </p:nvSpPr>
          <p:spPr>
            <a:xfrm flipV="1">
              <a:off x="53524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Line 956"/>
            <p:cNvSpPr/>
            <p:nvPr/>
          </p:nvSpPr>
          <p:spPr>
            <a:xfrm flipV="1">
              <a:off x="54608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Line 957"/>
            <p:cNvSpPr/>
            <p:nvPr/>
          </p:nvSpPr>
          <p:spPr>
            <a:xfrm flipV="1">
              <a:off x="55692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Line 958"/>
            <p:cNvSpPr/>
            <p:nvPr/>
          </p:nvSpPr>
          <p:spPr>
            <a:xfrm flipV="1">
              <a:off x="567720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Line 959"/>
            <p:cNvSpPr/>
            <p:nvPr/>
          </p:nvSpPr>
          <p:spPr>
            <a:xfrm flipV="1">
              <a:off x="57855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Line 960"/>
            <p:cNvSpPr/>
            <p:nvPr/>
          </p:nvSpPr>
          <p:spPr>
            <a:xfrm flipV="1">
              <a:off x="589356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Line 961"/>
            <p:cNvSpPr/>
            <p:nvPr/>
          </p:nvSpPr>
          <p:spPr>
            <a:xfrm flipV="1">
              <a:off x="600192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Line 962"/>
            <p:cNvSpPr/>
            <p:nvPr/>
          </p:nvSpPr>
          <p:spPr>
            <a:xfrm flipV="1">
              <a:off x="611028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Line 963"/>
            <p:cNvSpPr/>
            <p:nvPr/>
          </p:nvSpPr>
          <p:spPr>
            <a:xfrm flipV="1">
              <a:off x="6218640" y="333648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Rectangle 964"/>
            <p:cNvSpPr/>
            <p:nvPr/>
          </p:nvSpPr>
          <p:spPr>
            <a:xfrm>
              <a:off x="1242720" y="3423240"/>
              <a:ext cx="24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6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Rectangle 965"/>
            <p:cNvSpPr/>
            <p:nvPr/>
          </p:nvSpPr>
          <p:spPr>
            <a:xfrm>
              <a:off x="1780920" y="3423240"/>
              <a:ext cx="24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8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Rectangle 966"/>
            <p:cNvSpPr/>
            <p:nvPr/>
          </p:nvSpPr>
          <p:spPr>
            <a:xfrm>
              <a:off x="2280240" y="34232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Rectangle 967"/>
            <p:cNvSpPr/>
            <p:nvPr/>
          </p:nvSpPr>
          <p:spPr>
            <a:xfrm>
              <a:off x="2817360" y="34232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2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Rectangle 968"/>
            <p:cNvSpPr/>
            <p:nvPr/>
          </p:nvSpPr>
          <p:spPr>
            <a:xfrm>
              <a:off x="3359520" y="34232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4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Rectangle 969"/>
            <p:cNvSpPr/>
            <p:nvPr/>
          </p:nvSpPr>
          <p:spPr>
            <a:xfrm>
              <a:off x="3900960" y="34232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6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Rectangle 970"/>
            <p:cNvSpPr/>
            <p:nvPr/>
          </p:nvSpPr>
          <p:spPr>
            <a:xfrm>
              <a:off x="4442040" y="34232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8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Rectangle 971"/>
            <p:cNvSpPr/>
            <p:nvPr/>
          </p:nvSpPr>
          <p:spPr>
            <a:xfrm>
              <a:off x="4983480" y="34232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0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Rectangle 972"/>
            <p:cNvSpPr/>
            <p:nvPr/>
          </p:nvSpPr>
          <p:spPr>
            <a:xfrm>
              <a:off x="5523120" y="34232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2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Line 973"/>
            <p:cNvSpPr/>
            <p:nvPr/>
          </p:nvSpPr>
          <p:spPr>
            <a:xfrm flipV="1">
              <a:off x="135324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Line 974"/>
            <p:cNvSpPr/>
            <p:nvPr/>
          </p:nvSpPr>
          <p:spPr>
            <a:xfrm flipV="1">
              <a:off x="189324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Line 975"/>
            <p:cNvSpPr/>
            <p:nvPr/>
          </p:nvSpPr>
          <p:spPr>
            <a:xfrm flipV="1">
              <a:off x="243468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Line 976"/>
            <p:cNvSpPr/>
            <p:nvPr/>
          </p:nvSpPr>
          <p:spPr>
            <a:xfrm flipV="1">
              <a:off x="297432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Line 977"/>
            <p:cNvSpPr/>
            <p:nvPr/>
          </p:nvSpPr>
          <p:spPr>
            <a:xfrm flipV="1">
              <a:off x="351540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Line 978"/>
            <p:cNvSpPr/>
            <p:nvPr/>
          </p:nvSpPr>
          <p:spPr>
            <a:xfrm flipV="1">
              <a:off x="405684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Line 979"/>
            <p:cNvSpPr/>
            <p:nvPr/>
          </p:nvSpPr>
          <p:spPr>
            <a:xfrm flipV="1">
              <a:off x="459648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Line 980"/>
            <p:cNvSpPr/>
            <p:nvPr/>
          </p:nvSpPr>
          <p:spPr>
            <a:xfrm flipV="1">
              <a:off x="513756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Line 981"/>
            <p:cNvSpPr/>
            <p:nvPr/>
          </p:nvSpPr>
          <p:spPr>
            <a:xfrm flipV="1">
              <a:off x="567720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Line 982"/>
            <p:cNvSpPr/>
            <p:nvPr/>
          </p:nvSpPr>
          <p:spPr>
            <a:xfrm flipV="1">
              <a:off x="6218640" y="3336480"/>
              <a:ext cx="0" cy="39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Line 983"/>
            <p:cNvSpPr/>
            <p:nvPr/>
          </p:nvSpPr>
          <p:spPr>
            <a:xfrm flipV="1">
              <a:off x="1125000" y="1095480"/>
              <a:ext cx="0" cy="2241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Line 984"/>
            <p:cNvSpPr/>
            <p:nvPr/>
          </p:nvSpPr>
          <p:spPr>
            <a:xfrm>
              <a:off x="1117080" y="33368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Line 985"/>
            <p:cNvSpPr/>
            <p:nvPr/>
          </p:nvSpPr>
          <p:spPr>
            <a:xfrm>
              <a:off x="1117080" y="33051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Line 986"/>
            <p:cNvSpPr/>
            <p:nvPr/>
          </p:nvSpPr>
          <p:spPr>
            <a:xfrm>
              <a:off x="1117080" y="32756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Line 987"/>
            <p:cNvSpPr/>
            <p:nvPr/>
          </p:nvSpPr>
          <p:spPr>
            <a:xfrm>
              <a:off x="1117080" y="32443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Line 988"/>
            <p:cNvSpPr/>
            <p:nvPr/>
          </p:nvSpPr>
          <p:spPr>
            <a:xfrm>
              <a:off x="1117080" y="32140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Line 989"/>
            <p:cNvSpPr/>
            <p:nvPr/>
          </p:nvSpPr>
          <p:spPr>
            <a:xfrm>
              <a:off x="1117080" y="31831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Line 990"/>
            <p:cNvSpPr/>
            <p:nvPr/>
          </p:nvSpPr>
          <p:spPr>
            <a:xfrm>
              <a:off x="1117080" y="31532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Line 991"/>
            <p:cNvSpPr/>
            <p:nvPr/>
          </p:nvSpPr>
          <p:spPr>
            <a:xfrm>
              <a:off x="1117080" y="31219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Line 992"/>
            <p:cNvSpPr/>
            <p:nvPr/>
          </p:nvSpPr>
          <p:spPr>
            <a:xfrm>
              <a:off x="1117080" y="30920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Line 993"/>
            <p:cNvSpPr/>
            <p:nvPr/>
          </p:nvSpPr>
          <p:spPr>
            <a:xfrm>
              <a:off x="1117080" y="30607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Line 994"/>
            <p:cNvSpPr/>
            <p:nvPr/>
          </p:nvSpPr>
          <p:spPr>
            <a:xfrm>
              <a:off x="1117080" y="30308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Line 995"/>
            <p:cNvSpPr/>
            <p:nvPr/>
          </p:nvSpPr>
          <p:spPr>
            <a:xfrm>
              <a:off x="1117080" y="29991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Line 996"/>
            <p:cNvSpPr/>
            <p:nvPr/>
          </p:nvSpPr>
          <p:spPr>
            <a:xfrm>
              <a:off x="1117080" y="29696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Line 997"/>
            <p:cNvSpPr/>
            <p:nvPr/>
          </p:nvSpPr>
          <p:spPr>
            <a:xfrm>
              <a:off x="1117080" y="29383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Line 998"/>
            <p:cNvSpPr/>
            <p:nvPr/>
          </p:nvSpPr>
          <p:spPr>
            <a:xfrm>
              <a:off x="1117080" y="29070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Line 999"/>
            <p:cNvSpPr/>
            <p:nvPr/>
          </p:nvSpPr>
          <p:spPr>
            <a:xfrm>
              <a:off x="1117080" y="28771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Line 1000"/>
            <p:cNvSpPr/>
            <p:nvPr/>
          </p:nvSpPr>
          <p:spPr>
            <a:xfrm>
              <a:off x="1117080" y="28458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Line 1001"/>
            <p:cNvSpPr/>
            <p:nvPr/>
          </p:nvSpPr>
          <p:spPr>
            <a:xfrm>
              <a:off x="1117080" y="28159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Line 1002"/>
            <p:cNvSpPr/>
            <p:nvPr/>
          </p:nvSpPr>
          <p:spPr>
            <a:xfrm>
              <a:off x="1117080" y="27860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Line 1003"/>
            <p:cNvSpPr/>
            <p:nvPr/>
          </p:nvSpPr>
          <p:spPr>
            <a:xfrm>
              <a:off x="1117080" y="27547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Line 1004"/>
            <p:cNvSpPr/>
            <p:nvPr/>
          </p:nvSpPr>
          <p:spPr>
            <a:xfrm>
              <a:off x="1117080" y="27234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Line 1005"/>
            <p:cNvSpPr/>
            <p:nvPr/>
          </p:nvSpPr>
          <p:spPr>
            <a:xfrm>
              <a:off x="1117080" y="26935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Line 1006"/>
            <p:cNvSpPr/>
            <p:nvPr/>
          </p:nvSpPr>
          <p:spPr>
            <a:xfrm>
              <a:off x="1117080" y="26622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Line 1007"/>
            <p:cNvSpPr/>
            <p:nvPr/>
          </p:nvSpPr>
          <p:spPr>
            <a:xfrm>
              <a:off x="1117080" y="26323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Line 1008"/>
            <p:cNvSpPr/>
            <p:nvPr/>
          </p:nvSpPr>
          <p:spPr>
            <a:xfrm>
              <a:off x="1117080" y="26010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Line 1009"/>
            <p:cNvSpPr/>
            <p:nvPr/>
          </p:nvSpPr>
          <p:spPr>
            <a:xfrm>
              <a:off x="1117080" y="25711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Line 1010"/>
            <p:cNvSpPr/>
            <p:nvPr/>
          </p:nvSpPr>
          <p:spPr>
            <a:xfrm>
              <a:off x="1117080" y="25398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Line 1011"/>
            <p:cNvSpPr/>
            <p:nvPr/>
          </p:nvSpPr>
          <p:spPr>
            <a:xfrm>
              <a:off x="1117080" y="25099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Line 1012"/>
            <p:cNvSpPr/>
            <p:nvPr/>
          </p:nvSpPr>
          <p:spPr>
            <a:xfrm>
              <a:off x="1117080" y="24786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Line 1013"/>
            <p:cNvSpPr/>
            <p:nvPr/>
          </p:nvSpPr>
          <p:spPr>
            <a:xfrm>
              <a:off x="1117080" y="24487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Line 1014"/>
            <p:cNvSpPr/>
            <p:nvPr/>
          </p:nvSpPr>
          <p:spPr>
            <a:xfrm>
              <a:off x="1117080" y="24174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Line 1015"/>
            <p:cNvSpPr/>
            <p:nvPr/>
          </p:nvSpPr>
          <p:spPr>
            <a:xfrm>
              <a:off x="1117080" y="23875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Line 1016"/>
            <p:cNvSpPr/>
            <p:nvPr/>
          </p:nvSpPr>
          <p:spPr>
            <a:xfrm>
              <a:off x="1117080" y="23562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Line 1017"/>
            <p:cNvSpPr/>
            <p:nvPr/>
          </p:nvSpPr>
          <p:spPr>
            <a:xfrm>
              <a:off x="1117080" y="23266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Line 1018"/>
            <p:cNvSpPr/>
            <p:nvPr/>
          </p:nvSpPr>
          <p:spPr>
            <a:xfrm>
              <a:off x="1117080" y="22950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Line 1019"/>
            <p:cNvSpPr/>
            <p:nvPr/>
          </p:nvSpPr>
          <p:spPr>
            <a:xfrm>
              <a:off x="1117080" y="22651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Line 1020"/>
            <p:cNvSpPr/>
            <p:nvPr/>
          </p:nvSpPr>
          <p:spPr>
            <a:xfrm>
              <a:off x="1117080" y="22338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Line 1021"/>
            <p:cNvSpPr/>
            <p:nvPr/>
          </p:nvSpPr>
          <p:spPr>
            <a:xfrm>
              <a:off x="1117080" y="22039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Line 1022"/>
            <p:cNvSpPr/>
            <p:nvPr/>
          </p:nvSpPr>
          <p:spPr>
            <a:xfrm>
              <a:off x="1117080" y="21726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Line 1023"/>
            <p:cNvSpPr/>
            <p:nvPr/>
          </p:nvSpPr>
          <p:spPr>
            <a:xfrm>
              <a:off x="1117080" y="21427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Line 1024"/>
            <p:cNvSpPr/>
            <p:nvPr/>
          </p:nvSpPr>
          <p:spPr>
            <a:xfrm>
              <a:off x="1117080" y="21117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Line 1025"/>
            <p:cNvSpPr/>
            <p:nvPr/>
          </p:nvSpPr>
          <p:spPr>
            <a:xfrm>
              <a:off x="1117080" y="20815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Line 1026"/>
            <p:cNvSpPr/>
            <p:nvPr/>
          </p:nvSpPr>
          <p:spPr>
            <a:xfrm>
              <a:off x="1117080" y="20502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Line 1027"/>
            <p:cNvSpPr/>
            <p:nvPr/>
          </p:nvSpPr>
          <p:spPr>
            <a:xfrm>
              <a:off x="1117080" y="20206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Line 1028"/>
            <p:cNvSpPr/>
            <p:nvPr/>
          </p:nvSpPr>
          <p:spPr>
            <a:xfrm>
              <a:off x="1117080" y="19890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Line 1029"/>
            <p:cNvSpPr/>
            <p:nvPr/>
          </p:nvSpPr>
          <p:spPr>
            <a:xfrm>
              <a:off x="1117080" y="19594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Line 1030"/>
            <p:cNvSpPr/>
            <p:nvPr/>
          </p:nvSpPr>
          <p:spPr>
            <a:xfrm>
              <a:off x="1117080" y="19278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Line 1031"/>
            <p:cNvSpPr/>
            <p:nvPr/>
          </p:nvSpPr>
          <p:spPr>
            <a:xfrm>
              <a:off x="1117080" y="18979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Line 1032"/>
            <p:cNvSpPr/>
            <p:nvPr/>
          </p:nvSpPr>
          <p:spPr>
            <a:xfrm>
              <a:off x="1117080" y="18666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Line 1033"/>
            <p:cNvSpPr/>
            <p:nvPr/>
          </p:nvSpPr>
          <p:spPr>
            <a:xfrm>
              <a:off x="1117080" y="18352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Line 1034"/>
            <p:cNvSpPr/>
            <p:nvPr/>
          </p:nvSpPr>
          <p:spPr>
            <a:xfrm>
              <a:off x="1117080" y="18057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Line 1035"/>
            <p:cNvSpPr/>
            <p:nvPr/>
          </p:nvSpPr>
          <p:spPr>
            <a:xfrm>
              <a:off x="1117080" y="17740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Line 1036"/>
            <p:cNvSpPr/>
            <p:nvPr/>
          </p:nvSpPr>
          <p:spPr>
            <a:xfrm>
              <a:off x="1117080" y="17445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Line 1037"/>
            <p:cNvSpPr/>
            <p:nvPr/>
          </p:nvSpPr>
          <p:spPr>
            <a:xfrm>
              <a:off x="1117080" y="17146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Line 1038"/>
            <p:cNvSpPr/>
            <p:nvPr/>
          </p:nvSpPr>
          <p:spPr>
            <a:xfrm>
              <a:off x="1117080" y="16830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Line 1039"/>
            <p:cNvSpPr/>
            <p:nvPr/>
          </p:nvSpPr>
          <p:spPr>
            <a:xfrm>
              <a:off x="1117080" y="16516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Line 1040"/>
            <p:cNvSpPr/>
            <p:nvPr/>
          </p:nvSpPr>
          <p:spPr>
            <a:xfrm>
              <a:off x="1117080" y="16218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Line 1041"/>
            <p:cNvSpPr/>
            <p:nvPr/>
          </p:nvSpPr>
          <p:spPr>
            <a:xfrm>
              <a:off x="1117080" y="15908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Line 1042"/>
            <p:cNvSpPr/>
            <p:nvPr/>
          </p:nvSpPr>
          <p:spPr>
            <a:xfrm>
              <a:off x="1117080" y="15606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Line 1043"/>
            <p:cNvSpPr/>
            <p:nvPr/>
          </p:nvSpPr>
          <p:spPr>
            <a:xfrm>
              <a:off x="1117080" y="15296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Line 1044"/>
            <p:cNvSpPr/>
            <p:nvPr/>
          </p:nvSpPr>
          <p:spPr>
            <a:xfrm>
              <a:off x="1117080" y="14997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Line 1045"/>
            <p:cNvSpPr/>
            <p:nvPr/>
          </p:nvSpPr>
          <p:spPr>
            <a:xfrm>
              <a:off x="1117080" y="14680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Line 1046"/>
            <p:cNvSpPr/>
            <p:nvPr/>
          </p:nvSpPr>
          <p:spPr>
            <a:xfrm>
              <a:off x="1117080" y="14385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Line 1047"/>
            <p:cNvSpPr/>
            <p:nvPr/>
          </p:nvSpPr>
          <p:spPr>
            <a:xfrm>
              <a:off x="1117080" y="14068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Line 1048"/>
            <p:cNvSpPr/>
            <p:nvPr/>
          </p:nvSpPr>
          <p:spPr>
            <a:xfrm>
              <a:off x="1117080" y="13773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Line 1049"/>
            <p:cNvSpPr/>
            <p:nvPr/>
          </p:nvSpPr>
          <p:spPr>
            <a:xfrm>
              <a:off x="1117080" y="13456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Line 1050"/>
            <p:cNvSpPr/>
            <p:nvPr/>
          </p:nvSpPr>
          <p:spPr>
            <a:xfrm>
              <a:off x="1117080" y="13158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Line 1051"/>
            <p:cNvSpPr/>
            <p:nvPr/>
          </p:nvSpPr>
          <p:spPr>
            <a:xfrm>
              <a:off x="1117080" y="12848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Line 1052"/>
            <p:cNvSpPr/>
            <p:nvPr/>
          </p:nvSpPr>
          <p:spPr>
            <a:xfrm>
              <a:off x="1117080" y="12546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Line 1053"/>
            <p:cNvSpPr/>
            <p:nvPr/>
          </p:nvSpPr>
          <p:spPr>
            <a:xfrm>
              <a:off x="1117080" y="12236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Line 1054"/>
            <p:cNvSpPr/>
            <p:nvPr/>
          </p:nvSpPr>
          <p:spPr>
            <a:xfrm>
              <a:off x="1117080" y="11937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Line 1055"/>
            <p:cNvSpPr/>
            <p:nvPr/>
          </p:nvSpPr>
          <p:spPr>
            <a:xfrm>
              <a:off x="1117080" y="11624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Line 1056"/>
            <p:cNvSpPr/>
            <p:nvPr/>
          </p:nvSpPr>
          <p:spPr>
            <a:xfrm>
              <a:off x="1117080" y="11325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Line 1057"/>
            <p:cNvSpPr/>
            <p:nvPr/>
          </p:nvSpPr>
          <p:spPr>
            <a:xfrm>
              <a:off x="1117080" y="11008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Line 1058"/>
            <p:cNvSpPr/>
            <p:nvPr/>
          </p:nvSpPr>
          <p:spPr>
            <a:xfrm>
              <a:off x="1108080" y="333684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Line 1059"/>
            <p:cNvSpPr/>
            <p:nvPr/>
          </p:nvSpPr>
          <p:spPr>
            <a:xfrm>
              <a:off x="1108080" y="318312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Line 1060"/>
            <p:cNvSpPr/>
            <p:nvPr/>
          </p:nvSpPr>
          <p:spPr>
            <a:xfrm>
              <a:off x="1108080" y="303084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Line 1061"/>
            <p:cNvSpPr/>
            <p:nvPr/>
          </p:nvSpPr>
          <p:spPr>
            <a:xfrm>
              <a:off x="1108080" y="287712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Line 1062"/>
            <p:cNvSpPr/>
            <p:nvPr/>
          </p:nvSpPr>
          <p:spPr>
            <a:xfrm>
              <a:off x="1108080" y="272340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Line 1063"/>
            <p:cNvSpPr/>
            <p:nvPr/>
          </p:nvSpPr>
          <p:spPr>
            <a:xfrm>
              <a:off x="1108080" y="257112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Line 1064"/>
            <p:cNvSpPr/>
            <p:nvPr/>
          </p:nvSpPr>
          <p:spPr>
            <a:xfrm>
              <a:off x="1108080" y="241740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Line 1065"/>
            <p:cNvSpPr/>
            <p:nvPr/>
          </p:nvSpPr>
          <p:spPr>
            <a:xfrm>
              <a:off x="1108080" y="226512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Line 1066"/>
            <p:cNvSpPr/>
            <p:nvPr/>
          </p:nvSpPr>
          <p:spPr>
            <a:xfrm>
              <a:off x="1108080" y="211176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Line 1067"/>
            <p:cNvSpPr/>
            <p:nvPr/>
          </p:nvSpPr>
          <p:spPr>
            <a:xfrm>
              <a:off x="1108080" y="195948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Line 1068"/>
            <p:cNvSpPr/>
            <p:nvPr/>
          </p:nvSpPr>
          <p:spPr>
            <a:xfrm>
              <a:off x="1108080" y="180576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Line 1069"/>
            <p:cNvSpPr/>
            <p:nvPr/>
          </p:nvSpPr>
          <p:spPr>
            <a:xfrm>
              <a:off x="1108080" y="165168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Line 1070"/>
            <p:cNvSpPr/>
            <p:nvPr/>
          </p:nvSpPr>
          <p:spPr>
            <a:xfrm>
              <a:off x="1108080" y="149976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Line 1071"/>
            <p:cNvSpPr/>
            <p:nvPr/>
          </p:nvSpPr>
          <p:spPr>
            <a:xfrm>
              <a:off x="1108080" y="134568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Line 1072"/>
            <p:cNvSpPr/>
            <p:nvPr/>
          </p:nvSpPr>
          <p:spPr>
            <a:xfrm>
              <a:off x="1108080" y="119376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Freeform 1073"/>
            <p:cNvSpPr/>
            <p:nvPr/>
          </p:nvSpPr>
          <p:spPr>
            <a:xfrm flipV="1">
              <a:off x="1125000" y="1094400"/>
              <a:ext cx="5145480" cy="2235240"/>
            </a:xfrm>
            <a:custGeom>
              <a:avLst/>
              <a:gdLst>
                <a:gd name="textAreaLeft" fmla="*/ 0 w 5145480"/>
                <a:gd name="textAreaRight" fmla="*/ 5145480 w 5145480"/>
                <a:gd name="textAreaTop" fmla="*/ -360 h 2235240"/>
                <a:gd name="textAreaBottom" fmla="*/ 2235240 h 2235240"/>
              </a:gdLst>
              <a:ahLst/>
              <a:rect l="textAreaLeft" t="textAreaTop" r="textAreaRight" b="textAreaBottom"/>
              <a:pathLst>
                <a:path w="8926" h="7130">
                  <a:moveTo>
                    <a:pt x="0" y="64"/>
                  </a:moveTo>
                  <a:lnTo>
                    <a:pt x="2" y="64"/>
                  </a:lnTo>
                  <a:lnTo>
                    <a:pt x="7" y="79"/>
                  </a:lnTo>
                  <a:lnTo>
                    <a:pt x="12" y="78"/>
                  </a:lnTo>
                  <a:lnTo>
                    <a:pt x="17" y="73"/>
                  </a:lnTo>
                  <a:lnTo>
                    <a:pt x="23" y="59"/>
                  </a:lnTo>
                  <a:lnTo>
                    <a:pt x="28" y="56"/>
                  </a:lnTo>
                  <a:lnTo>
                    <a:pt x="33" y="59"/>
                  </a:lnTo>
                  <a:lnTo>
                    <a:pt x="39" y="51"/>
                  </a:lnTo>
                  <a:lnTo>
                    <a:pt x="44" y="46"/>
                  </a:lnTo>
                  <a:lnTo>
                    <a:pt x="49" y="35"/>
                  </a:lnTo>
                  <a:lnTo>
                    <a:pt x="55" y="32"/>
                  </a:lnTo>
                  <a:lnTo>
                    <a:pt x="60" y="30"/>
                  </a:lnTo>
                  <a:lnTo>
                    <a:pt x="65" y="29"/>
                  </a:lnTo>
                  <a:lnTo>
                    <a:pt x="71" y="30"/>
                  </a:lnTo>
                  <a:lnTo>
                    <a:pt x="76" y="28"/>
                  </a:lnTo>
                  <a:lnTo>
                    <a:pt x="81" y="29"/>
                  </a:lnTo>
                  <a:lnTo>
                    <a:pt x="86" y="28"/>
                  </a:lnTo>
                  <a:lnTo>
                    <a:pt x="92" y="28"/>
                  </a:lnTo>
                  <a:lnTo>
                    <a:pt x="97" y="27"/>
                  </a:lnTo>
                  <a:lnTo>
                    <a:pt x="102" y="28"/>
                  </a:lnTo>
                  <a:lnTo>
                    <a:pt x="108" y="27"/>
                  </a:lnTo>
                  <a:lnTo>
                    <a:pt x="113" y="24"/>
                  </a:lnTo>
                  <a:lnTo>
                    <a:pt x="118" y="25"/>
                  </a:lnTo>
                  <a:lnTo>
                    <a:pt x="124" y="24"/>
                  </a:lnTo>
                  <a:lnTo>
                    <a:pt x="129" y="23"/>
                  </a:lnTo>
                  <a:lnTo>
                    <a:pt x="134" y="23"/>
                  </a:lnTo>
                  <a:lnTo>
                    <a:pt x="140" y="34"/>
                  </a:lnTo>
                  <a:lnTo>
                    <a:pt x="145" y="40"/>
                  </a:lnTo>
                  <a:lnTo>
                    <a:pt x="150" y="26"/>
                  </a:lnTo>
                  <a:lnTo>
                    <a:pt x="155" y="24"/>
                  </a:lnTo>
                  <a:lnTo>
                    <a:pt x="161" y="24"/>
                  </a:lnTo>
                  <a:lnTo>
                    <a:pt x="166" y="25"/>
                  </a:lnTo>
                  <a:lnTo>
                    <a:pt x="171" y="26"/>
                  </a:lnTo>
                  <a:lnTo>
                    <a:pt x="177" y="28"/>
                  </a:lnTo>
                  <a:lnTo>
                    <a:pt x="182" y="28"/>
                  </a:lnTo>
                  <a:lnTo>
                    <a:pt x="187" y="24"/>
                  </a:lnTo>
                  <a:lnTo>
                    <a:pt x="193" y="24"/>
                  </a:lnTo>
                  <a:lnTo>
                    <a:pt x="198" y="25"/>
                  </a:lnTo>
                  <a:lnTo>
                    <a:pt x="203" y="31"/>
                  </a:lnTo>
                  <a:lnTo>
                    <a:pt x="209" y="28"/>
                  </a:lnTo>
                  <a:lnTo>
                    <a:pt x="214" y="26"/>
                  </a:lnTo>
                  <a:lnTo>
                    <a:pt x="219" y="28"/>
                  </a:lnTo>
                  <a:lnTo>
                    <a:pt x="224" y="26"/>
                  </a:lnTo>
                  <a:lnTo>
                    <a:pt x="230" y="26"/>
                  </a:lnTo>
                  <a:lnTo>
                    <a:pt x="235" y="27"/>
                  </a:lnTo>
                  <a:lnTo>
                    <a:pt x="240" y="27"/>
                  </a:lnTo>
                  <a:lnTo>
                    <a:pt x="246" y="27"/>
                  </a:lnTo>
                  <a:lnTo>
                    <a:pt x="251" y="29"/>
                  </a:lnTo>
                  <a:lnTo>
                    <a:pt x="256" y="29"/>
                  </a:lnTo>
                  <a:lnTo>
                    <a:pt x="262" y="30"/>
                  </a:lnTo>
                  <a:lnTo>
                    <a:pt x="267" y="31"/>
                  </a:lnTo>
                  <a:lnTo>
                    <a:pt x="272" y="31"/>
                  </a:lnTo>
                  <a:lnTo>
                    <a:pt x="278" y="28"/>
                  </a:lnTo>
                  <a:lnTo>
                    <a:pt x="283" y="29"/>
                  </a:lnTo>
                  <a:lnTo>
                    <a:pt x="288" y="30"/>
                  </a:lnTo>
                  <a:lnTo>
                    <a:pt x="293" y="32"/>
                  </a:lnTo>
                  <a:lnTo>
                    <a:pt x="299" y="37"/>
                  </a:lnTo>
                  <a:lnTo>
                    <a:pt x="304" y="28"/>
                  </a:lnTo>
                  <a:lnTo>
                    <a:pt x="309" y="29"/>
                  </a:lnTo>
                  <a:lnTo>
                    <a:pt x="315" y="33"/>
                  </a:lnTo>
                  <a:lnTo>
                    <a:pt x="320" y="29"/>
                  </a:lnTo>
                  <a:lnTo>
                    <a:pt x="325" y="23"/>
                  </a:lnTo>
                  <a:lnTo>
                    <a:pt x="331" y="23"/>
                  </a:lnTo>
                  <a:lnTo>
                    <a:pt x="336" y="24"/>
                  </a:lnTo>
                  <a:lnTo>
                    <a:pt x="341" y="28"/>
                  </a:lnTo>
                  <a:lnTo>
                    <a:pt x="347" y="47"/>
                  </a:lnTo>
                  <a:lnTo>
                    <a:pt x="352" y="46"/>
                  </a:lnTo>
                  <a:lnTo>
                    <a:pt x="357" y="27"/>
                  </a:lnTo>
                  <a:lnTo>
                    <a:pt x="362" y="26"/>
                  </a:lnTo>
                  <a:lnTo>
                    <a:pt x="368" y="25"/>
                  </a:lnTo>
                  <a:lnTo>
                    <a:pt x="373" y="24"/>
                  </a:lnTo>
                  <a:lnTo>
                    <a:pt x="378" y="22"/>
                  </a:lnTo>
                  <a:lnTo>
                    <a:pt x="384" y="23"/>
                  </a:lnTo>
                  <a:lnTo>
                    <a:pt x="389" y="27"/>
                  </a:lnTo>
                  <a:lnTo>
                    <a:pt x="394" y="32"/>
                  </a:lnTo>
                  <a:lnTo>
                    <a:pt x="400" y="28"/>
                  </a:lnTo>
                  <a:lnTo>
                    <a:pt x="405" y="26"/>
                  </a:lnTo>
                  <a:lnTo>
                    <a:pt x="410" y="27"/>
                  </a:lnTo>
                  <a:lnTo>
                    <a:pt x="416" y="26"/>
                  </a:lnTo>
                  <a:lnTo>
                    <a:pt x="421" y="28"/>
                  </a:lnTo>
                  <a:lnTo>
                    <a:pt x="426" y="30"/>
                  </a:lnTo>
                  <a:lnTo>
                    <a:pt x="431" y="32"/>
                  </a:lnTo>
                  <a:lnTo>
                    <a:pt x="437" y="37"/>
                  </a:lnTo>
                  <a:lnTo>
                    <a:pt x="442" y="34"/>
                  </a:lnTo>
                  <a:lnTo>
                    <a:pt x="447" y="33"/>
                  </a:lnTo>
                  <a:lnTo>
                    <a:pt x="453" y="34"/>
                  </a:lnTo>
                  <a:lnTo>
                    <a:pt x="458" y="33"/>
                  </a:lnTo>
                  <a:lnTo>
                    <a:pt x="463" y="33"/>
                  </a:lnTo>
                  <a:lnTo>
                    <a:pt x="469" y="37"/>
                  </a:lnTo>
                  <a:lnTo>
                    <a:pt x="474" y="41"/>
                  </a:lnTo>
                  <a:lnTo>
                    <a:pt x="479" y="27"/>
                  </a:lnTo>
                  <a:lnTo>
                    <a:pt x="485" y="30"/>
                  </a:lnTo>
                  <a:lnTo>
                    <a:pt x="490" y="76"/>
                  </a:lnTo>
                  <a:lnTo>
                    <a:pt x="495" y="48"/>
                  </a:lnTo>
                  <a:lnTo>
                    <a:pt x="500" y="23"/>
                  </a:lnTo>
                  <a:lnTo>
                    <a:pt x="506" y="26"/>
                  </a:lnTo>
                  <a:lnTo>
                    <a:pt x="511" y="24"/>
                  </a:lnTo>
                  <a:lnTo>
                    <a:pt x="516" y="19"/>
                  </a:lnTo>
                  <a:lnTo>
                    <a:pt x="522" y="19"/>
                  </a:lnTo>
                  <a:lnTo>
                    <a:pt x="527" y="20"/>
                  </a:lnTo>
                  <a:lnTo>
                    <a:pt x="532" y="20"/>
                  </a:lnTo>
                  <a:lnTo>
                    <a:pt x="538" y="19"/>
                  </a:lnTo>
                  <a:lnTo>
                    <a:pt x="543" y="19"/>
                  </a:lnTo>
                  <a:lnTo>
                    <a:pt x="548" y="22"/>
                  </a:lnTo>
                  <a:lnTo>
                    <a:pt x="554" y="26"/>
                  </a:lnTo>
                  <a:lnTo>
                    <a:pt x="559" y="30"/>
                  </a:lnTo>
                  <a:lnTo>
                    <a:pt x="564" y="28"/>
                  </a:lnTo>
                  <a:lnTo>
                    <a:pt x="569" y="23"/>
                  </a:lnTo>
                  <a:lnTo>
                    <a:pt x="575" y="20"/>
                  </a:lnTo>
                  <a:lnTo>
                    <a:pt x="580" y="19"/>
                  </a:lnTo>
                  <a:lnTo>
                    <a:pt x="585" y="20"/>
                  </a:lnTo>
                  <a:lnTo>
                    <a:pt x="591" y="23"/>
                  </a:lnTo>
                  <a:lnTo>
                    <a:pt x="596" y="20"/>
                  </a:lnTo>
                  <a:lnTo>
                    <a:pt x="601" y="19"/>
                  </a:lnTo>
                  <a:lnTo>
                    <a:pt x="607" y="19"/>
                  </a:lnTo>
                  <a:lnTo>
                    <a:pt x="612" y="19"/>
                  </a:lnTo>
                  <a:lnTo>
                    <a:pt x="617" y="19"/>
                  </a:lnTo>
                  <a:lnTo>
                    <a:pt x="623" y="17"/>
                  </a:lnTo>
                  <a:lnTo>
                    <a:pt x="628" y="17"/>
                  </a:lnTo>
                  <a:lnTo>
                    <a:pt x="633" y="17"/>
                  </a:lnTo>
                  <a:lnTo>
                    <a:pt x="638" y="17"/>
                  </a:lnTo>
                  <a:lnTo>
                    <a:pt x="644" y="18"/>
                  </a:lnTo>
                  <a:lnTo>
                    <a:pt x="649" y="18"/>
                  </a:lnTo>
                  <a:lnTo>
                    <a:pt x="654" y="18"/>
                  </a:lnTo>
                  <a:lnTo>
                    <a:pt x="660" y="17"/>
                  </a:lnTo>
                  <a:lnTo>
                    <a:pt x="665" y="16"/>
                  </a:lnTo>
                  <a:lnTo>
                    <a:pt x="670" y="18"/>
                  </a:lnTo>
                  <a:lnTo>
                    <a:pt x="676" y="17"/>
                  </a:lnTo>
                  <a:lnTo>
                    <a:pt x="681" y="17"/>
                  </a:lnTo>
                  <a:lnTo>
                    <a:pt x="686" y="16"/>
                  </a:lnTo>
                  <a:lnTo>
                    <a:pt x="692" y="16"/>
                  </a:lnTo>
                  <a:lnTo>
                    <a:pt x="697" y="16"/>
                  </a:lnTo>
                  <a:lnTo>
                    <a:pt x="702" y="17"/>
                  </a:lnTo>
                  <a:lnTo>
                    <a:pt x="707" y="17"/>
                  </a:lnTo>
                  <a:lnTo>
                    <a:pt x="713" y="16"/>
                  </a:lnTo>
                  <a:lnTo>
                    <a:pt x="718" y="18"/>
                  </a:lnTo>
                  <a:lnTo>
                    <a:pt x="723" y="18"/>
                  </a:lnTo>
                  <a:lnTo>
                    <a:pt x="729" y="18"/>
                  </a:lnTo>
                  <a:lnTo>
                    <a:pt x="734" y="17"/>
                  </a:lnTo>
                  <a:lnTo>
                    <a:pt x="739" y="18"/>
                  </a:lnTo>
                  <a:lnTo>
                    <a:pt x="745" y="19"/>
                  </a:lnTo>
                  <a:lnTo>
                    <a:pt x="750" y="20"/>
                  </a:lnTo>
                  <a:lnTo>
                    <a:pt x="755" y="17"/>
                  </a:lnTo>
                  <a:lnTo>
                    <a:pt x="761" y="18"/>
                  </a:lnTo>
                  <a:lnTo>
                    <a:pt x="766" y="19"/>
                  </a:lnTo>
                  <a:lnTo>
                    <a:pt x="771" y="20"/>
                  </a:lnTo>
                  <a:lnTo>
                    <a:pt x="776" y="18"/>
                  </a:lnTo>
                  <a:lnTo>
                    <a:pt x="782" y="17"/>
                  </a:lnTo>
                  <a:lnTo>
                    <a:pt x="787" y="17"/>
                  </a:lnTo>
                  <a:lnTo>
                    <a:pt x="792" y="18"/>
                  </a:lnTo>
                  <a:lnTo>
                    <a:pt x="798" y="18"/>
                  </a:lnTo>
                  <a:lnTo>
                    <a:pt x="803" y="18"/>
                  </a:lnTo>
                  <a:lnTo>
                    <a:pt x="808" y="19"/>
                  </a:lnTo>
                  <a:lnTo>
                    <a:pt x="814" y="19"/>
                  </a:lnTo>
                  <a:lnTo>
                    <a:pt x="819" y="19"/>
                  </a:lnTo>
                  <a:lnTo>
                    <a:pt x="824" y="19"/>
                  </a:lnTo>
                  <a:lnTo>
                    <a:pt x="830" y="21"/>
                  </a:lnTo>
                  <a:lnTo>
                    <a:pt x="835" y="19"/>
                  </a:lnTo>
                  <a:lnTo>
                    <a:pt x="840" y="21"/>
                  </a:lnTo>
                  <a:lnTo>
                    <a:pt x="845" y="21"/>
                  </a:lnTo>
                  <a:lnTo>
                    <a:pt x="851" y="22"/>
                  </a:lnTo>
                  <a:lnTo>
                    <a:pt x="856" y="20"/>
                  </a:lnTo>
                  <a:lnTo>
                    <a:pt x="861" y="21"/>
                  </a:lnTo>
                  <a:lnTo>
                    <a:pt x="867" y="22"/>
                  </a:lnTo>
                  <a:lnTo>
                    <a:pt x="872" y="25"/>
                  </a:lnTo>
                  <a:lnTo>
                    <a:pt x="877" y="30"/>
                  </a:lnTo>
                  <a:lnTo>
                    <a:pt x="883" y="33"/>
                  </a:lnTo>
                  <a:lnTo>
                    <a:pt x="888" y="31"/>
                  </a:lnTo>
                  <a:lnTo>
                    <a:pt x="893" y="29"/>
                  </a:lnTo>
                  <a:lnTo>
                    <a:pt x="899" y="28"/>
                  </a:lnTo>
                  <a:lnTo>
                    <a:pt x="904" y="30"/>
                  </a:lnTo>
                  <a:lnTo>
                    <a:pt x="909" y="30"/>
                  </a:lnTo>
                  <a:lnTo>
                    <a:pt x="914" y="33"/>
                  </a:lnTo>
                  <a:lnTo>
                    <a:pt x="920" y="46"/>
                  </a:lnTo>
                  <a:lnTo>
                    <a:pt x="925" y="69"/>
                  </a:lnTo>
                  <a:lnTo>
                    <a:pt x="930" y="34"/>
                  </a:lnTo>
                  <a:lnTo>
                    <a:pt x="936" y="23"/>
                  </a:lnTo>
                  <a:lnTo>
                    <a:pt x="941" y="22"/>
                  </a:lnTo>
                  <a:lnTo>
                    <a:pt x="946" y="24"/>
                  </a:lnTo>
                  <a:lnTo>
                    <a:pt x="952" y="22"/>
                  </a:lnTo>
                  <a:lnTo>
                    <a:pt x="957" y="22"/>
                  </a:lnTo>
                  <a:lnTo>
                    <a:pt x="962" y="24"/>
                  </a:lnTo>
                  <a:lnTo>
                    <a:pt x="968" y="22"/>
                  </a:lnTo>
                  <a:lnTo>
                    <a:pt x="973" y="19"/>
                  </a:lnTo>
                  <a:lnTo>
                    <a:pt x="978" y="19"/>
                  </a:lnTo>
                  <a:lnTo>
                    <a:pt x="983" y="19"/>
                  </a:lnTo>
                  <a:lnTo>
                    <a:pt x="989" y="18"/>
                  </a:lnTo>
                  <a:lnTo>
                    <a:pt x="994" y="20"/>
                  </a:lnTo>
                  <a:lnTo>
                    <a:pt x="999" y="19"/>
                  </a:lnTo>
                  <a:lnTo>
                    <a:pt x="1005" y="19"/>
                  </a:lnTo>
                  <a:lnTo>
                    <a:pt x="1010" y="22"/>
                  </a:lnTo>
                  <a:lnTo>
                    <a:pt x="1015" y="19"/>
                  </a:lnTo>
                  <a:lnTo>
                    <a:pt x="1021" y="21"/>
                  </a:lnTo>
                  <a:lnTo>
                    <a:pt x="1026" y="20"/>
                  </a:lnTo>
                  <a:lnTo>
                    <a:pt x="1031" y="21"/>
                  </a:lnTo>
                  <a:lnTo>
                    <a:pt x="1037" y="20"/>
                  </a:lnTo>
                  <a:lnTo>
                    <a:pt x="1042" y="22"/>
                  </a:lnTo>
                  <a:lnTo>
                    <a:pt x="1047" y="21"/>
                  </a:lnTo>
                  <a:lnTo>
                    <a:pt x="1052" y="17"/>
                  </a:lnTo>
                  <a:lnTo>
                    <a:pt x="1058" y="17"/>
                  </a:lnTo>
                  <a:lnTo>
                    <a:pt x="1063" y="16"/>
                  </a:lnTo>
                  <a:lnTo>
                    <a:pt x="1068" y="15"/>
                  </a:lnTo>
                  <a:lnTo>
                    <a:pt x="1074" y="15"/>
                  </a:lnTo>
                  <a:lnTo>
                    <a:pt x="1079" y="16"/>
                  </a:lnTo>
                  <a:lnTo>
                    <a:pt x="1084" y="15"/>
                  </a:lnTo>
                  <a:lnTo>
                    <a:pt x="1090" y="17"/>
                  </a:lnTo>
                  <a:lnTo>
                    <a:pt x="1095" y="18"/>
                  </a:lnTo>
                  <a:lnTo>
                    <a:pt x="1100" y="19"/>
                  </a:lnTo>
                  <a:lnTo>
                    <a:pt x="1106" y="30"/>
                  </a:lnTo>
                  <a:lnTo>
                    <a:pt x="1111" y="43"/>
                  </a:lnTo>
                  <a:lnTo>
                    <a:pt x="1116" y="25"/>
                  </a:lnTo>
                  <a:lnTo>
                    <a:pt x="1121" y="17"/>
                  </a:lnTo>
                  <a:lnTo>
                    <a:pt x="1127" y="19"/>
                  </a:lnTo>
                  <a:lnTo>
                    <a:pt x="1132" y="24"/>
                  </a:lnTo>
                  <a:lnTo>
                    <a:pt x="1137" y="21"/>
                  </a:lnTo>
                  <a:lnTo>
                    <a:pt x="1143" y="23"/>
                  </a:lnTo>
                  <a:lnTo>
                    <a:pt x="1148" y="37"/>
                  </a:lnTo>
                  <a:lnTo>
                    <a:pt x="1153" y="31"/>
                  </a:lnTo>
                  <a:lnTo>
                    <a:pt x="1159" y="20"/>
                  </a:lnTo>
                  <a:lnTo>
                    <a:pt x="1164" y="21"/>
                  </a:lnTo>
                  <a:lnTo>
                    <a:pt x="1169" y="20"/>
                  </a:lnTo>
                  <a:lnTo>
                    <a:pt x="1175" y="18"/>
                  </a:lnTo>
                  <a:lnTo>
                    <a:pt x="1180" y="16"/>
                  </a:lnTo>
                  <a:lnTo>
                    <a:pt x="1185" y="15"/>
                  </a:lnTo>
                  <a:lnTo>
                    <a:pt x="1190" y="21"/>
                  </a:lnTo>
                  <a:lnTo>
                    <a:pt x="1196" y="23"/>
                  </a:lnTo>
                  <a:lnTo>
                    <a:pt x="1201" y="21"/>
                  </a:lnTo>
                  <a:lnTo>
                    <a:pt x="1206" y="20"/>
                  </a:lnTo>
                  <a:lnTo>
                    <a:pt x="1212" y="20"/>
                  </a:lnTo>
                  <a:lnTo>
                    <a:pt x="1217" y="19"/>
                  </a:lnTo>
                  <a:lnTo>
                    <a:pt x="1222" y="17"/>
                  </a:lnTo>
                  <a:lnTo>
                    <a:pt x="1228" y="16"/>
                  </a:lnTo>
                  <a:lnTo>
                    <a:pt x="1233" y="17"/>
                  </a:lnTo>
                  <a:lnTo>
                    <a:pt x="1238" y="15"/>
                  </a:lnTo>
                  <a:lnTo>
                    <a:pt x="1244" y="19"/>
                  </a:lnTo>
                  <a:lnTo>
                    <a:pt x="1249" y="31"/>
                  </a:lnTo>
                  <a:lnTo>
                    <a:pt x="1254" y="28"/>
                  </a:lnTo>
                  <a:lnTo>
                    <a:pt x="1259" y="24"/>
                  </a:lnTo>
                  <a:lnTo>
                    <a:pt x="1265" y="21"/>
                  </a:lnTo>
                  <a:lnTo>
                    <a:pt x="1270" y="20"/>
                  </a:lnTo>
                  <a:lnTo>
                    <a:pt x="1275" y="18"/>
                  </a:lnTo>
                  <a:lnTo>
                    <a:pt x="1281" y="16"/>
                  </a:lnTo>
                  <a:lnTo>
                    <a:pt x="1286" y="16"/>
                  </a:lnTo>
                  <a:lnTo>
                    <a:pt x="1291" y="15"/>
                  </a:lnTo>
                  <a:lnTo>
                    <a:pt x="1297" y="13"/>
                  </a:lnTo>
                  <a:lnTo>
                    <a:pt x="1302" y="15"/>
                  </a:lnTo>
                  <a:lnTo>
                    <a:pt x="1307" y="16"/>
                  </a:lnTo>
                  <a:lnTo>
                    <a:pt x="1313" y="15"/>
                  </a:lnTo>
                  <a:lnTo>
                    <a:pt x="1318" y="19"/>
                  </a:lnTo>
                  <a:lnTo>
                    <a:pt x="1323" y="18"/>
                  </a:lnTo>
                  <a:lnTo>
                    <a:pt x="1328" y="17"/>
                  </a:lnTo>
                  <a:lnTo>
                    <a:pt x="1334" y="18"/>
                  </a:lnTo>
                  <a:lnTo>
                    <a:pt x="1339" y="29"/>
                  </a:lnTo>
                  <a:lnTo>
                    <a:pt x="1344" y="55"/>
                  </a:lnTo>
                  <a:lnTo>
                    <a:pt x="1350" y="42"/>
                  </a:lnTo>
                  <a:lnTo>
                    <a:pt x="1355" y="23"/>
                  </a:lnTo>
                  <a:lnTo>
                    <a:pt x="1360" y="21"/>
                  </a:lnTo>
                  <a:lnTo>
                    <a:pt x="1366" y="19"/>
                  </a:lnTo>
                  <a:lnTo>
                    <a:pt x="1371" y="19"/>
                  </a:lnTo>
                  <a:lnTo>
                    <a:pt x="1376" y="18"/>
                  </a:lnTo>
                  <a:lnTo>
                    <a:pt x="1382" y="15"/>
                  </a:lnTo>
                  <a:lnTo>
                    <a:pt x="1387" y="13"/>
                  </a:lnTo>
                  <a:lnTo>
                    <a:pt x="1392" y="14"/>
                  </a:lnTo>
                  <a:lnTo>
                    <a:pt x="1397" y="15"/>
                  </a:lnTo>
                  <a:lnTo>
                    <a:pt x="1403" y="15"/>
                  </a:lnTo>
                  <a:lnTo>
                    <a:pt x="1408" y="16"/>
                  </a:lnTo>
                  <a:lnTo>
                    <a:pt x="1413" y="16"/>
                  </a:lnTo>
                  <a:lnTo>
                    <a:pt x="1419" y="14"/>
                  </a:lnTo>
                  <a:lnTo>
                    <a:pt x="1424" y="13"/>
                  </a:lnTo>
                  <a:lnTo>
                    <a:pt x="1429" y="15"/>
                  </a:lnTo>
                  <a:lnTo>
                    <a:pt x="1435" y="12"/>
                  </a:lnTo>
                  <a:lnTo>
                    <a:pt x="1440" y="12"/>
                  </a:lnTo>
                  <a:lnTo>
                    <a:pt x="1445" y="14"/>
                  </a:lnTo>
                  <a:lnTo>
                    <a:pt x="1451" y="13"/>
                  </a:lnTo>
                  <a:lnTo>
                    <a:pt x="1456" y="16"/>
                  </a:lnTo>
                  <a:lnTo>
                    <a:pt x="1461" y="57"/>
                  </a:lnTo>
                  <a:lnTo>
                    <a:pt x="1466" y="58"/>
                  </a:lnTo>
                  <a:lnTo>
                    <a:pt x="1472" y="34"/>
                  </a:lnTo>
                  <a:lnTo>
                    <a:pt x="1477" y="22"/>
                  </a:lnTo>
                  <a:lnTo>
                    <a:pt x="1482" y="19"/>
                  </a:lnTo>
                  <a:lnTo>
                    <a:pt x="1488" y="15"/>
                  </a:lnTo>
                  <a:lnTo>
                    <a:pt x="1493" y="17"/>
                  </a:lnTo>
                  <a:lnTo>
                    <a:pt x="1498" y="17"/>
                  </a:lnTo>
                  <a:lnTo>
                    <a:pt x="1504" y="16"/>
                  </a:lnTo>
                  <a:lnTo>
                    <a:pt x="1509" y="14"/>
                  </a:lnTo>
                  <a:lnTo>
                    <a:pt x="1514" y="16"/>
                  </a:lnTo>
                  <a:lnTo>
                    <a:pt x="1520" y="22"/>
                  </a:lnTo>
                  <a:lnTo>
                    <a:pt x="1525" y="21"/>
                  </a:lnTo>
                  <a:lnTo>
                    <a:pt x="1530" y="17"/>
                  </a:lnTo>
                  <a:lnTo>
                    <a:pt x="1535" y="17"/>
                  </a:lnTo>
                  <a:lnTo>
                    <a:pt x="1541" y="14"/>
                  </a:lnTo>
                  <a:lnTo>
                    <a:pt x="1546" y="14"/>
                  </a:lnTo>
                  <a:lnTo>
                    <a:pt x="1551" y="14"/>
                  </a:lnTo>
                  <a:lnTo>
                    <a:pt x="1557" y="12"/>
                  </a:lnTo>
                  <a:lnTo>
                    <a:pt x="1562" y="12"/>
                  </a:lnTo>
                  <a:lnTo>
                    <a:pt x="1567" y="12"/>
                  </a:lnTo>
                  <a:lnTo>
                    <a:pt x="1573" y="13"/>
                  </a:lnTo>
                  <a:lnTo>
                    <a:pt x="1578" y="19"/>
                  </a:lnTo>
                  <a:lnTo>
                    <a:pt x="1583" y="21"/>
                  </a:lnTo>
                  <a:lnTo>
                    <a:pt x="1589" y="16"/>
                  </a:lnTo>
                  <a:lnTo>
                    <a:pt x="1594" y="13"/>
                  </a:lnTo>
                  <a:lnTo>
                    <a:pt x="1599" y="14"/>
                  </a:lnTo>
                  <a:lnTo>
                    <a:pt x="1604" y="13"/>
                  </a:lnTo>
                  <a:lnTo>
                    <a:pt x="1610" y="13"/>
                  </a:lnTo>
                  <a:lnTo>
                    <a:pt x="1615" y="14"/>
                  </a:lnTo>
                  <a:lnTo>
                    <a:pt x="1620" y="18"/>
                  </a:lnTo>
                  <a:lnTo>
                    <a:pt x="1626" y="27"/>
                  </a:lnTo>
                  <a:lnTo>
                    <a:pt x="1631" y="24"/>
                  </a:lnTo>
                  <a:lnTo>
                    <a:pt x="1636" y="20"/>
                  </a:lnTo>
                  <a:lnTo>
                    <a:pt x="1642" y="15"/>
                  </a:lnTo>
                  <a:lnTo>
                    <a:pt x="1647" y="15"/>
                  </a:lnTo>
                  <a:lnTo>
                    <a:pt x="1652" y="17"/>
                  </a:lnTo>
                  <a:lnTo>
                    <a:pt x="1658" y="14"/>
                  </a:lnTo>
                  <a:lnTo>
                    <a:pt x="1663" y="11"/>
                  </a:lnTo>
                  <a:lnTo>
                    <a:pt x="1668" y="12"/>
                  </a:lnTo>
                  <a:lnTo>
                    <a:pt x="1673" y="11"/>
                  </a:lnTo>
                  <a:lnTo>
                    <a:pt x="1679" y="11"/>
                  </a:lnTo>
                  <a:lnTo>
                    <a:pt x="1684" y="11"/>
                  </a:lnTo>
                  <a:lnTo>
                    <a:pt x="1689" y="11"/>
                  </a:lnTo>
                  <a:lnTo>
                    <a:pt x="1695" y="9"/>
                  </a:lnTo>
                  <a:lnTo>
                    <a:pt x="1700" y="9"/>
                  </a:lnTo>
                  <a:lnTo>
                    <a:pt x="1705" y="9"/>
                  </a:lnTo>
                  <a:lnTo>
                    <a:pt x="1711" y="9"/>
                  </a:lnTo>
                  <a:lnTo>
                    <a:pt x="1716" y="10"/>
                  </a:lnTo>
                  <a:lnTo>
                    <a:pt x="1721" y="9"/>
                  </a:lnTo>
                  <a:lnTo>
                    <a:pt x="1727" y="9"/>
                  </a:lnTo>
                  <a:lnTo>
                    <a:pt x="1732" y="9"/>
                  </a:lnTo>
                  <a:lnTo>
                    <a:pt x="1737" y="11"/>
                  </a:lnTo>
                  <a:lnTo>
                    <a:pt x="1742" y="27"/>
                  </a:lnTo>
                  <a:lnTo>
                    <a:pt x="1748" y="38"/>
                  </a:lnTo>
                  <a:lnTo>
                    <a:pt x="1753" y="26"/>
                  </a:lnTo>
                  <a:lnTo>
                    <a:pt x="1758" y="21"/>
                  </a:lnTo>
                  <a:lnTo>
                    <a:pt x="1764" y="16"/>
                  </a:lnTo>
                  <a:lnTo>
                    <a:pt x="1769" y="12"/>
                  </a:lnTo>
                  <a:lnTo>
                    <a:pt x="1774" y="11"/>
                  </a:lnTo>
                  <a:lnTo>
                    <a:pt x="1780" y="11"/>
                  </a:lnTo>
                  <a:lnTo>
                    <a:pt x="1785" y="11"/>
                  </a:lnTo>
                  <a:lnTo>
                    <a:pt x="1790" y="11"/>
                  </a:lnTo>
                  <a:lnTo>
                    <a:pt x="1796" y="11"/>
                  </a:lnTo>
                  <a:lnTo>
                    <a:pt x="1801" y="11"/>
                  </a:lnTo>
                  <a:lnTo>
                    <a:pt x="1806" y="13"/>
                  </a:lnTo>
                  <a:lnTo>
                    <a:pt x="1811" y="12"/>
                  </a:lnTo>
                  <a:lnTo>
                    <a:pt x="1817" y="12"/>
                  </a:lnTo>
                  <a:lnTo>
                    <a:pt x="1822" y="13"/>
                  </a:lnTo>
                  <a:lnTo>
                    <a:pt x="1827" y="10"/>
                  </a:lnTo>
                  <a:lnTo>
                    <a:pt x="1833" y="8"/>
                  </a:lnTo>
                  <a:lnTo>
                    <a:pt x="1838" y="8"/>
                  </a:lnTo>
                  <a:lnTo>
                    <a:pt x="1843" y="8"/>
                  </a:lnTo>
                  <a:lnTo>
                    <a:pt x="1849" y="10"/>
                  </a:lnTo>
                  <a:lnTo>
                    <a:pt x="1854" y="9"/>
                  </a:lnTo>
                  <a:lnTo>
                    <a:pt x="1859" y="9"/>
                  </a:lnTo>
                  <a:lnTo>
                    <a:pt x="1865" y="10"/>
                  </a:lnTo>
                  <a:lnTo>
                    <a:pt x="1870" y="11"/>
                  </a:lnTo>
                  <a:lnTo>
                    <a:pt x="1875" y="13"/>
                  </a:lnTo>
                  <a:lnTo>
                    <a:pt x="1880" y="11"/>
                  </a:lnTo>
                  <a:lnTo>
                    <a:pt x="1886" y="11"/>
                  </a:lnTo>
                  <a:lnTo>
                    <a:pt x="1891" y="11"/>
                  </a:lnTo>
                  <a:lnTo>
                    <a:pt x="1896" y="15"/>
                  </a:lnTo>
                  <a:lnTo>
                    <a:pt x="1902" y="13"/>
                  </a:lnTo>
                  <a:lnTo>
                    <a:pt x="1907" y="11"/>
                  </a:lnTo>
                  <a:lnTo>
                    <a:pt x="1912" y="11"/>
                  </a:lnTo>
                  <a:lnTo>
                    <a:pt x="1918" y="13"/>
                  </a:lnTo>
                  <a:lnTo>
                    <a:pt x="1923" y="10"/>
                  </a:lnTo>
                  <a:lnTo>
                    <a:pt x="1928" y="8"/>
                  </a:lnTo>
                  <a:lnTo>
                    <a:pt x="1934" y="9"/>
                  </a:lnTo>
                  <a:lnTo>
                    <a:pt x="1939" y="11"/>
                  </a:lnTo>
                  <a:lnTo>
                    <a:pt x="1944" y="10"/>
                  </a:lnTo>
                  <a:lnTo>
                    <a:pt x="1949" y="11"/>
                  </a:lnTo>
                  <a:lnTo>
                    <a:pt x="1955" y="14"/>
                  </a:lnTo>
                  <a:lnTo>
                    <a:pt x="1960" y="17"/>
                  </a:lnTo>
                  <a:lnTo>
                    <a:pt x="1965" y="18"/>
                  </a:lnTo>
                  <a:lnTo>
                    <a:pt x="1971" y="20"/>
                  </a:lnTo>
                  <a:lnTo>
                    <a:pt x="1976" y="24"/>
                  </a:lnTo>
                  <a:lnTo>
                    <a:pt x="1981" y="25"/>
                  </a:lnTo>
                  <a:lnTo>
                    <a:pt x="1987" y="25"/>
                  </a:lnTo>
                  <a:lnTo>
                    <a:pt x="1992" y="28"/>
                  </a:lnTo>
                  <a:lnTo>
                    <a:pt x="1997" y="27"/>
                  </a:lnTo>
                  <a:lnTo>
                    <a:pt x="2003" y="27"/>
                  </a:lnTo>
                  <a:lnTo>
                    <a:pt x="2008" y="41"/>
                  </a:lnTo>
                  <a:lnTo>
                    <a:pt x="2013" y="58"/>
                  </a:lnTo>
                  <a:lnTo>
                    <a:pt x="2018" y="31"/>
                  </a:lnTo>
                  <a:lnTo>
                    <a:pt x="2024" y="16"/>
                  </a:lnTo>
                  <a:lnTo>
                    <a:pt x="2029" y="11"/>
                  </a:lnTo>
                  <a:lnTo>
                    <a:pt x="2034" y="8"/>
                  </a:lnTo>
                  <a:lnTo>
                    <a:pt x="2040" y="9"/>
                  </a:lnTo>
                  <a:lnTo>
                    <a:pt x="2045" y="10"/>
                  </a:lnTo>
                  <a:lnTo>
                    <a:pt x="2050" y="12"/>
                  </a:lnTo>
                  <a:lnTo>
                    <a:pt x="2056" y="11"/>
                  </a:lnTo>
                  <a:lnTo>
                    <a:pt x="2061" y="10"/>
                  </a:lnTo>
                  <a:lnTo>
                    <a:pt x="2066" y="8"/>
                  </a:lnTo>
                  <a:lnTo>
                    <a:pt x="2072" y="9"/>
                  </a:lnTo>
                  <a:lnTo>
                    <a:pt x="2077" y="9"/>
                  </a:lnTo>
                  <a:lnTo>
                    <a:pt x="2082" y="12"/>
                  </a:lnTo>
                  <a:lnTo>
                    <a:pt x="2087" y="14"/>
                  </a:lnTo>
                  <a:lnTo>
                    <a:pt x="2093" y="12"/>
                  </a:lnTo>
                  <a:lnTo>
                    <a:pt x="2098" y="8"/>
                  </a:lnTo>
                  <a:lnTo>
                    <a:pt x="2103" y="10"/>
                  </a:lnTo>
                  <a:lnTo>
                    <a:pt x="2109" y="11"/>
                  </a:lnTo>
                  <a:lnTo>
                    <a:pt x="2114" y="7"/>
                  </a:lnTo>
                  <a:lnTo>
                    <a:pt x="2119" y="7"/>
                  </a:lnTo>
                  <a:lnTo>
                    <a:pt x="2125" y="8"/>
                  </a:lnTo>
                  <a:lnTo>
                    <a:pt x="2130" y="7"/>
                  </a:lnTo>
                  <a:lnTo>
                    <a:pt x="2135" y="6"/>
                  </a:lnTo>
                  <a:lnTo>
                    <a:pt x="2141" y="8"/>
                  </a:lnTo>
                  <a:lnTo>
                    <a:pt x="2146" y="8"/>
                  </a:lnTo>
                  <a:lnTo>
                    <a:pt x="2151" y="6"/>
                  </a:lnTo>
                  <a:lnTo>
                    <a:pt x="2156" y="6"/>
                  </a:lnTo>
                  <a:lnTo>
                    <a:pt x="2162" y="6"/>
                  </a:lnTo>
                  <a:lnTo>
                    <a:pt x="2167" y="6"/>
                  </a:lnTo>
                  <a:lnTo>
                    <a:pt x="2172" y="6"/>
                  </a:lnTo>
                  <a:lnTo>
                    <a:pt x="2178" y="11"/>
                  </a:lnTo>
                  <a:lnTo>
                    <a:pt x="2183" y="17"/>
                  </a:lnTo>
                  <a:lnTo>
                    <a:pt x="2188" y="14"/>
                  </a:lnTo>
                  <a:lnTo>
                    <a:pt x="2194" y="11"/>
                  </a:lnTo>
                  <a:lnTo>
                    <a:pt x="2199" y="11"/>
                  </a:lnTo>
                  <a:lnTo>
                    <a:pt x="2204" y="11"/>
                  </a:lnTo>
                  <a:lnTo>
                    <a:pt x="2210" y="12"/>
                  </a:lnTo>
                  <a:lnTo>
                    <a:pt x="2215" y="12"/>
                  </a:lnTo>
                  <a:lnTo>
                    <a:pt x="2220" y="9"/>
                  </a:lnTo>
                  <a:lnTo>
                    <a:pt x="2225" y="6"/>
                  </a:lnTo>
                  <a:lnTo>
                    <a:pt x="2231" y="7"/>
                  </a:lnTo>
                  <a:lnTo>
                    <a:pt x="2236" y="8"/>
                  </a:lnTo>
                  <a:lnTo>
                    <a:pt x="2241" y="10"/>
                  </a:lnTo>
                  <a:lnTo>
                    <a:pt x="2247" y="8"/>
                  </a:lnTo>
                  <a:lnTo>
                    <a:pt x="2252" y="8"/>
                  </a:lnTo>
                  <a:lnTo>
                    <a:pt x="2257" y="8"/>
                  </a:lnTo>
                  <a:lnTo>
                    <a:pt x="2263" y="9"/>
                  </a:lnTo>
                  <a:lnTo>
                    <a:pt x="2268" y="16"/>
                  </a:lnTo>
                  <a:lnTo>
                    <a:pt x="2273" y="23"/>
                  </a:lnTo>
                  <a:lnTo>
                    <a:pt x="2279" y="20"/>
                  </a:lnTo>
                  <a:lnTo>
                    <a:pt x="2284" y="15"/>
                  </a:lnTo>
                  <a:lnTo>
                    <a:pt x="2289" y="13"/>
                  </a:lnTo>
                  <a:lnTo>
                    <a:pt x="2294" y="12"/>
                  </a:lnTo>
                  <a:lnTo>
                    <a:pt x="2300" y="13"/>
                  </a:lnTo>
                  <a:lnTo>
                    <a:pt x="2305" y="12"/>
                  </a:lnTo>
                  <a:lnTo>
                    <a:pt x="2310" y="11"/>
                  </a:lnTo>
                  <a:lnTo>
                    <a:pt x="2316" y="10"/>
                  </a:lnTo>
                  <a:lnTo>
                    <a:pt x="2321" y="11"/>
                  </a:lnTo>
                  <a:lnTo>
                    <a:pt x="2326" y="10"/>
                  </a:lnTo>
                  <a:lnTo>
                    <a:pt x="2332" y="10"/>
                  </a:lnTo>
                  <a:lnTo>
                    <a:pt x="2337" y="12"/>
                  </a:lnTo>
                  <a:lnTo>
                    <a:pt x="2342" y="12"/>
                  </a:lnTo>
                  <a:lnTo>
                    <a:pt x="2348" y="12"/>
                  </a:lnTo>
                  <a:lnTo>
                    <a:pt x="2353" y="11"/>
                  </a:lnTo>
                  <a:lnTo>
                    <a:pt x="2358" y="10"/>
                  </a:lnTo>
                  <a:lnTo>
                    <a:pt x="2363" y="11"/>
                  </a:lnTo>
                  <a:lnTo>
                    <a:pt x="2369" y="11"/>
                  </a:lnTo>
                  <a:lnTo>
                    <a:pt x="2374" y="13"/>
                  </a:lnTo>
                  <a:lnTo>
                    <a:pt x="2379" y="16"/>
                  </a:lnTo>
                  <a:lnTo>
                    <a:pt x="2385" y="18"/>
                  </a:lnTo>
                  <a:lnTo>
                    <a:pt x="2390" y="15"/>
                  </a:lnTo>
                  <a:lnTo>
                    <a:pt x="2395" y="12"/>
                  </a:lnTo>
                  <a:lnTo>
                    <a:pt x="2401" y="13"/>
                  </a:lnTo>
                  <a:lnTo>
                    <a:pt x="2406" y="13"/>
                  </a:lnTo>
                  <a:lnTo>
                    <a:pt x="2411" y="12"/>
                  </a:lnTo>
                  <a:lnTo>
                    <a:pt x="2417" y="21"/>
                  </a:lnTo>
                  <a:lnTo>
                    <a:pt x="2422" y="41"/>
                  </a:lnTo>
                  <a:lnTo>
                    <a:pt x="2427" y="37"/>
                  </a:lnTo>
                  <a:lnTo>
                    <a:pt x="2432" y="22"/>
                  </a:lnTo>
                  <a:lnTo>
                    <a:pt x="2438" y="16"/>
                  </a:lnTo>
                  <a:lnTo>
                    <a:pt x="2443" y="13"/>
                  </a:lnTo>
                  <a:lnTo>
                    <a:pt x="2448" y="12"/>
                  </a:lnTo>
                  <a:lnTo>
                    <a:pt x="2454" y="10"/>
                  </a:lnTo>
                  <a:lnTo>
                    <a:pt x="2459" y="11"/>
                  </a:lnTo>
                  <a:lnTo>
                    <a:pt x="2464" y="10"/>
                  </a:lnTo>
                  <a:lnTo>
                    <a:pt x="2470" y="11"/>
                  </a:lnTo>
                  <a:lnTo>
                    <a:pt x="2475" y="10"/>
                  </a:lnTo>
                  <a:lnTo>
                    <a:pt x="2480" y="14"/>
                  </a:lnTo>
                  <a:lnTo>
                    <a:pt x="2486" y="16"/>
                  </a:lnTo>
                  <a:lnTo>
                    <a:pt x="2491" y="14"/>
                  </a:lnTo>
                  <a:lnTo>
                    <a:pt x="2496" y="12"/>
                  </a:lnTo>
                  <a:lnTo>
                    <a:pt x="2501" y="11"/>
                  </a:lnTo>
                  <a:lnTo>
                    <a:pt x="2507" y="15"/>
                  </a:lnTo>
                  <a:lnTo>
                    <a:pt x="2512" y="38"/>
                  </a:lnTo>
                  <a:lnTo>
                    <a:pt x="2517" y="46"/>
                  </a:lnTo>
                  <a:lnTo>
                    <a:pt x="2523" y="30"/>
                  </a:lnTo>
                  <a:lnTo>
                    <a:pt x="2528" y="19"/>
                  </a:lnTo>
                  <a:lnTo>
                    <a:pt x="2533" y="19"/>
                  </a:lnTo>
                  <a:lnTo>
                    <a:pt x="2539" y="18"/>
                  </a:lnTo>
                  <a:lnTo>
                    <a:pt x="2544" y="16"/>
                  </a:lnTo>
                  <a:lnTo>
                    <a:pt x="2549" y="13"/>
                  </a:lnTo>
                  <a:lnTo>
                    <a:pt x="2555" y="12"/>
                  </a:lnTo>
                  <a:lnTo>
                    <a:pt x="2560" y="9"/>
                  </a:lnTo>
                  <a:lnTo>
                    <a:pt x="2565" y="10"/>
                  </a:lnTo>
                  <a:lnTo>
                    <a:pt x="2570" y="10"/>
                  </a:lnTo>
                  <a:lnTo>
                    <a:pt x="2576" y="12"/>
                  </a:lnTo>
                  <a:lnTo>
                    <a:pt x="2581" y="9"/>
                  </a:lnTo>
                  <a:lnTo>
                    <a:pt x="2586" y="7"/>
                  </a:lnTo>
                  <a:lnTo>
                    <a:pt x="2592" y="9"/>
                  </a:lnTo>
                  <a:lnTo>
                    <a:pt x="2597" y="9"/>
                  </a:lnTo>
                  <a:lnTo>
                    <a:pt x="2602" y="9"/>
                  </a:lnTo>
                  <a:lnTo>
                    <a:pt x="2608" y="9"/>
                  </a:lnTo>
                  <a:lnTo>
                    <a:pt x="2613" y="8"/>
                  </a:lnTo>
                  <a:lnTo>
                    <a:pt x="2618" y="10"/>
                  </a:lnTo>
                  <a:lnTo>
                    <a:pt x="2624" y="29"/>
                  </a:lnTo>
                  <a:lnTo>
                    <a:pt x="2629" y="37"/>
                  </a:lnTo>
                  <a:lnTo>
                    <a:pt x="2634" y="24"/>
                  </a:lnTo>
                  <a:lnTo>
                    <a:pt x="2639" y="15"/>
                  </a:lnTo>
                  <a:lnTo>
                    <a:pt x="2645" y="14"/>
                  </a:lnTo>
                  <a:lnTo>
                    <a:pt x="2650" y="15"/>
                  </a:lnTo>
                  <a:lnTo>
                    <a:pt x="2655" y="13"/>
                  </a:lnTo>
                  <a:lnTo>
                    <a:pt x="2661" y="9"/>
                  </a:lnTo>
                  <a:lnTo>
                    <a:pt x="2666" y="10"/>
                  </a:lnTo>
                  <a:lnTo>
                    <a:pt x="2671" y="10"/>
                  </a:lnTo>
                  <a:lnTo>
                    <a:pt x="2677" y="10"/>
                  </a:lnTo>
                  <a:lnTo>
                    <a:pt x="2682" y="11"/>
                  </a:lnTo>
                  <a:lnTo>
                    <a:pt x="2687" y="16"/>
                  </a:lnTo>
                  <a:lnTo>
                    <a:pt x="2693" y="19"/>
                  </a:lnTo>
                  <a:lnTo>
                    <a:pt x="2698" y="11"/>
                  </a:lnTo>
                  <a:lnTo>
                    <a:pt x="2703" y="7"/>
                  </a:lnTo>
                  <a:lnTo>
                    <a:pt x="2708" y="7"/>
                  </a:lnTo>
                  <a:lnTo>
                    <a:pt x="2714" y="10"/>
                  </a:lnTo>
                  <a:lnTo>
                    <a:pt x="2719" y="12"/>
                  </a:lnTo>
                  <a:lnTo>
                    <a:pt x="2724" y="9"/>
                  </a:lnTo>
                  <a:lnTo>
                    <a:pt x="2730" y="8"/>
                  </a:lnTo>
                  <a:lnTo>
                    <a:pt x="2735" y="8"/>
                  </a:lnTo>
                  <a:lnTo>
                    <a:pt x="2740" y="14"/>
                  </a:lnTo>
                  <a:lnTo>
                    <a:pt x="2746" y="15"/>
                  </a:lnTo>
                  <a:lnTo>
                    <a:pt x="2751" y="11"/>
                  </a:lnTo>
                  <a:lnTo>
                    <a:pt x="2756" y="9"/>
                  </a:lnTo>
                  <a:lnTo>
                    <a:pt x="2762" y="8"/>
                  </a:lnTo>
                  <a:lnTo>
                    <a:pt x="2767" y="7"/>
                  </a:lnTo>
                  <a:lnTo>
                    <a:pt x="2772" y="7"/>
                  </a:lnTo>
                  <a:lnTo>
                    <a:pt x="2777" y="10"/>
                  </a:lnTo>
                  <a:lnTo>
                    <a:pt x="2783" y="13"/>
                  </a:lnTo>
                  <a:lnTo>
                    <a:pt x="2788" y="12"/>
                  </a:lnTo>
                  <a:lnTo>
                    <a:pt x="2793" y="9"/>
                  </a:lnTo>
                  <a:lnTo>
                    <a:pt x="2799" y="9"/>
                  </a:lnTo>
                  <a:lnTo>
                    <a:pt x="2804" y="8"/>
                  </a:lnTo>
                  <a:lnTo>
                    <a:pt x="2809" y="8"/>
                  </a:lnTo>
                  <a:lnTo>
                    <a:pt x="2815" y="12"/>
                  </a:lnTo>
                  <a:lnTo>
                    <a:pt x="2820" y="22"/>
                  </a:lnTo>
                  <a:lnTo>
                    <a:pt x="2825" y="22"/>
                  </a:lnTo>
                  <a:lnTo>
                    <a:pt x="2831" y="12"/>
                  </a:lnTo>
                  <a:lnTo>
                    <a:pt x="2836" y="8"/>
                  </a:lnTo>
                  <a:lnTo>
                    <a:pt x="2841" y="7"/>
                  </a:lnTo>
                  <a:lnTo>
                    <a:pt x="2846" y="6"/>
                  </a:lnTo>
                  <a:lnTo>
                    <a:pt x="2852" y="7"/>
                  </a:lnTo>
                  <a:lnTo>
                    <a:pt x="2857" y="7"/>
                  </a:lnTo>
                  <a:lnTo>
                    <a:pt x="2862" y="6"/>
                  </a:lnTo>
                  <a:lnTo>
                    <a:pt x="2868" y="6"/>
                  </a:lnTo>
                  <a:lnTo>
                    <a:pt x="2873" y="5"/>
                  </a:lnTo>
                  <a:lnTo>
                    <a:pt x="2878" y="8"/>
                  </a:lnTo>
                  <a:lnTo>
                    <a:pt x="2884" y="16"/>
                  </a:lnTo>
                  <a:lnTo>
                    <a:pt x="2889" y="27"/>
                  </a:lnTo>
                  <a:lnTo>
                    <a:pt x="2894" y="20"/>
                  </a:lnTo>
                  <a:lnTo>
                    <a:pt x="2900" y="10"/>
                  </a:lnTo>
                  <a:lnTo>
                    <a:pt x="2905" y="9"/>
                  </a:lnTo>
                  <a:lnTo>
                    <a:pt x="2910" y="10"/>
                  </a:lnTo>
                  <a:lnTo>
                    <a:pt x="2915" y="8"/>
                  </a:lnTo>
                  <a:lnTo>
                    <a:pt x="2921" y="7"/>
                  </a:lnTo>
                  <a:lnTo>
                    <a:pt x="2926" y="7"/>
                  </a:lnTo>
                  <a:lnTo>
                    <a:pt x="2931" y="7"/>
                  </a:lnTo>
                  <a:lnTo>
                    <a:pt x="2937" y="9"/>
                  </a:lnTo>
                  <a:lnTo>
                    <a:pt x="2942" y="9"/>
                  </a:lnTo>
                  <a:lnTo>
                    <a:pt x="2947" y="8"/>
                  </a:lnTo>
                  <a:lnTo>
                    <a:pt x="2953" y="8"/>
                  </a:lnTo>
                  <a:lnTo>
                    <a:pt x="2958" y="9"/>
                  </a:lnTo>
                  <a:lnTo>
                    <a:pt x="2963" y="8"/>
                  </a:lnTo>
                  <a:lnTo>
                    <a:pt x="2969" y="10"/>
                  </a:lnTo>
                  <a:lnTo>
                    <a:pt x="2974" y="9"/>
                  </a:lnTo>
                  <a:lnTo>
                    <a:pt x="2979" y="8"/>
                  </a:lnTo>
                  <a:lnTo>
                    <a:pt x="2984" y="12"/>
                  </a:lnTo>
                  <a:lnTo>
                    <a:pt x="2990" y="17"/>
                  </a:lnTo>
                  <a:lnTo>
                    <a:pt x="2995" y="13"/>
                  </a:lnTo>
                  <a:lnTo>
                    <a:pt x="3000" y="10"/>
                  </a:lnTo>
                  <a:lnTo>
                    <a:pt x="3006" y="15"/>
                  </a:lnTo>
                  <a:lnTo>
                    <a:pt x="3011" y="16"/>
                  </a:lnTo>
                  <a:lnTo>
                    <a:pt x="3016" y="13"/>
                  </a:lnTo>
                  <a:lnTo>
                    <a:pt x="3022" y="8"/>
                  </a:lnTo>
                  <a:lnTo>
                    <a:pt x="3027" y="7"/>
                  </a:lnTo>
                  <a:lnTo>
                    <a:pt x="3032" y="9"/>
                  </a:lnTo>
                  <a:lnTo>
                    <a:pt x="3038" y="13"/>
                  </a:lnTo>
                  <a:lnTo>
                    <a:pt x="3043" y="11"/>
                  </a:lnTo>
                  <a:lnTo>
                    <a:pt x="3048" y="11"/>
                  </a:lnTo>
                  <a:lnTo>
                    <a:pt x="3053" y="10"/>
                  </a:lnTo>
                  <a:lnTo>
                    <a:pt x="3059" y="10"/>
                  </a:lnTo>
                  <a:lnTo>
                    <a:pt x="3064" y="8"/>
                  </a:lnTo>
                  <a:lnTo>
                    <a:pt x="3069" y="10"/>
                  </a:lnTo>
                  <a:lnTo>
                    <a:pt x="3075" y="10"/>
                  </a:lnTo>
                  <a:lnTo>
                    <a:pt x="3080" y="12"/>
                  </a:lnTo>
                  <a:lnTo>
                    <a:pt x="3085" y="18"/>
                  </a:lnTo>
                  <a:lnTo>
                    <a:pt x="3091" y="18"/>
                  </a:lnTo>
                  <a:lnTo>
                    <a:pt x="3096" y="19"/>
                  </a:lnTo>
                  <a:lnTo>
                    <a:pt x="3101" y="17"/>
                  </a:lnTo>
                  <a:lnTo>
                    <a:pt x="3107" y="24"/>
                  </a:lnTo>
                  <a:lnTo>
                    <a:pt x="3112" y="22"/>
                  </a:lnTo>
                  <a:lnTo>
                    <a:pt x="3117" y="13"/>
                  </a:lnTo>
                  <a:lnTo>
                    <a:pt x="3122" y="15"/>
                  </a:lnTo>
                  <a:lnTo>
                    <a:pt x="3128" y="20"/>
                  </a:lnTo>
                  <a:lnTo>
                    <a:pt x="3133" y="29"/>
                  </a:lnTo>
                  <a:lnTo>
                    <a:pt x="3138" y="41"/>
                  </a:lnTo>
                  <a:lnTo>
                    <a:pt x="3144" y="51"/>
                  </a:lnTo>
                  <a:lnTo>
                    <a:pt x="3149" y="50"/>
                  </a:lnTo>
                  <a:lnTo>
                    <a:pt x="3154" y="59"/>
                  </a:lnTo>
                  <a:lnTo>
                    <a:pt x="3160" y="78"/>
                  </a:lnTo>
                  <a:lnTo>
                    <a:pt x="3165" y="75"/>
                  </a:lnTo>
                  <a:lnTo>
                    <a:pt x="3170" y="52"/>
                  </a:lnTo>
                  <a:lnTo>
                    <a:pt x="3176" y="45"/>
                  </a:lnTo>
                  <a:lnTo>
                    <a:pt x="3181" y="41"/>
                  </a:lnTo>
                  <a:lnTo>
                    <a:pt x="3186" y="41"/>
                  </a:lnTo>
                  <a:lnTo>
                    <a:pt x="3191" y="38"/>
                  </a:lnTo>
                  <a:lnTo>
                    <a:pt x="3197" y="38"/>
                  </a:lnTo>
                  <a:lnTo>
                    <a:pt x="3202" y="43"/>
                  </a:lnTo>
                  <a:lnTo>
                    <a:pt x="3207" y="41"/>
                  </a:lnTo>
                  <a:lnTo>
                    <a:pt x="3213" y="42"/>
                  </a:lnTo>
                  <a:lnTo>
                    <a:pt x="3218" y="46"/>
                  </a:lnTo>
                  <a:lnTo>
                    <a:pt x="3223" y="54"/>
                  </a:lnTo>
                  <a:lnTo>
                    <a:pt x="3229" y="60"/>
                  </a:lnTo>
                  <a:lnTo>
                    <a:pt x="3234" y="60"/>
                  </a:lnTo>
                  <a:lnTo>
                    <a:pt x="3239" y="55"/>
                  </a:lnTo>
                  <a:lnTo>
                    <a:pt x="3245" y="50"/>
                  </a:lnTo>
                  <a:lnTo>
                    <a:pt x="3250" y="48"/>
                  </a:lnTo>
                  <a:lnTo>
                    <a:pt x="3255" y="40"/>
                  </a:lnTo>
                  <a:lnTo>
                    <a:pt x="3260" y="34"/>
                  </a:lnTo>
                  <a:lnTo>
                    <a:pt x="3266" y="29"/>
                  </a:lnTo>
                  <a:lnTo>
                    <a:pt x="3271" y="30"/>
                  </a:lnTo>
                  <a:lnTo>
                    <a:pt x="3276" y="38"/>
                  </a:lnTo>
                  <a:lnTo>
                    <a:pt x="3282" y="54"/>
                  </a:lnTo>
                  <a:lnTo>
                    <a:pt x="3287" y="56"/>
                  </a:lnTo>
                  <a:lnTo>
                    <a:pt x="3292" y="53"/>
                  </a:lnTo>
                  <a:lnTo>
                    <a:pt x="3298" y="45"/>
                  </a:lnTo>
                  <a:lnTo>
                    <a:pt x="3303" y="40"/>
                  </a:lnTo>
                  <a:lnTo>
                    <a:pt x="3308" y="33"/>
                  </a:lnTo>
                  <a:lnTo>
                    <a:pt x="3314" y="26"/>
                  </a:lnTo>
                  <a:lnTo>
                    <a:pt x="3319" y="20"/>
                  </a:lnTo>
                  <a:lnTo>
                    <a:pt x="3324" y="17"/>
                  </a:lnTo>
                  <a:lnTo>
                    <a:pt x="3329" y="13"/>
                  </a:lnTo>
                  <a:lnTo>
                    <a:pt x="3335" y="11"/>
                  </a:lnTo>
                  <a:lnTo>
                    <a:pt x="3340" y="11"/>
                  </a:lnTo>
                  <a:lnTo>
                    <a:pt x="3345" y="11"/>
                  </a:lnTo>
                  <a:lnTo>
                    <a:pt x="3351" y="13"/>
                  </a:lnTo>
                  <a:lnTo>
                    <a:pt x="3356" y="11"/>
                  </a:lnTo>
                  <a:lnTo>
                    <a:pt x="3361" y="12"/>
                  </a:lnTo>
                  <a:lnTo>
                    <a:pt x="3367" y="67"/>
                  </a:lnTo>
                  <a:lnTo>
                    <a:pt x="3372" y="435"/>
                  </a:lnTo>
                  <a:lnTo>
                    <a:pt x="3377" y="949"/>
                  </a:lnTo>
                  <a:lnTo>
                    <a:pt x="3383" y="501"/>
                  </a:lnTo>
                  <a:lnTo>
                    <a:pt x="3388" y="85"/>
                  </a:lnTo>
                  <a:lnTo>
                    <a:pt x="3393" y="16"/>
                  </a:lnTo>
                  <a:lnTo>
                    <a:pt x="3398" y="11"/>
                  </a:lnTo>
                  <a:lnTo>
                    <a:pt x="3404" y="9"/>
                  </a:lnTo>
                  <a:lnTo>
                    <a:pt x="3409" y="9"/>
                  </a:lnTo>
                  <a:lnTo>
                    <a:pt x="3414" y="9"/>
                  </a:lnTo>
                  <a:lnTo>
                    <a:pt x="3420" y="10"/>
                  </a:lnTo>
                  <a:lnTo>
                    <a:pt x="3425" y="7"/>
                  </a:lnTo>
                  <a:lnTo>
                    <a:pt x="3430" y="5"/>
                  </a:lnTo>
                  <a:lnTo>
                    <a:pt x="3436" y="5"/>
                  </a:lnTo>
                  <a:lnTo>
                    <a:pt x="3441" y="5"/>
                  </a:lnTo>
                  <a:lnTo>
                    <a:pt x="3446" y="6"/>
                  </a:lnTo>
                  <a:lnTo>
                    <a:pt x="3452" y="7"/>
                  </a:lnTo>
                  <a:lnTo>
                    <a:pt x="3457" y="6"/>
                  </a:lnTo>
                  <a:lnTo>
                    <a:pt x="3462" y="8"/>
                  </a:lnTo>
                  <a:lnTo>
                    <a:pt x="3467" y="11"/>
                  </a:lnTo>
                  <a:lnTo>
                    <a:pt x="3473" y="13"/>
                  </a:lnTo>
                  <a:lnTo>
                    <a:pt x="3478" y="13"/>
                  </a:lnTo>
                  <a:lnTo>
                    <a:pt x="3483" y="10"/>
                  </a:lnTo>
                  <a:lnTo>
                    <a:pt x="3489" y="6"/>
                  </a:lnTo>
                  <a:lnTo>
                    <a:pt x="3494" y="5"/>
                  </a:lnTo>
                  <a:lnTo>
                    <a:pt x="3499" y="5"/>
                  </a:lnTo>
                  <a:lnTo>
                    <a:pt x="3505" y="4"/>
                  </a:lnTo>
                  <a:lnTo>
                    <a:pt x="3510" y="5"/>
                  </a:lnTo>
                  <a:lnTo>
                    <a:pt x="3515" y="5"/>
                  </a:lnTo>
                  <a:lnTo>
                    <a:pt x="3521" y="4"/>
                  </a:lnTo>
                  <a:lnTo>
                    <a:pt x="3526" y="4"/>
                  </a:lnTo>
                  <a:lnTo>
                    <a:pt x="3531" y="4"/>
                  </a:lnTo>
                  <a:lnTo>
                    <a:pt x="3536" y="5"/>
                  </a:lnTo>
                  <a:lnTo>
                    <a:pt x="3542" y="5"/>
                  </a:lnTo>
                  <a:lnTo>
                    <a:pt x="3547" y="5"/>
                  </a:lnTo>
                  <a:lnTo>
                    <a:pt x="3552" y="4"/>
                  </a:lnTo>
                  <a:lnTo>
                    <a:pt x="3558" y="5"/>
                  </a:lnTo>
                  <a:lnTo>
                    <a:pt x="3563" y="5"/>
                  </a:lnTo>
                  <a:lnTo>
                    <a:pt x="3568" y="4"/>
                  </a:lnTo>
                  <a:lnTo>
                    <a:pt x="3574" y="5"/>
                  </a:lnTo>
                  <a:lnTo>
                    <a:pt x="3579" y="8"/>
                  </a:lnTo>
                  <a:lnTo>
                    <a:pt x="3584" y="7"/>
                  </a:lnTo>
                  <a:lnTo>
                    <a:pt x="3590" y="6"/>
                  </a:lnTo>
                  <a:lnTo>
                    <a:pt x="3595" y="7"/>
                  </a:lnTo>
                  <a:lnTo>
                    <a:pt x="3600" y="7"/>
                  </a:lnTo>
                  <a:lnTo>
                    <a:pt x="3605" y="6"/>
                  </a:lnTo>
                  <a:lnTo>
                    <a:pt x="3611" y="6"/>
                  </a:lnTo>
                  <a:lnTo>
                    <a:pt x="3616" y="5"/>
                  </a:lnTo>
                  <a:lnTo>
                    <a:pt x="3621" y="4"/>
                  </a:lnTo>
                  <a:lnTo>
                    <a:pt x="3627" y="5"/>
                  </a:lnTo>
                  <a:lnTo>
                    <a:pt x="3632" y="5"/>
                  </a:lnTo>
                  <a:lnTo>
                    <a:pt x="3637" y="5"/>
                  </a:lnTo>
                  <a:lnTo>
                    <a:pt x="3643" y="6"/>
                  </a:lnTo>
                  <a:lnTo>
                    <a:pt x="3648" y="5"/>
                  </a:lnTo>
                  <a:lnTo>
                    <a:pt x="3653" y="4"/>
                  </a:lnTo>
                  <a:lnTo>
                    <a:pt x="3659" y="4"/>
                  </a:lnTo>
                  <a:lnTo>
                    <a:pt x="3664" y="4"/>
                  </a:lnTo>
                  <a:lnTo>
                    <a:pt x="3669" y="4"/>
                  </a:lnTo>
                  <a:lnTo>
                    <a:pt x="3674" y="4"/>
                  </a:lnTo>
                  <a:lnTo>
                    <a:pt x="3680" y="4"/>
                  </a:lnTo>
                  <a:lnTo>
                    <a:pt x="3685" y="5"/>
                  </a:lnTo>
                  <a:lnTo>
                    <a:pt x="3690" y="5"/>
                  </a:lnTo>
                  <a:lnTo>
                    <a:pt x="3696" y="5"/>
                  </a:lnTo>
                  <a:lnTo>
                    <a:pt x="3701" y="7"/>
                  </a:lnTo>
                  <a:lnTo>
                    <a:pt x="3706" y="8"/>
                  </a:lnTo>
                  <a:lnTo>
                    <a:pt x="3712" y="10"/>
                  </a:lnTo>
                  <a:lnTo>
                    <a:pt x="3717" y="12"/>
                  </a:lnTo>
                  <a:lnTo>
                    <a:pt x="3722" y="10"/>
                  </a:lnTo>
                  <a:lnTo>
                    <a:pt x="3728" y="10"/>
                  </a:lnTo>
                  <a:lnTo>
                    <a:pt x="3733" y="14"/>
                  </a:lnTo>
                  <a:lnTo>
                    <a:pt x="3738" y="14"/>
                  </a:lnTo>
                  <a:lnTo>
                    <a:pt x="3743" y="15"/>
                  </a:lnTo>
                  <a:lnTo>
                    <a:pt x="3749" y="13"/>
                  </a:lnTo>
                  <a:lnTo>
                    <a:pt x="3754" y="12"/>
                  </a:lnTo>
                  <a:lnTo>
                    <a:pt x="3759" y="9"/>
                  </a:lnTo>
                  <a:lnTo>
                    <a:pt x="3765" y="8"/>
                  </a:lnTo>
                  <a:lnTo>
                    <a:pt x="3770" y="9"/>
                  </a:lnTo>
                  <a:lnTo>
                    <a:pt x="3775" y="11"/>
                  </a:lnTo>
                  <a:lnTo>
                    <a:pt x="3781" y="11"/>
                  </a:lnTo>
                  <a:lnTo>
                    <a:pt x="3786" y="12"/>
                  </a:lnTo>
                  <a:lnTo>
                    <a:pt x="3791" y="12"/>
                  </a:lnTo>
                  <a:lnTo>
                    <a:pt x="3797" y="19"/>
                  </a:lnTo>
                  <a:lnTo>
                    <a:pt x="3802" y="23"/>
                  </a:lnTo>
                  <a:lnTo>
                    <a:pt x="3807" y="14"/>
                  </a:lnTo>
                  <a:lnTo>
                    <a:pt x="3812" y="11"/>
                  </a:lnTo>
                  <a:lnTo>
                    <a:pt x="3818" y="11"/>
                  </a:lnTo>
                  <a:lnTo>
                    <a:pt x="3823" y="9"/>
                  </a:lnTo>
                  <a:lnTo>
                    <a:pt x="3828" y="10"/>
                  </a:lnTo>
                  <a:lnTo>
                    <a:pt x="3834" y="11"/>
                  </a:lnTo>
                  <a:lnTo>
                    <a:pt x="3839" y="11"/>
                  </a:lnTo>
                  <a:lnTo>
                    <a:pt x="3844" y="10"/>
                  </a:lnTo>
                  <a:lnTo>
                    <a:pt x="3850" y="10"/>
                  </a:lnTo>
                  <a:lnTo>
                    <a:pt x="3855" y="12"/>
                  </a:lnTo>
                  <a:lnTo>
                    <a:pt x="3860" y="12"/>
                  </a:lnTo>
                  <a:lnTo>
                    <a:pt x="3866" y="8"/>
                  </a:lnTo>
                  <a:lnTo>
                    <a:pt x="3871" y="9"/>
                  </a:lnTo>
                  <a:lnTo>
                    <a:pt x="3876" y="13"/>
                  </a:lnTo>
                  <a:lnTo>
                    <a:pt x="3881" y="19"/>
                  </a:lnTo>
                  <a:lnTo>
                    <a:pt x="3887" y="18"/>
                  </a:lnTo>
                  <a:lnTo>
                    <a:pt x="3892" y="16"/>
                  </a:lnTo>
                  <a:lnTo>
                    <a:pt x="3897" y="12"/>
                  </a:lnTo>
                  <a:lnTo>
                    <a:pt x="3903" y="10"/>
                  </a:lnTo>
                  <a:lnTo>
                    <a:pt x="3908" y="9"/>
                  </a:lnTo>
                  <a:lnTo>
                    <a:pt x="3913" y="8"/>
                  </a:lnTo>
                  <a:lnTo>
                    <a:pt x="3919" y="8"/>
                  </a:lnTo>
                  <a:lnTo>
                    <a:pt x="3924" y="9"/>
                  </a:lnTo>
                  <a:lnTo>
                    <a:pt x="3929" y="11"/>
                  </a:lnTo>
                  <a:lnTo>
                    <a:pt x="3935" y="10"/>
                  </a:lnTo>
                  <a:lnTo>
                    <a:pt x="3940" y="9"/>
                  </a:lnTo>
                  <a:lnTo>
                    <a:pt x="3945" y="11"/>
                  </a:lnTo>
                  <a:lnTo>
                    <a:pt x="3950" y="9"/>
                  </a:lnTo>
                  <a:lnTo>
                    <a:pt x="3956" y="8"/>
                  </a:lnTo>
                  <a:lnTo>
                    <a:pt x="3961" y="6"/>
                  </a:lnTo>
                  <a:lnTo>
                    <a:pt x="3966" y="6"/>
                  </a:lnTo>
                  <a:lnTo>
                    <a:pt x="3972" y="7"/>
                  </a:lnTo>
                  <a:lnTo>
                    <a:pt x="3977" y="7"/>
                  </a:lnTo>
                  <a:lnTo>
                    <a:pt x="3982" y="8"/>
                  </a:lnTo>
                  <a:lnTo>
                    <a:pt x="3988" y="8"/>
                  </a:lnTo>
                  <a:lnTo>
                    <a:pt x="3993" y="14"/>
                  </a:lnTo>
                  <a:lnTo>
                    <a:pt x="3998" y="25"/>
                  </a:lnTo>
                  <a:lnTo>
                    <a:pt x="4004" y="24"/>
                  </a:lnTo>
                  <a:lnTo>
                    <a:pt x="4009" y="16"/>
                  </a:lnTo>
                  <a:lnTo>
                    <a:pt x="4014" y="13"/>
                  </a:lnTo>
                  <a:lnTo>
                    <a:pt x="4019" y="16"/>
                  </a:lnTo>
                  <a:lnTo>
                    <a:pt x="4025" y="21"/>
                  </a:lnTo>
                  <a:lnTo>
                    <a:pt x="4030" y="16"/>
                  </a:lnTo>
                  <a:lnTo>
                    <a:pt x="4035" y="13"/>
                  </a:lnTo>
                  <a:lnTo>
                    <a:pt x="4041" y="13"/>
                  </a:lnTo>
                  <a:lnTo>
                    <a:pt x="4046" y="12"/>
                  </a:lnTo>
                  <a:lnTo>
                    <a:pt x="4051" y="8"/>
                  </a:lnTo>
                  <a:lnTo>
                    <a:pt x="4057" y="7"/>
                  </a:lnTo>
                  <a:lnTo>
                    <a:pt x="4062" y="7"/>
                  </a:lnTo>
                  <a:lnTo>
                    <a:pt x="4067" y="6"/>
                  </a:lnTo>
                  <a:lnTo>
                    <a:pt x="4073" y="6"/>
                  </a:lnTo>
                  <a:lnTo>
                    <a:pt x="4078" y="4"/>
                  </a:lnTo>
                  <a:lnTo>
                    <a:pt x="4083" y="4"/>
                  </a:lnTo>
                  <a:lnTo>
                    <a:pt x="4088" y="5"/>
                  </a:lnTo>
                  <a:lnTo>
                    <a:pt x="4094" y="4"/>
                  </a:lnTo>
                  <a:lnTo>
                    <a:pt x="4099" y="2"/>
                  </a:lnTo>
                  <a:lnTo>
                    <a:pt x="4104" y="5"/>
                  </a:lnTo>
                  <a:lnTo>
                    <a:pt x="4110" y="8"/>
                  </a:lnTo>
                  <a:lnTo>
                    <a:pt x="4115" y="11"/>
                  </a:lnTo>
                  <a:lnTo>
                    <a:pt x="4120" y="11"/>
                  </a:lnTo>
                  <a:lnTo>
                    <a:pt x="4126" y="10"/>
                  </a:lnTo>
                  <a:lnTo>
                    <a:pt x="4131" y="10"/>
                  </a:lnTo>
                  <a:lnTo>
                    <a:pt x="4136" y="14"/>
                  </a:lnTo>
                  <a:lnTo>
                    <a:pt x="4142" y="10"/>
                  </a:lnTo>
                  <a:lnTo>
                    <a:pt x="4147" y="6"/>
                  </a:lnTo>
                  <a:lnTo>
                    <a:pt x="4152" y="6"/>
                  </a:lnTo>
                  <a:lnTo>
                    <a:pt x="4157" y="4"/>
                  </a:lnTo>
                  <a:lnTo>
                    <a:pt x="4163" y="3"/>
                  </a:lnTo>
                  <a:lnTo>
                    <a:pt x="4168" y="4"/>
                  </a:lnTo>
                  <a:lnTo>
                    <a:pt x="4173" y="6"/>
                  </a:lnTo>
                  <a:lnTo>
                    <a:pt x="4179" y="3"/>
                  </a:lnTo>
                  <a:lnTo>
                    <a:pt x="4184" y="1"/>
                  </a:lnTo>
                  <a:lnTo>
                    <a:pt x="4189" y="3"/>
                  </a:lnTo>
                  <a:lnTo>
                    <a:pt x="4195" y="5"/>
                  </a:lnTo>
                  <a:lnTo>
                    <a:pt x="4200" y="7"/>
                  </a:lnTo>
                  <a:lnTo>
                    <a:pt x="4205" y="6"/>
                  </a:lnTo>
                  <a:lnTo>
                    <a:pt x="4211" y="6"/>
                  </a:lnTo>
                  <a:lnTo>
                    <a:pt x="4216" y="7"/>
                  </a:lnTo>
                  <a:lnTo>
                    <a:pt x="4221" y="8"/>
                  </a:lnTo>
                  <a:lnTo>
                    <a:pt x="4226" y="7"/>
                  </a:lnTo>
                  <a:lnTo>
                    <a:pt x="4232" y="3"/>
                  </a:lnTo>
                  <a:lnTo>
                    <a:pt x="4237" y="3"/>
                  </a:lnTo>
                  <a:lnTo>
                    <a:pt x="4242" y="2"/>
                  </a:lnTo>
                  <a:lnTo>
                    <a:pt x="4248" y="3"/>
                  </a:lnTo>
                  <a:lnTo>
                    <a:pt x="4253" y="2"/>
                  </a:lnTo>
                  <a:lnTo>
                    <a:pt x="4258" y="2"/>
                  </a:lnTo>
                  <a:lnTo>
                    <a:pt x="4264" y="1"/>
                  </a:lnTo>
                  <a:lnTo>
                    <a:pt x="4269" y="0"/>
                  </a:lnTo>
                  <a:lnTo>
                    <a:pt x="4274" y="1"/>
                  </a:lnTo>
                  <a:lnTo>
                    <a:pt x="4280" y="1"/>
                  </a:lnTo>
                  <a:lnTo>
                    <a:pt x="4285" y="1"/>
                  </a:lnTo>
                  <a:lnTo>
                    <a:pt x="4290" y="3"/>
                  </a:lnTo>
                  <a:lnTo>
                    <a:pt x="4295" y="7"/>
                  </a:lnTo>
                  <a:lnTo>
                    <a:pt x="4301" y="6"/>
                  </a:lnTo>
                  <a:lnTo>
                    <a:pt x="4306" y="2"/>
                  </a:lnTo>
                  <a:lnTo>
                    <a:pt x="4311" y="2"/>
                  </a:lnTo>
                  <a:lnTo>
                    <a:pt x="4317" y="2"/>
                  </a:lnTo>
                  <a:lnTo>
                    <a:pt x="4322" y="6"/>
                  </a:lnTo>
                  <a:lnTo>
                    <a:pt x="4327" y="11"/>
                  </a:lnTo>
                  <a:lnTo>
                    <a:pt x="4333" y="10"/>
                  </a:lnTo>
                  <a:lnTo>
                    <a:pt x="4338" y="5"/>
                  </a:lnTo>
                  <a:lnTo>
                    <a:pt x="4343" y="3"/>
                  </a:lnTo>
                  <a:lnTo>
                    <a:pt x="4349" y="2"/>
                  </a:lnTo>
                  <a:lnTo>
                    <a:pt x="4354" y="2"/>
                  </a:lnTo>
                  <a:lnTo>
                    <a:pt x="4359" y="2"/>
                  </a:lnTo>
                  <a:lnTo>
                    <a:pt x="4364" y="2"/>
                  </a:lnTo>
                  <a:lnTo>
                    <a:pt x="4370" y="3"/>
                  </a:lnTo>
                  <a:lnTo>
                    <a:pt x="4375" y="2"/>
                  </a:lnTo>
                  <a:lnTo>
                    <a:pt x="4380" y="2"/>
                  </a:lnTo>
                  <a:lnTo>
                    <a:pt x="4386" y="1"/>
                  </a:lnTo>
                  <a:lnTo>
                    <a:pt x="4391" y="2"/>
                  </a:lnTo>
                  <a:lnTo>
                    <a:pt x="4396" y="1"/>
                  </a:lnTo>
                  <a:lnTo>
                    <a:pt x="4402" y="2"/>
                  </a:lnTo>
                  <a:lnTo>
                    <a:pt x="4407" y="3"/>
                  </a:lnTo>
                  <a:lnTo>
                    <a:pt x="4412" y="2"/>
                  </a:lnTo>
                  <a:lnTo>
                    <a:pt x="4418" y="0"/>
                  </a:lnTo>
                  <a:lnTo>
                    <a:pt x="4423" y="1"/>
                  </a:lnTo>
                  <a:lnTo>
                    <a:pt x="4428" y="5"/>
                  </a:lnTo>
                  <a:lnTo>
                    <a:pt x="4433" y="8"/>
                  </a:lnTo>
                  <a:lnTo>
                    <a:pt x="4439" y="9"/>
                  </a:lnTo>
                  <a:lnTo>
                    <a:pt x="4444" y="4"/>
                  </a:lnTo>
                  <a:lnTo>
                    <a:pt x="4449" y="4"/>
                  </a:lnTo>
                  <a:lnTo>
                    <a:pt x="4455" y="5"/>
                  </a:lnTo>
                  <a:lnTo>
                    <a:pt x="4460" y="13"/>
                  </a:lnTo>
                  <a:lnTo>
                    <a:pt x="4465" y="20"/>
                  </a:lnTo>
                  <a:lnTo>
                    <a:pt x="4471" y="14"/>
                  </a:lnTo>
                  <a:lnTo>
                    <a:pt x="4476" y="7"/>
                  </a:lnTo>
                  <a:lnTo>
                    <a:pt x="4481" y="6"/>
                  </a:lnTo>
                  <a:lnTo>
                    <a:pt x="4487" y="5"/>
                  </a:lnTo>
                  <a:lnTo>
                    <a:pt x="4492" y="6"/>
                  </a:lnTo>
                  <a:lnTo>
                    <a:pt x="4497" y="4"/>
                  </a:lnTo>
                  <a:lnTo>
                    <a:pt x="4502" y="8"/>
                  </a:lnTo>
                  <a:lnTo>
                    <a:pt x="4508" y="14"/>
                  </a:lnTo>
                  <a:lnTo>
                    <a:pt x="4513" y="15"/>
                  </a:lnTo>
                  <a:lnTo>
                    <a:pt x="4518" y="16"/>
                  </a:lnTo>
                  <a:lnTo>
                    <a:pt x="4524" y="13"/>
                  </a:lnTo>
                  <a:lnTo>
                    <a:pt x="4529" y="16"/>
                  </a:lnTo>
                  <a:lnTo>
                    <a:pt x="4534" y="22"/>
                  </a:lnTo>
                  <a:lnTo>
                    <a:pt x="4540" y="19"/>
                  </a:lnTo>
                  <a:lnTo>
                    <a:pt x="4545" y="9"/>
                  </a:lnTo>
                  <a:lnTo>
                    <a:pt x="4550" y="7"/>
                  </a:lnTo>
                  <a:lnTo>
                    <a:pt x="4556" y="8"/>
                  </a:lnTo>
                  <a:lnTo>
                    <a:pt x="4561" y="7"/>
                  </a:lnTo>
                  <a:lnTo>
                    <a:pt x="4566" y="5"/>
                  </a:lnTo>
                  <a:lnTo>
                    <a:pt x="4571" y="5"/>
                  </a:lnTo>
                  <a:lnTo>
                    <a:pt x="4577" y="5"/>
                  </a:lnTo>
                  <a:lnTo>
                    <a:pt x="4582" y="4"/>
                  </a:lnTo>
                  <a:lnTo>
                    <a:pt x="4587" y="5"/>
                  </a:lnTo>
                  <a:lnTo>
                    <a:pt x="4593" y="5"/>
                  </a:lnTo>
                  <a:lnTo>
                    <a:pt x="4598" y="5"/>
                  </a:lnTo>
                  <a:lnTo>
                    <a:pt x="4603" y="5"/>
                  </a:lnTo>
                  <a:lnTo>
                    <a:pt x="4609" y="4"/>
                  </a:lnTo>
                  <a:lnTo>
                    <a:pt x="4614" y="4"/>
                  </a:lnTo>
                  <a:lnTo>
                    <a:pt x="4619" y="6"/>
                  </a:lnTo>
                  <a:lnTo>
                    <a:pt x="4625" y="6"/>
                  </a:lnTo>
                  <a:lnTo>
                    <a:pt x="4630" y="6"/>
                  </a:lnTo>
                  <a:lnTo>
                    <a:pt x="4635" y="7"/>
                  </a:lnTo>
                  <a:lnTo>
                    <a:pt x="4640" y="5"/>
                  </a:lnTo>
                  <a:lnTo>
                    <a:pt x="4646" y="4"/>
                  </a:lnTo>
                  <a:lnTo>
                    <a:pt x="4651" y="4"/>
                  </a:lnTo>
                  <a:lnTo>
                    <a:pt x="4656" y="5"/>
                  </a:lnTo>
                  <a:lnTo>
                    <a:pt x="4662" y="6"/>
                  </a:lnTo>
                  <a:lnTo>
                    <a:pt x="4667" y="12"/>
                  </a:lnTo>
                  <a:lnTo>
                    <a:pt x="4672" y="14"/>
                  </a:lnTo>
                  <a:lnTo>
                    <a:pt x="4678" y="18"/>
                  </a:lnTo>
                  <a:lnTo>
                    <a:pt x="4683" y="52"/>
                  </a:lnTo>
                  <a:lnTo>
                    <a:pt x="4688" y="88"/>
                  </a:lnTo>
                  <a:lnTo>
                    <a:pt x="4694" y="63"/>
                  </a:lnTo>
                  <a:lnTo>
                    <a:pt x="4699" y="38"/>
                  </a:lnTo>
                  <a:lnTo>
                    <a:pt x="4704" y="27"/>
                  </a:lnTo>
                  <a:lnTo>
                    <a:pt x="4709" y="23"/>
                  </a:lnTo>
                  <a:lnTo>
                    <a:pt x="4715" y="19"/>
                  </a:lnTo>
                  <a:lnTo>
                    <a:pt x="4720" y="16"/>
                  </a:lnTo>
                  <a:lnTo>
                    <a:pt x="4725" y="16"/>
                  </a:lnTo>
                  <a:lnTo>
                    <a:pt x="4731" y="13"/>
                  </a:lnTo>
                  <a:lnTo>
                    <a:pt x="4736" y="10"/>
                  </a:lnTo>
                  <a:lnTo>
                    <a:pt x="4741" y="10"/>
                  </a:lnTo>
                  <a:lnTo>
                    <a:pt x="4747" y="9"/>
                  </a:lnTo>
                  <a:lnTo>
                    <a:pt x="4752" y="9"/>
                  </a:lnTo>
                  <a:lnTo>
                    <a:pt x="4757" y="9"/>
                  </a:lnTo>
                  <a:lnTo>
                    <a:pt x="4763" y="10"/>
                  </a:lnTo>
                  <a:lnTo>
                    <a:pt x="4768" y="27"/>
                  </a:lnTo>
                  <a:lnTo>
                    <a:pt x="4773" y="48"/>
                  </a:lnTo>
                  <a:lnTo>
                    <a:pt x="4778" y="29"/>
                  </a:lnTo>
                  <a:lnTo>
                    <a:pt x="4784" y="12"/>
                  </a:lnTo>
                  <a:lnTo>
                    <a:pt x="4789" y="9"/>
                  </a:lnTo>
                  <a:lnTo>
                    <a:pt x="4794" y="6"/>
                  </a:lnTo>
                  <a:lnTo>
                    <a:pt x="4800" y="5"/>
                  </a:lnTo>
                  <a:lnTo>
                    <a:pt x="4805" y="5"/>
                  </a:lnTo>
                  <a:lnTo>
                    <a:pt x="4810" y="4"/>
                  </a:lnTo>
                  <a:lnTo>
                    <a:pt x="4816" y="4"/>
                  </a:lnTo>
                  <a:lnTo>
                    <a:pt x="4821" y="5"/>
                  </a:lnTo>
                  <a:lnTo>
                    <a:pt x="4826" y="7"/>
                  </a:lnTo>
                  <a:lnTo>
                    <a:pt x="4832" y="7"/>
                  </a:lnTo>
                  <a:lnTo>
                    <a:pt x="4837" y="5"/>
                  </a:lnTo>
                  <a:lnTo>
                    <a:pt x="4842" y="3"/>
                  </a:lnTo>
                  <a:lnTo>
                    <a:pt x="4847" y="4"/>
                  </a:lnTo>
                  <a:lnTo>
                    <a:pt x="4853" y="3"/>
                  </a:lnTo>
                  <a:lnTo>
                    <a:pt x="4858" y="3"/>
                  </a:lnTo>
                  <a:lnTo>
                    <a:pt x="4863" y="3"/>
                  </a:lnTo>
                  <a:lnTo>
                    <a:pt x="4869" y="2"/>
                  </a:lnTo>
                  <a:lnTo>
                    <a:pt x="4874" y="2"/>
                  </a:lnTo>
                  <a:lnTo>
                    <a:pt x="4879" y="7"/>
                  </a:lnTo>
                  <a:lnTo>
                    <a:pt x="4885" y="16"/>
                  </a:lnTo>
                  <a:lnTo>
                    <a:pt x="4890" y="14"/>
                  </a:lnTo>
                  <a:lnTo>
                    <a:pt x="4895" y="7"/>
                  </a:lnTo>
                  <a:lnTo>
                    <a:pt x="4901" y="7"/>
                  </a:lnTo>
                  <a:lnTo>
                    <a:pt x="4906" y="5"/>
                  </a:lnTo>
                  <a:lnTo>
                    <a:pt x="4911" y="3"/>
                  </a:lnTo>
                  <a:lnTo>
                    <a:pt x="4916" y="3"/>
                  </a:lnTo>
                  <a:lnTo>
                    <a:pt x="4922" y="3"/>
                  </a:lnTo>
                  <a:lnTo>
                    <a:pt x="4927" y="2"/>
                  </a:lnTo>
                  <a:lnTo>
                    <a:pt x="4932" y="3"/>
                  </a:lnTo>
                  <a:lnTo>
                    <a:pt x="4938" y="2"/>
                  </a:lnTo>
                  <a:lnTo>
                    <a:pt x="4943" y="1"/>
                  </a:lnTo>
                  <a:lnTo>
                    <a:pt x="4948" y="1"/>
                  </a:lnTo>
                  <a:lnTo>
                    <a:pt x="4954" y="1"/>
                  </a:lnTo>
                  <a:lnTo>
                    <a:pt x="4959" y="2"/>
                  </a:lnTo>
                  <a:lnTo>
                    <a:pt x="4964" y="4"/>
                  </a:lnTo>
                  <a:lnTo>
                    <a:pt x="4970" y="13"/>
                  </a:lnTo>
                  <a:lnTo>
                    <a:pt x="4975" y="24"/>
                  </a:lnTo>
                  <a:lnTo>
                    <a:pt x="4980" y="20"/>
                  </a:lnTo>
                  <a:lnTo>
                    <a:pt x="4985" y="11"/>
                  </a:lnTo>
                  <a:lnTo>
                    <a:pt x="4991" y="10"/>
                  </a:lnTo>
                  <a:lnTo>
                    <a:pt x="4996" y="9"/>
                  </a:lnTo>
                  <a:lnTo>
                    <a:pt x="5001" y="6"/>
                  </a:lnTo>
                  <a:lnTo>
                    <a:pt x="5007" y="4"/>
                  </a:lnTo>
                  <a:lnTo>
                    <a:pt x="5012" y="3"/>
                  </a:lnTo>
                  <a:lnTo>
                    <a:pt x="5017" y="3"/>
                  </a:lnTo>
                  <a:lnTo>
                    <a:pt x="5023" y="3"/>
                  </a:lnTo>
                  <a:lnTo>
                    <a:pt x="5028" y="3"/>
                  </a:lnTo>
                  <a:lnTo>
                    <a:pt x="5033" y="3"/>
                  </a:lnTo>
                  <a:lnTo>
                    <a:pt x="5039" y="3"/>
                  </a:lnTo>
                  <a:lnTo>
                    <a:pt x="5044" y="1"/>
                  </a:lnTo>
                  <a:lnTo>
                    <a:pt x="5049" y="2"/>
                  </a:lnTo>
                  <a:lnTo>
                    <a:pt x="5054" y="3"/>
                  </a:lnTo>
                  <a:lnTo>
                    <a:pt x="5060" y="5"/>
                  </a:lnTo>
                  <a:lnTo>
                    <a:pt x="5065" y="5"/>
                  </a:lnTo>
                  <a:lnTo>
                    <a:pt x="5070" y="5"/>
                  </a:lnTo>
                  <a:lnTo>
                    <a:pt x="5076" y="6"/>
                  </a:lnTo>
                  <a:lnTo>
                    <a:pt x="5081" y="5"/>
                  </a:lnTo>
                  <a:lnTo>
                    <a:pt x="5086" y="3"/>
                  </a:lnTo>
                  <a:lnTo>
                    <a:pt x="5092" y="2"/>
                  </a:lnTo>
                  <a:lnTo>
                    <a:pt x="5097" y="2"/>
                  </a:lnTo>
                  <a:lnTo>
                    <a:pt x="5102" y="2"/>
                  </a:lnTo>
                  <a:lnTo>
                    <a:pt x="5108" y="3"/>
                  </a:lnTo>
                  <a:lnTo>
                    <a:pt x="5113" y="2"/>
                  </a:lnTo>
                  <a:lnTo>
                    <a:pt x="5118" y="3"/>
                  </a:lnTo>
                  <a:lnTo>
                    <a:pt x="5123" y="3"/>
                  </a:lnTo>
                  <a:lnTo>
                    <a:pt x="5129" y="2"/>
                  </a:lnTo>
                  <a:lnTo>
                    <a:pt x="5134" y="2"/>
                  </a:lnTo>
                  <a:lnTo>
                    <a:pt x="5139" y="3"/>
                  </a:lnTo>
                  <a:lnTo>
                    <a:pt x="5145" y="1"/>
                  </a:lnTo>
                  <a:lnTo>
                    <a:pt x="5150" y="1"/>
                  </a:lnTo>
                  <a:lnTo>
                    <a:pt x="5155" y="1"/>
                  </a:lnTo>
                  <a:lnTo>
                    <a:pt x="5161" y="1"/>
                  </a:lnTo>
                  <a:lnTo>
                    <a:pt x="5166" y="0"/>
                  </a:lnTo>
                  <a:lnTo>
                    <a:pt x="5171" y="1"/>
                  </a:lnTo>
                  <a:lnTo>
                    <a:pt x="5177" y="3"/>
                  </a:lnTo>
                  <a:lnTo>
                    <a:pt x="5182" y="3"/>
                  </a:lnTo>
                  <a:lnTo>
                    <a:pt x="5187" y="9"/>
                  </a:lnTo>
                  <a:lnTo>
                    <a:pt x="5192" y="14"/>
                  </a:lnTo>
                  <a:lnTo>
                    <a:pt x="5198" y="10"/>
                  </a:lnTo>
                  <a:lnTo>
                    <a:pt x="5203" y="4"/>
                  </a:lnTo>
                  <a:lnTo>
                    <a:pt x="5208" y="3"/>
                  </a:lnTo>
                  <a:lnTo>
                    <a:pt x="5214" y="1"/>
                  </a:lnTo>
                  <a:lnTo>
                    <a:pt x="5219" y="2"/>
                  </a:lnTo>
                  <a:lnTo>
                    <a:pt x="5224" y="1"/>
                  </a:lnTo>
                  <a:lnTo>
                    <a:pt x="5230" y="2"/>
                  </a:lnTo>
                  <a:lnTo>
                    <a:pt x="5235" y="5"/>
                  </a:lnTo>
                  <a:lnTo>
                    <a:pt x="5240" y="4"/>
                  </a:lnTo>
                  <a:lnTo>
                    <a:pt x="5246" y="4"/>
                  </a:lnTo>
                  <a:lnTo>
                    <a:pt x="5251" y="2"/>
                  </a:lnTo>
                  <a:lnTo>
                    <a:pt x="5256" y="3"/>
                  </a:lnTo>
                  <a:lnTo>
                    <a:pt x="5261" y="2"/>
                  </a:lnTo>
                  <a:lnTo>
                    <a:pt x="5267" y="3"/>
                  </a:lnTo>
                  <a:lnTo>
                    <a:pt x="5272" y="3"/>
                  </a:lnTo>
                  <a:lnTo>
                    <a:pt x="5277" y="2"/>
                  </a:lnTo>
                  <a:lnTo>
                    <a:pt x="5283" y="2"/>
                  </a:lnTo>
                  <a:lnTo>
                    <a:pt x="5288" y="3"/>
                  </a:lnTo>
                  <a:lnTo>
                    <a:pt x="5293" y="2"/>
                  </a:lnTo>
                  <a:lnTo>
                    <a:pt x="5299" y="3"/>
                  </a:lnTo>
                  <a:lnTo>
                    <a:pt x="5304" y="2"/>
                  </a:lnTo>
                  <a:lnTo>
                    <a:pt x="5309" y="3"/>
                  </a:lnTo>
                  <a:lnTo>
                    <a:pt x="5315" y="3"/>
                  </a:lnTo>
                  <a:lnTo>
                    <a:pt x="5320" y="3"/>
                  </a:lnTo>
                  <a:lnTo>
                    <a:pt x="5325" y="3"/>
                  </a:lnTo>
                  <a:lnTo>
                    <a:pt x="5330" y="2"/>
                  </a:lnTo>
                  <a:lnTo>
                    <a:pt x="5336" y="2"/>
                  </a:lnTo>
                  <a:lnTo>
                    <a:pt x="5341" y="3"/>
                  </a:lnTo>
                  <a:lnTo>
                    <a:pt x="5346" y="3"/>
                  </a:lnTo>
                  <a:lnTo>
                    <a:pt x="5352" y="3"/>
                  </a:lnTo>
                  <a:lnTo>
                    <a:pt x="5357" y="2"/>
                  </a:lnTo>
                  <a:lnTo>
                    <a:pt x="5362" y="3"/>
                  </a:lnTo>
                  <a:lnTo>
                    <a:pt x="5368" y="3"/>
                  </a:lnTo>
                  <a:lnTo>
                    <a:pt x="5373" y="1"/>
                  </a:lnTo>
                  <a:lnTo>
                    <a:pt x="5378" y="2"/>
                  </a:lnTo>
                  <a:lnTo>
                    <a:pt x="5384" y="2"/>
                  </a:lnTo>
                  <a:lnTo>
                    <a:pt x="5389" y="2"/>
                  </a:lnTo>
                  <a:lnTo>
                    <a:pt x="5394" y="2"/>
                  </a:lnTo>
                  <a:lnTo>
                    <a:pt x="5399" y="2"/>
                  </a:lnTo>
                  <a:lnTo>
                    <a:pt x="5405" y="5"/>
                  </a:lnTo>
                  <a:lnTo>
                    <a:pt x="5410" y="10"/>
                  </a:lnTo>
                  <a:lnTo>
                    <a:pt x="5415" y="8"/>
                  </a:lnTo>
                  <a:lnTo>
                    <a:pt x="5421" y="5"/>
                  </a:lnTo>
                  <a:lnTo>
                    <a:pt x="5426" y="16"/>
                  </a:lnTo>
                  <a:lnTo>
                    <a:pt x="5431" y="71"/>
                  </a:lnTo>
                  <a:lnTo>
                    <a:pt x="5437" y="210"/>
                  </a:lnTo>
                  <a:lnTo>
                    <a:pt x="5442" y="251"/>
                  </a:lnTo>
                  <a:lnTo>
                    <a:pt x="5447" y="113"/>
                  </a:lnTo>
                  <a:lnTo>
                    <a:pt x="5453" y="40"/>
                  </a:lnTo>
                  <a:lnTo>
                    <a:pt x="5458" y="22"/>
                  </a:lnTo>
                  <a:lnTo>
                    <a:pt x="5463" y="16"/>
                  </a:lnTo>
                  <a:lnTo>
                    <a:pt x="5468" y="13"/>
                  </a:lnTo>
                  <a:lnTo>
                    <a:pt x="5474" y="22"/>
                  </a:lnTo>
                  <a:lnTo>
                    <a:pt x="5479" y="43"/>
                  </a:lnTo>
                  <a:lnTo>
                    <a:pt x="5484" y="41"/>
                  </a:lnTo>
                  <a:lnTo>
                    <a:pt x="5490" y="22"/>
                  </a:lnTo>
                  <a:lnTo>
                    <a:pt x="5495" y="14"/>
                  </a:lnTo>
                  <a:lnTo>
                    <a:pt x="5500" y="11"/>
                  </a:lnTo>
                  <a:lnTo>
                    <a:pt x="5506" y="9"/>
                  </a:lnTo>
                  <a:lnTo>
                    <a:pt x="5511" y="7"/>
                  </a:lnTo>
                  <a:lnTo>
                    <a:pt x="5516" y="6"/>
                  </a:lnTo>
                  <a:lnTo>
                    <a:pt x="5522" y="7"/>
                  </a:lnTo>
                  <a:lnTo>
                    <a:pt x="5527" y="5"/>
                  </a:lnTo>
                  <a:lnTo>
                    <a:pt x="5532" y="6"/>
                  </a:lnTo>
                  <a:lnTo>
                    <a:pt x="5537" y="6"/>
                  </a:lnTo>
                  <a:lnTo>
                    <a:pt x="5543" y="6"/>
                  </a:lnTo>
                  <a:lnTo>
                    <a:pt x="5548" y="5"/>
                  </a:lnTo>
                  <a:lnTo>
                    <a:pt x="5553" y="10"/>
                  </a:lnTo>
                  <a:lnTo>
                    <a:pt x="5559" y="15"/>
                  </a:lnTo>
                  <a:lnTo>
                    <a:pt x="5564" y="14"/>
                  </a:lnTo>
                  <a:lnTo>
                    <a:pt x="5569" y="9"/>
                  </a:lnTo>
                  <a:lnTo>
                    <a:pt x="5575" y="6"/>
                  </a:lnTo>
                  <a:lnTo>
                    <a:pt x="5580" y="6"/>
                  </a:lnTo>
                  <a:lnTo>
                    <a:pt x="5585" y="9"/>
                  </a:lnTo>
                  <a:lnTo>
                    <a:pt x="5591" y="8"/>
                  </a:lnTo>
                  <a:lnTo>
                    <a:pt x="5596" y="6"/>
                  </a:lnTo>
                  <a:lnTo>
                    <a:pt x="5601" y="5"/>
                  </a:lnTo>
                  <a:lnTo>
                    <a:pt x="5606" y="4"/>
                  </a:lnTo>
                  <a:lnTo>
                    <a:pt x="5612" y="4"/>
                  </a:lnTo>
                  <a:lnTo>
                    <a:pt x="5617" y="4"/>
                  </a:lnTo>
                  <a:lnTo>
                    <a:pt x="5622" y="4"/>
                  </a:lnTo>
                  <a:lnTo>
                    <a:pt x="5628" y="3"/>
                  </a:lnTo>
                  <a:lnTo>
                    <a:pt x="5633" y="3"/>
                  </a:lnTo>
                  <a:lnTo>
                    <a:pt x="5638" y="2"/>
                  </a:lnTo>
                  <a:lnTo>
                    <a:pt x="5644" y="8"/>
                  </a:lnTo>
                  <a:lnTo>
                    <a:pt x="5649" y="48"/>
                  </a:lnTo>
                  <a:lnTo>
                    <a:pt x="5654" y="161"/>
                  </a:lnTo>
                  <a:lnTo>
                    <a:pt x="5660" y="173"/>
                  </a:lnTo>
                  <a:lnTo>
                    <a:pt x="5665" y="76"/>
                  </a:lnTo>
                  <a:lnTo>
                    <a:pt x="5670" y="35"/>
                  </a:lnTo>
                  <a:lnTo>
                    <a:pt x="5675" y="19"/>
                  </a:lnTo>
                  <a:lnTo>
                    <a:pt x="5681" y="15"/>
                  </a:lnTo>
                  <a:lnTo>
                    <a:pt x="5686" y="10"/>
                  </a:lnTo>
                  <a:lnTo>
                    <a:pt x="5691" y="9"/>
                  </a:lnTo>
                  <a:lnTo>
                    <a:pt x="5697" y="8"/>
                  </a:lnTo>
                  <a:lnTo>
                    <a:pt x="5702" y="9"/>
                  </a:lnTo>
                  <a:lnTo>
                    <a:pt x="5707" y="9"/>
                  </a:lnTo>
                  <a:lnTo>
                    <a:pt x="5713" y="6"/>
                  </a:lnTo>
                  <a:lnTo>
                    <a:pt x="5718" y="7"/>
                  </a:lnTo>
                  <a:lnTo>
                    <a:pt x="5723" y="5"/>
                  </a:lnTo>
                  <a:lnTo>
                    <a:pt x="5729" y="6"/>
                  </a:lnTo>
                  <a:lnTo>
                    <a:pt x="5734" y="5"/>
                  </a:lnTo>
                  <a:lnTo>
                    <a:pt x="5739" y="5"/>
                  </a:lnTo>
                  <a:lnTo>
                    <a:pt x="5744" y="5"/>
                  </a:lnTo>
                  <a:lnTo>
                    <a:pt x="5750" y="4"/>
                  </a:lnTo>
                  <a:lnTo>
                    <a:pt x="5755" y="5"/>
                  </a:lnTo>
                  <a:lnTo>
                    <a:pt x="5760" y="5"/>
                  </a:lnTo>
                  <a:lnTo>
                    <a:pt x="5766" y="5"/>
                  </a:lnTo>
                  <a:lnTo>
                    <a:pt x="5771" y="6"/>
                  </a:lnTo>
                  <a:lnTo>
                    <a:pt x="5776" y="7"/>
                  </a:lnTo>
                  <a:lnTo>
                    <a:pt x="5782" y="6"/>
                  </a:lnTo>
                  <a:lnTo>
                    <a:pt x="5787" y="5"/>
                  </a:lnTo>
                  <a:lnTo>
                    <a:pt x="5792" y="3"/>
                  </a:lnTo>
                  <a:lnTo>
                    <a:pt x="5798" y="4"/>
                  </a:lnTo>
                  <a:lnTo>
                    <a:pt x="5803" y="4"/>
                  </a:lnTo>
                  <a:lnTo>
                    <a:pt x="5808" y="5"/>
                  </a:lnTo>
                  <a:lnTo>
                    <a:pt x="5813" y="3"/>
                  </a:lnTo>
                  <a:lnTo>
                    <a:pt x="5819" y="4"/>
                  </a:lnTo>
                  <a:lnTo>
                    <a:pt x="5824" y="3"/>
                  </a:lnTo>
                  <a:lnTo>
                    <a:pt x="5829" y="4"/>
                  </a:lnTo>
                  <a:lnTo>
                    <a:pt x="5835" y="4"/>
                  </a:lnTo>
                  <a:lnTo>
                    <a:pt x="5840" y="3"/>
                  </a:lnTo>
                  <a:lnTo>
                    <a:pt x="5845" y="5"/>
                  </a:lnTo>
                  <a:lnTo>
                    <a:pt x="5851" y="5"/>
                  </a:lnTo>
                  <a:lnTo>
                    <a:pt x="5856" y="4"/>
                  </a:lnTo>
                  <a:lnTo>
                    <a:pt x="5861" y="5"/>
                  </a:lnTo>
                  <a:lnTo>
                    <a:pt x="5867" y="5"/>
                  </a:lnTo>
                  <a:lnTo>
                    <a:pt x="5872" y="2"/>
                  </a:lnTo>
                  <a:lnTo>
                    <a:pt x="5877" y="3"/>
                  </a:lnTo>
                  <a:lnTo>
                    <a:pt x="5882" y="4"/>
                  </a:lnTo>
                  <a:lnTo>
                    <a:pt x="5888" y="3"/>
                  </a:lnTo>
                  <a:lnTo>
                    <a:pt x="5893" y="5"/>
                  </a:lnTo>
                  <a:lnTo>
                    <a:pt x="5898" y="6"/>
                  </a:lnTo>
                  <a:lnTo>
                    <a:pt x="5904" y="7"/>
                  </a:lnTo>
                  <a:lnTo>
                    <a:pt x="5909" y="7"/>
                  </a:lnTo>
                  <a:lnTo>
                    <a:pt x="5914" y="7"/>
                  </a:lnTo>
                  <a:lnTo>
                    <a:pt x="5920" y="7"/>
                  </a:lnTo>
                  <a:lnTo>
                    <a:pt x="5925" y="10"/>
                  </a:lnTo>
                  <a:lnTo>
                    <a:pt x="5930" y="11"/>
                  </a:lnTo>
                  <a:lnTo>
                    <a:pt x="5936" y="11"/>
                  </a:lnTo>
                  <a:lnTo>
                    <a:pt x="5941" y="9"/>
                  </a:lnTo>
                  <a:lnTo>
                    <a:pt x="5946" y="8"/>
                  </a:lnTo>
                  <a:lnTo>
                    <a:pt x="5951" y="7"/>
                  </a:lnTo>
                  <a:lnTo>
                    <a:pt x="5957" y="7"/>
                  </a:lnTo>
                  <a:lnTo>
                    <a:pt x="5962" y="8"/>
                  </a:lnTo>
                  <a:lnTo>
                    <a:pt x="5967" y="7"/>
                  </a:lnTo>
                  <a:lnTo>
                    <a:pt x="5973" y="5"/>
                  </a:lnTo>
                  <a:lnTo>
                    <a:pt x="5978" y="3"/>
                  </a:lnTo>
                  <a:lnTo>
                    <a:pt x="5983" y="3"/>
                  </a:lnTo>
                  <a:lnTo>
                    <a:pt x="5989" y="3"/>
                  </a:lnTo>
                  <a:lnTo>
                    <a:pt x="5994" y="2"/>
                  </a:lnTo>
                  <a:lnTo>
                    <a:pt x="5999" y="3"/>
                  </a:lnTo>
                  <a:lnTo>
                    <a:pt x="6005" y="5"/>
                  </a:lnTo>
                  <a:lnTo>
                    <a:pt x="6010" y="6"/>
                  </a:lnTo>
                  <a:lnTo>
                    <a:pt x="6015" y="5"/>
                  </a:lnTo>
                  <a:lnTo>
                    <a:pt x="6020" y="5"/>
                  </a:lnTo>
                  <a:lnTo>
                    <a:pt x="6026" y="5"/>
                  </a:lnTo>
                  <a:lnTo>
                    <a:pt x="6031" y="5"/>
                  </a:lnTo>
                  <a:lnTo>
                    <a:pt x="6036" y="5"/>
                  </a:lnTo>
                  <a:lnTo>
                    <a:pt x="6042" y="5"/>
                  </a:lnTo>
                  <a:lnTo>
                    <a:pt x="6047" y="6"/>
                  </a:lnTo>
                  <a:lnTo>
                    <a:pt x="6052" y="5"/>
                  </a:lnTo>
                  <a:lnTo>
                    <a:pt x="6058" y="4"/>
                  </a:lnTo>
                  <a:lnTo>
                    <a:pt x="6063" y="3"/>
                  </a:lnTo>
                  <a:lnTo>
                    <a:pt x="6068" y="3"/>
                  </a:lnTo>
                  <a:lnTo>
                    <a:pt x="6074" y="4"/>
                  </a:lnTo>
                  <a:lnTo>
                    <a:pt x="6079" y="4"/>
                  </a:lnTo>
                  <a:lnTo>
                    <a:pt x="6084" y="5"/>
                  </a:lnTo>
                  <a:lnTo>
                    <a:pt x="6089" y="6"/>
                  </a:lnTo>
                  <a:lnTo>
                    <a:pt x="6095" y="6"/>
                  </a:lnTo>
                  <a:lnTo>
                    <a:pt x="6100" y="5"/>
                  </a:lnTo>
                  <a:lnTo>
                    <a:pt x="6105" y="4"/>
                  </a:lnTo>
                  <a:lnTo>
                    <a:pt x="6111" y="5"/>
                  </a:lnTo>
                  <a:lnTo>
                    <a:pt x="6116" y="4"/>
                  </a:lnTo>
                  <a:lnTo>
                    <a:pt x="6121" y="3"/>
                  </a:lnTo>
                  <a:lnTo>
                    <a:pt x="6127" y="4"/>
                  </a:lnTo>
                  <a:lnTo>
                    <a:pt x="6132" y="3"/>
                  </a:lnTo>
                  <a:lnTo>
                    <a:pt x="6137" y="5"/>
                  </a:lnTo>
                  <a:lnTo>
                    <a:pt x="6143" y="3"/>
                  </a:lnTo>
                  <a:lnTo>
                    <a:pt x="6148" y="4"/>
                  </a:lnTo>
                  <a:lnTo>
                    <a:pt x="6153" y="4"/>
                  </a:lnTo>
                  <a:lnTo>
                    <a:pt x="6158" y="3"/>
                  </a:lnTo>
                  <a:lnTo>
                    <a:pt x="6164" y="5"/>
                  </a:lnTo>
                  <a:lnTo>
                    <a:pt x="6169" y="4"/>
                  </a:lnTo>
                  <a:lnTo>
                    <a:pt x="6174" y="5"/>
                  </a:lnTo>
                  <a:lnTo>
                    <a:pt x="6180" y="4"/>
                  </a:lnTo>
                  <a:lnTo>
                    <a:pt x="6185" y="4"/>
                  </a:lnTo>
                  <a:lnTo>
                    <a:pt x="6190" y="4"/>
                  </a:lnTo>
                  <a:lnTo>
                    <a:pt x="6196" y="4"/>
                  </a:lnTo>
                  <a:lnTo>
                    <a:pt x="6201" y="5"/>
                  </a:lnTo>
                  <a:lnTo>
                    <a:pt x="6206" y="5"/>
                  </a:lnTo>
                  <a:lnTo>
                    <a:pt x="6212" y="6"/>
                  </a:lnTo>
                  <a:lnTo>
                    <a:pt x="6217" y="4"/>
                  </a:lnTo>
                  <a:lnTo>
                    <a:pt x="6222" y="5"/>
                  </a:lnTo>
                  <a:lnTo>
                    <a:pt x="6227" y="4"/>
                  </a:lnTo>
                  <a:lnTo>
                    <a:pt x="6233" y="5"/>
                  </a:lnTo>
                  <a:lnTo>
                    <a:pt x="6238" y="5"/>
                  </a:lnTo>
                  <a:lnTo>
                    <a:pt x="6243" y="6"/>
                  </a:lnTo>
                  <a:lnTo>
                    <a:pt x="6249" y="8"/>
                  </a:lnTo>
                  <a:lnTo>
                    <a:pt x="6254" y="14"/>
                  </a:lnTo>
                  <a:lnTo>
                    <a:pt x="6259" y="11"/>
                  </a:lnTo>
                  <a:lnTo>
                    <a:pt x="6265" y="7"/>
                  </a:lnTo>
                  <a:lnTo>
                    <a:pt x="6270" y="8"/>
                  </a:lnTo>
                  <a:lnTo>
                    <a:pt x="6275" y="21"/>
                  </a:lnTo>
                  <a:lnTo>
                    <a:pt x="6281" y="32"/>
                  </a:lnTo>
                  <a:lnTo>
                    <a:pt x="6286" y="23"/>
                  </a:lnTo>
                  <a:lnTo>
                    <a:pt x="6291" y="12"/>
                  </a:lnTo>
                  <a:lnTo>
                    <a:pt x="6296" y="9"/>
                  </a:lnTo>
                  <a:lnTo>
                    <a:pt x="6302" y="8"/>
                  </a:lnTo>
                  <a:lnTo>
                    <a:pt x="6307" y="11"/>
                  </a:lnTo>
                  <a:lnTo>
                    <a:pt x="6312" y="9"/>
                  </a:lnTo>
                  <a:lnTo>
                    <a:pt x="6318" y="9"/>
                  </a:lnTo>
                  <a:lnTo>
                    <a:pt x="6323" y="10"/>
                  </a:lnTo>
                  <a:lnTo>
                    <a:pt x="6328" y="8"/>
                  </a:lnTo>
                  <a:lnTo>
                    <a:pt x="6334" y="8"/>
                  </a:lnTo>
                  <a:lnTo>
                    <a:pt x="6339" y="7"/>
                  </a:lnTo>
                  <a:lnTo>
                    <a:pt x="6344" y="8"/>
                  </a:lnTo>
                  <a:lnTo>
                    <a:pt x="6350" y="8"/>
                  </a:lnTo>
                  <a:lnTo>
                    <a:pt x="6355" y="8"/>
                  </a:lnTo>
                  <a:lnTo>
                    <a:pt x="6360" y="8"/>
                  </a:lnTo>
                  <a:lnTo>
                    <a:pt x="6365" y="8"/>
                  </a:lnTo>
                  <a:lnTo>
                    <a:pt x="6371" y="7"/>
                  </a:lnTo>
                  <a:lnTo>
                    <a:pt x="6376" y="7"/>
                  </a:lnTo>
                  <a:lnTo>
                    <a:pt x="6381" y="8"/>
                  </a:lnTo>
                  <a:lnTo>
                    <a:pt x="6387" y="10"/>
                  </a:lnTo>
                  <a:lnTo>
                    <a:pt x="6392" y="11"/>
                  </a:lnTo>
                  <a:lnTo>
                    <a:pt x="6397" y="10"/>
                  </a:lnTo>
                  <a:lnTo>
                    <a:pt x="6403" y="10"/>
                  </a:lnTo>
                  <a:lnTo>
                    <a:pt x="6408" y="7"/>
                  </a:lnTo>
                  <a:lnTo>
                    <a:pt x="6413" y="9"/>
                  </a:lnTo>
                  <a:lnTo>
                    <a:pt x="6419" y="9"/>
                  </a:lnTo>
                  <a:lnTo>
                    <a:pt x="6424" y="9"/>
                  </a:lnTo>
                  <a:lnTo>
                    <a:pt x="6429" y="11"/>
                  </a:lnTo>
                  <a:lnTo>
                    <a:pt x="6434" y="12"/>
                  </a:lnTo>
                  <a:lnTo>
                    <a:pt x="6440" y="11"/>
                  </a:lnTo>
                  <a:lnTo>
                    <a:pt x="6445" y="11"/>
                  </a:lnTo>
                  <a:lnTo>
                    <a:pt x="6450" y="10"/>
                  </a:lnTo>
                  <a:lnTo>
                    <a:pt x="6456" y="9"/>
                  </a:lnTo>
                  <a:lnTo>
                    <a:pt x="6461" y="10"/>
                  </a:lnTo>
                  <a:lnTo>
                    <a:pt x="6466" y="9"/>
                  </a:lnTo>
                  <a:lnTo>
                    <a:pt x="6472" y="11"/>
                  </a:lnTo>
                  <a:lnTo>
                    <a:pt x="6477" y="12"/>
                  </a:lnTo>
                  <a:lnTo>
                    <a:pt x="6482" y="11"/>
                  </a:lnTo>
                  <a:lnTo>
                    <a:pt x="6488" y="11"/>
                  </a:lnTo>
                  <a:lnTo>
                    <a:pt x="6493" y="11"/>
                  </a:lnTo>
                  <a:lnTo>
                    <a:pt x="6498" y="10"/>
                  </a:lnTo>
                  <a:lnTo>
                    <a:pt x="6503" y="12"/>
                  </a:lnTo>
                  <a:lnTo>
                    <a:pt x="6509" y="11"/>
                  </a:lnTo>
                  <a:lnTo>
                    <a:pt x="6514" y="11"/>
                  </a:lnTo>
                  <a:lnTo>
                    <a:pt x="6519" y="11"/>
                  </a:lnTo>
                  <a:lnTo>
                    <a:pt x="6525" y="10"/>
                  </a:lnTo>
                  <a:lnTo>
                    <a:pt x="6530" y="10"/>
                  </a:lnTo>
                  <a:lnTo>
                    <a:pt x="6535" y="11"/>
                  </a:lnTo>
                  <a:lnTo>
                    <a:pt x="6541" y="13"/>
                  </a:lnTo>
                  <a:lnTo>
                    <a:pt x="6546" y="18"/>
                  </a:lnTo>
                  <a:lnTo>
                    <a:pt x="6551" y="27"/>
                  </a:lnTo>
                  <a:lnTo>
                    <a:pt x="6557" y="31"/>
                  </a:lnTo>
                  <a:lnTo>
                    <a:pt x="6562" y="30"/>
                  </a:lnTo>
                  <a:lnTo>
                    <a:pt x="6567" y="27"/>
                  </a:lnTo>
                  <a:lnTo>
                    <a:pt x="6572" y="21"/>
                  </a:lnTo>
                  <a:lnTo>
                    <a:pt x="6578" y="19"/>
                  </a:lnTo>
                  <a:lnTo>
                    <a:pt x="6583" y="19"/>
                  </a:lnTo>
                  <a:lnTo>
                    <a:pt x="6588" y="17"/>
                  </a:lnTo>
                  <a:lnTo>
                    <a:pt x="6594" y="15"/>
                  </a:lnTo>
                  <a:lnTo>
                    <a:pt x="6599" y="13"/>
                  </a:lnTo>
                  <a:lnTo>
                    <a:pt x="6604" y="14"/>
                  </a:lnTo>
                  <a:lnTo>
                    <a:pt x="6610" y="19"/>
                  </a:lnTo>
                  <a:lnTo>
                    <a:pt x="6615" y="22"/>
                  </a:lnTo>
                  <a:lnTo>
                    <a:pt x="6620" y="23"/>
                  </a:lnTo>
                  <a:lnTo>
                    <a:pt x="6626" y="22"/>
                  </a:lnTo>
                  <a:lnTo>
                    <a:pt x="6631" y="26"/>
                  </a:lnTo>
                  <a:lnTo>
                    <a:pt x="6636" y="31"/>
                  </a:lnTo>
                  <a:lnTo>
                    <a:pt x="6641" y="58"/>
                  </a:lnTo>
                  <a:lnTo>
                    <a:pt x="6647" y="80"/>
                  </a:lnTo>
                  <a:lnTo>
                    <a:pt x="6652" y="56"/>
                  </a:lnTo>
                  <a:lnTo>
                    <a:pt x="6657" y="34"/>
                  </a:lnTo>
                  <a:lnTo>
                    <a:pt x="6663" y="28"/>
                  </a:lnTo>
                  <a:lnTo>
                    <a:pt x="6668" y="23"/>
                  </a:lnTo>
                  <a:lnTo>
                    <a:pt x="6673" y="20"/>
                  </a:lnTo>
                  <a:lnTo>
                    <a:pt x="6679" y="19"/>
                  </a:lnTo>
                  <a:lnTo>
                    <a:pt x="6684" y="19"/>
                  </a:lnTo>
                  <a:lnTo>
                    <a:pt x="6689" y="18"/>
                  </a:lnTo>
                  <a:lnTo>
                    <a:pt x="6695" y="18"/>
                  </a:lnTo>
                  <a:lnTo>
                    <a:pt x="6700" y="18"/>
                  </a:lnTo>
                  <a:lnTo>
                    <a:pt x="6705" y="17"/>
                  </a:lnTo>
                  <a:lnTo>
                    <a:pt x="6710" y="17"/>
                  </a:lnTo>
                  <a:lnTo>
                    <a:pt x="6716" y="18"/>
                  </a:lnTo>
                  <a:lnTo>
                    <a:pt x="6721" y="17"/>
                  </a:lnTo>
                  <a:lnTo>
                    <a:pt x="6726" y="16"/>
                  </a:lnTo>
                  <a:lnTo>
                    <a:pt x="6732" y="18"/>
                  </a:lnTo>
                  <a:lnTo>
                    <a:pt x="6737" y="22"/>
                  </a:lnTo>
                  <a:lnTo>
                    <a:pt x="6742" y="25"/>
                  </a:lnTo>
                  <a:lnTo>
                    <a:pt x="6748" y="23"/>
                  </a:lnTo>
                  <a:lnTo>
                    <a:pt x="6753" y="20"/>
                  </a:lnTo>
                  <a:lnTo>
                    <a:pt x="6758" y="18"/>
                  </a:lnTo>
                  <a:lnTo>
                    <a:pt x="6764" y="19"/>
                  </a:lnTo>
                  <a:lnTo>
                    <a:pt x="6769" y="19"/>
                  </a:lnTo>
                  <a:lnTo>
                    <a:pt x="6774" y="19"/>
                  </a:lnTo>
                  <a:lnTo>
                    <a:pt x="6779" y="18"/>
                  </a:lnTo>
                  <a:lnTo>
                    <a:pt x="6785" y="17"/>
                  </a:lnTo>
                  <a:lnTo>
                    <a:pt x="6790" y="17"/>
                  </a:lnTo>
                  <a:lnTo>
                    <a:pt x="6795" y="20"/>
                  </a:lnTo>
                  <a:lnTo>
                    <a:pt x="6801" y="22"/>
                  </a:lnTo>
                  <a:lnTo>
                    <a:pt x="6806" y="22"/>
                  </a:lnTo>
                  <a:lnTo>
                    <a:pt x="6811" y="25"/>
                  </a:lnTo>
                  <a:lnTo>
                    <a:pt x="6817" y="28"/>
                  </a:lnTo>
                  <a:lnTo>
                    <a:pt x="6822" y="28"/>
                  </a:lnTo>
                  <a:lnTo>
                    <a:pt x="6827" y="22"/>
                  </a:lnTo>
                  <a:lnTo>
                    <a:pt x="6833" y="21"/>
                  </a:lnTo>
                  <a:lnTo>
                    <a:pt x="6838" y="22"/>
                  </a:lnTo>
                  <a:lnTo>
                    <a:pt x="6843" y="20"/>
                  </a:lnTo>
                  <a:lnTo>
                    <a:pt x="6848" y="20"/>
                  </a:lnTo>
                  <a:lnTo>
                    <a:pt x="6854" y="24"/>
                  </a:lnTo>
                  <a:lnTo>
                    <a:pt x="6859" y="28"/>
                  </a:lnTo>
                  <a:lnTo>
                    <a:pt x="6864" y="25"/>
                  </a:lnTo>
                  <a:lnTo>
                    <a:pt x="6870" y="21"/>
                  </a:lnTo>
                  <a:lnTo>
                    <a:pt x="6875" y="19"/>
                  </a:lnTo>
                  <a:lnTo>
                    <a:pt x="6880" y="20"/>
                  </a:lnTo>
                  <a:lnTo>
                    <a:pt x="6886" y="19"/>
                  </a:lnTo>
                  <a:lnTo>
                    <a:pt x="6891" y="22"/>
                  </a:lnTo>
                  <a:lnTo>
                    <a:pt x="6896" y="22"/>
                  </a:lnTo>
                  <a:lnTo>
                    <a:pt x="6902" y="21"/>
                  </a:lnTo>
                  <a:lnTo>
                    <a:pt x="6907" y="19"/>
                  </a:lnTo>
                  <a:lnTo>
                    <a:pt x="6912" y="19"/>
                  </a:lnTo>
                  <a:lnTo>
                    <a:pt x="6917" y="18"/>
                  </a:lnTo>
                  <a:lnTo>
                    <a:pt x="6923" y="18"/>
                  </a:lnTo>
                  <a:lnTo>
                    <a:pt x="6928" y="18"/>
                  </a:lnTo>
                  <a:lnTo>
                    <a:pt x="6933" y="19"/>
                  </a:lnTo>
                  <a:lnTo>
                    <a:pt x="6939" y="19"/>
                  </a:lnTo>
                  <a:lnTo>
                    <a:pt x="6944" y="18"/>
                  </a:lnTo>
                  <a:lnTo>
                    <a:pt x="6949" y="17"/>
                  </a:lnTo>
                  <a:lnTo>
                    <a:pt x="6955" y="16"/>
                  </a:lnTo>
                  <a:lnTo>
                    <a:pt x="6960" y="16"/>
                  </a:lnTo>
                  <a:lnTo>
                    <a:pt x="6965" y="15"/>
                  </a:lnTo>
                  <a:lnTo>
                    <a:pt x="6971" y="16"/>
                  </a:lnTo>
                  <a:lnTo>
                    <a:pt x="6976" y="15"/>
                  </a:lnTo>
                  <a:lnTo>
                    <a:pt x="6981" y="16"/>
                  </a:lnTo>
                  <a:lnTo>
                    <a:pt x="6986" y="18"/>
                  </a:lnTo>
                  <a:lnTo>
                    <a:pt x="6992" y="22"/>
                  </a:lnTo>
                  <a:lnTo>
                    <a:pt x="6997" y="26"/>
                  </a:lnTo>
                  <a:lnTo>
                    <a:pt x="7002" y="56"/>
                  </a:lnTo>
                  <a:lnTo>
                    <a:pt x="7008" y="135"/>
                  </a:lnTo>
                  <a:lnTo>
                    <a:pt x="7013" y="185"/>
                  </a:lnTo>
                  <a:lnTo>
                    <a:pt x="7018" y="147"/>
                  </a:lnTo>
                  <a:lnTo>
                    <a:pt x="7024" y="95"/>
                  </a:lnTo>
                  <a:lnTo>
                    <a:pt x="7029" y="67"/>
                  </a:lnTo>
                  <a:lnTo>
                    <a:pt x="7034" y="55"/>
                  </a:lnTo>
                  <a:lnTo>
                    <a:pt x="7040" y="55"/>
                  </a:lnTo>
                  <a:lnTo>
                    <a:pt x="7045" y="78"/>
                  </a:lnTo>
                  <a:lnTo>
                    <a:pt x="7050" y="121"/>
                  </a:lnTo>
                  <a:lnTo>
                    <a:pt x="7055" y="134"/>
                  </a:lnTo>
                  <a:lnTo>
                    <a:pt x="7061" y="102"/>
                  </a:lnTo>
                  <a:lnTo>
                    <a:pt x="7066" y="75"/>
                  </a:lnTo>
                  <a:lnTo>
                    <a:pt x="7071" y="62"/>
                  </a:lnTo>
                  <a:lnTo>
                    <a:pt x="7077" y="53"/>
                  </a:lnTo>
                  <a:lnTo>
                    <a:pt x="7082" y="51"/>
                  </a:lnTo>
                  <a:lnTo>
                    <a:pt x="7087" y="44"/>
                  </a:lnTo>
                  <a:lnTo>
                    <a:pt x="7093" y="42"/>
                  </a:lnTo>
                  <a:lnTo>
                    <a:pt x="7098" y="38"/>
                  </a:lnTo>
                  <a:lnTo>
                    <a:pt x="7103" y="36"/>
                  </a:lnTo>
                  <a:lnTo>
                    <a:pt x="7109" y="36"/>
                  </a:lnTo>
                  <a:lnTo>
                    <a:pt x="7114" y="35"/>
                  </a:lnTo>
                  <a:lnTo>
                    <a:pt x="7119" y="35"/>
                  </a:lnTo>
                  <a:lnTo>
                    <a:pt x="7124" y="35"/>
                  </a:lnTo>
                  <a:lnTo>
                    <a:pt x="7130" y="34"/>
                  </a:lnTo>
                  <a:lnTo>
                    <a:pt x="7135" y="34"/>
                  </a:lnTo>
                  <a:lnTo>
                    <a:pt x="7140" y="36"/>
                  </a:lnTo>
                  <a:lnTo>
                    <a:pt x="7146" y="36"/>
                  </a:lnTo>
                  <a:lnTo>
                    <a:pt x="7151" y="35"/>
                  </a:lnTo>
                  <a:lnTo>
                    <a:pt x="7156" y="36"/>
                  </a:lnTo>
                  <a:lnTo>
                    <a:pt x="7162" y="36"/>
                  </a:lnTo>
                  <a:lnTo>
                    <a:pt x="7167" y="36"/>
                  </a:lnTo>
                  <a:lnTo>
                    <a:pt x="7172" y="34"/>
                  </a:lnTo>
                  <a:lnTo>
                    <a:pt x="7178" y="34"/>
                  </a:lnTo>
                  <a:lnTo>
                    <a:pt x="7183" y="35"/>
                  </a:lnTo>
                  <a:lnTo>
                    <a:pt x="7188" y="33"/>
                  </a:lnTo>
                  <a:lnTo>
                    <a:pt x="7193" y="32"/>
                  </a:lnTo>
                  <a:lnTo>
                    <a:pt x="7199" y="31"/>
                  </a:lnTo>
                  <a:lnTo>
                    <a:pt x="7204" y="29"/>
                  </a:lnTo>
                  <a:lnTo>
                    <a:pt x="7209" y="28"/>
                  </a:lnTo>
                  <a:lnTo>
                    <a:pt x="7215" y="27"/>
                  </a:lnTo>
                  <a:lnTo>
                    <a:pt x="7220" y="26"/>
                  </a:lnTo>
                  <a:lnTo>
                    <a:pt x="7225" y="24"/>
                  </a:lnTo>
                  <a:lnTo>
                    <a:pt x="7231" y="25"/>
                  </a:lnTo>
                  <a:lnTo>
                    <a:pt x="7236" y="28"/>
                  </a:lnTo>
                  <a:lnTo>
                    <a:pt x="7241" y="30"/>
                  </a:lnTo>
                  <a:lnTo>
                    <a:pt x="7247" y="29"/>
                  </a:lnTo>
                  <a:lnTo>
                    <a:pt x="7252" y="28"/>
                  </a:lnTo>
                  <a:lnTo>
                    <a:pt x="7257" y="26"/>
                  </a:lnTo>
                  <a:lnTo>
                    <a:pt x="7262" y="27"/>
                  </a:lnTo>
                  <a:lnTo>
                    <a:pt x="7268" y="25"/>
                  </a:lnTo>
                  <a:lnTo>
                    <a:pt x="7273" y="27"/>
                  </a:lnTo>
                  <a:lnTo>
                    <a:pt x="7278" y="24"/>
                  </a:lnTo>
                  <a:lnTo>
                    <a:pt x="7284" y="23"/>
                  </a:lnTo>
                  <a:lnTo>
                    <a:pt x="7289" y="21"/>
                  </a:lnTo>
                  <a:lnTo>
                    <a:pt x="7294" y="21"/>
                  </a:lnTo>
                  <a:lnTo>
                    <a:pt x="7300" y="21"/>
                  </a:lnTo>
                  <a:lnTo>
                    <a:pt x="7305" y="21"/>
                  </a:lnTo>
                  <a:lnTo>
                    <a:pt x="7310" y="19"/>
                  </a:lnTo>
                  <a:lnTo>
                    <a:pt x="7316" y="18"/>
                  </a:lnTo>
                  <a:lnTo>
                    <a:pt x="7321" y="19"/>
                  </a:lnTo>
                  <a:lnTo>
                    <a:pt x="7326" y="19"/>
                  </a:lnTo>
                  <a:lnTo>
                    <a:pt x="7331" y="20"/>
                  </a:lnTo>
                  <a:lnTo>
                    <a:pt x="7337" y="26"/>
                  </a:lnTo>
                  <a:lnTo>
                    <a:pt x="7342" y="42"/>
                  </a:lnTo>
                  <a:lnTo>
                    <a:pt x="7347" y="110"/>
                  </a:lnTo>
                  <a:lnTo>
                    <a:pt x="7353" y="409"/>
                  </a:lnTo>
                  <a:lnTo>
                    <a:pt x="7358" y="1491"/>
                  </a:lnTo>
                  <a:lnTo>
                    <a:pt x="7363" y="3781"/>
                  </a:lnTo>
                  <a:lnTo>
                    <a:pt x="7369" y="6444"/>
                  </a:lnTo>
                  <a:lnTo>
                    <a:pt x="7374" y="7130"/>
                  </a:lnTo>
                  <a:lnTo>
                    <a:pt x="7379" y="3317"/>
                  </a:lnTo>
                  <a:lnTo>
                    <a:pt x="7385" y="1407"/>
                  </a:lnTo>
                  <a:lnTo>
                    <a:pt x="7390" y="875"/>
                  </a:lnTo>
                  <a:lnTo>
                    <a:pt x="7395" y="625"/>
                  </a:lnTo>
                  <a:lnTo>
                    <a:pt x="7400" y="476"/>
                  </a:lnTo>
                  <a:lnTo>
                    <a:pt x="7406" y="380"/>
                  </a:lnTo>
                  <a:lnTo>
                    <a:pt x="7411" y="324"/>
                  </a:lnTo>
                  <a:lnTo>
                    <a:pt x="7416" y="285"/>
                  </a:lnTo>
                  <a:lnTo>
                    <a:pt x="7422" y="250"/>
                  </a:lnTo>
                  <a:lnTo>
                    <a:pt x="7427" y="218"/>
                  </a:lnTo>
                  <a:lnTo>
                    <a:pt x="7432" y="195"/>
                  </a:lnTo>
                  <a:lnTo>
                    <a:pt x="7438" y="173"/>
                  </a:lnTo>
                  <a:lnTo>
                    <a:pt x="7443" y="156"/>
                  </a:lnTo>
                  <a:lnTo>
                    <a:pt x="7448" y="141"/>
                  </a:lnTo>
                  <a:lnTo>
                    <a:pt x="7454" y="130"/>
                  </a:lnTo>
                  <a:lnTo>
                    <a:pt x="7459" y="122"/>
                  </a:lnTo>
                  <a:lnTo>
                    <a:pt x="7464" y="112"/>
                  </a:lnTo>
                  <a:lnTo>
                    <a:pt x="7469" y="104"/>
                  </a:lnTo>
                  <a:lnTo>
                    <a:pt x="7475" y="98"/>
                  </a:lnTo>
                  <a:lnTo>
                    <a:pt x="7480" y="91"/>
                  </a:lnTo>
                  <a:lnTo>
                    <a:pt x="7485" y="87"/>
                  </a:lnTo>
                  <a:lnTo>
                    <a:pt x="7491" y="84"/>
                  </a:lnTo>
                  <a:lnTo>
                    <a:pt x="7496" y="78"/>
                  </a:lnTo>
                  <a:lnTo>
                    <a:pt x="7501" y="75"/>
                  </a:lnTo>
                  <a:lnTo>
                    <a:pt x="7507" y="71"/>
                  </a:lnTo>
                  <a:lnTo>
                    <a:pt x="7512" y="67"/>
                  </a:lnTo>
                  <a:lnTo>
                    <a:pt x="7517" y="64"/>
                  </a:lnTo>
                  <a:lnTo>
                    <a:pt x="7523" y="61"/>
                  </a:lnTo>
                  <a:lnTo>
                    <a:pt x="7528" y="59"/>
                  </a:lnTo>
                  <a:lnTo>
                    <a:pt x="7533" y="57"/>
                  </a:lnTo>
                  <a:lnTo>
                    <a:pt x="7538" y="55"/>
                  </a:lnTo>
                  <a:lnTo>
                    <a:pt x="7544" y="55"/>
                  </a:lnTo>
                  <a:lnTo>
                    <a:pt x="7549" y="55"/>
                  </a:lnTo>
                  <a:lnTo>
                    <a:pt x="7554" y="58"/>
                  </a:lnTo>
                  <a:lnTo>
                    <a:pt x="7560" y="58"/>
                  </a:lnTo>
                  <a:lnTo>
                    <a:pt x="7565" y="57"/>
                  </a:lnTo>
                  <a:lnTo>
                    <a:pt x="7570" y="57"/>
                  </a:lnTo>
                  <a:lnTo>
                    <a:pt x="7576" y="53"/>
                  </a:lnTo>
                  <a:lnTo>
                    <a:pt x="7581" y="49"/>
                  </a:lnTo>
                  <a:lnTo>
                    <a:pt x="7586" y="47"/>
                  </a:lnTo>
                  <a:lnTo>
                    <a:pt x="7592" y="44"/>
                  </a:lnTo>
                  <a:lnTo>
                    <a:pt x="7597" y="43"/>
                  </a:lnTo>
                  <a:lnTo>
                    <a:pt x="7602" y="42"/>
                  </a:lnTo>
                  <a:lnTo>
                    <a:pt x="7607" y="40"/>
                  </a:lnTo>
                  <a:lnTo>
                    <a:pt x="7613" y="40"/>
                  </a:lnTo>
                  <a:lnTo>
                    <a:pt x="7618" y="38"/>
                  </a:lnTo>
                  <a:lnTo>
                    <a:pt x="7623" y="38"/>
                  </a:lnTo>
                  <a:lnTo>
                    <a:pt x="7629" y="38"/>
                  </a:lnTo>
                  <a:lnTo>
                    <a:pt x="7634" y="39"/>
                  </a:lnTo>
                  <a:lnTo>
                    <a:pt x="7639" y="46"/>
                  </a:lnTo>
                  <a:lnTo>
                    <a:pt x="7645" y="61"/>
                  </a:lnTo>
                  <a:lnTo>
                    <a:pt x="7650" y="75"/>
                  </a:lnTo>
                  <a:lnTo>
                    <a:pt x="7655" y="74"/>
                  </a:lnTo>
                  <a:lnTo>
                    <a:pt x="7661" y="64"/>
                  </a:lnTo>
                  <a:lnTo>
                    <a:pt x="7666" y="54"/>
                  </a:lnTo>
                  <a:lnTo>
                    <a:pt x="7671" y="49"/>
                  </a:lnTo>
                  <a:lnTo>
                    <a:pt x="7676" y="46"/>
                  </a:lnTo>
                  <a:lnTo>
                    <a:pt x="7682" y="43"/>
                  </a:lnTo>
                  <a:lnTo>
                    <a:pt x="7687" y="41"/>
                  </a:lnTo>
                  <a:lnTo>
                    <a:pt x="7692" y="39"/>
                  </a:lnTo>
                  <a:lnTo>
                    <a:pt x="7698" y="38"/>
                  </a:lnTo>
                  <a:lnTo>
                    <a:pt x="7703" y="37"/>
                  </a:lnTo>
                  <a:lnTo>
                    <a:pt x="7708" y="37"/>
                  </a:lnTo>
                  <a:lnTo>
                    <a:pt x="7714" y="35"/>
                  </a:lnTo>
                  <a:lnTo>
                    <a:pt x="7719" y="36"/>
                  </a:lnTo>
                  <a:lnTo>
                    <a:pt x="7724" y="35"/>
                  </a:lnTo>
                  <a:lnTo>
                    <a:pt x="7730" y="34"/>
                  </a:lnTo>
                  <a:lnTo>
                    <a:pt x="7735" y="33"/>
                  </a:lnTo>
                  <a:lnTo>
                    <a:pt x="7740" y="34"/>
                  </a:lnTo>
                  <a:lnTo>
                    <a:pt x="7745" y="31"/>
                  </a:lnTo>
                  <a:lnTo>
                    <a:pt x="7751" y="28"/>
                  </a:lnTo>
                  <a:lnTo>
                    <a:pt x="7756" y="28"/>
                  </a:lnTo>
                  <a:lnTo>
                    <a:pt x="7761" y="28"/>
                  </a:lnTo>
                  <a:lnTo>
                    <a:pt x="7767" y="27"/>
                  </a:lnTo>
                  <a:lnTo>
                    <a:pt x="7772" y="28"/>
                  </a:lnTo>
                  <a:lnTo>
                    <a:pt x="7777" y="27"/>
                  </a:lnTo>
                  <a:lnTo>
                    <a:pt x="7783" y="26"/>
                  </a:lnTo>
                  <a:lnTo>
                    <a:pt x="7788" y="25"/>
                  </a:lnTo>
                  <a:lnTo>
                    <a:pt x="7793" y="24"/>
                  </a:lnTo>
                  <a:lnTo>
                    <a:pt x="7799" y="23"/>
                  </a:lnTo>
                  <a:lnTo>
                    <a:pt x="7804" y="24"/>
                  </a:lnTo>
                  <a:lnTo>
                    <a:pt x="7809" y="24"/>
                  </a:lnTo>
                  <a:lnTo>
                    <a:pt x="7814" y="24"/>
                  </a:lnTo>
                  <a:lnTo>
                    <a:pt x="7820" y="23"/>
                  </a:lnTo>
                  <a:lnTo>
                    <a:pt x="7825" y="24"/>
                  </a:lnTo>
                  <a:lnTo>
                    <a:pt x="7830" y="24"/>
                  </a:lnTo>
                  <a:lnTo>
                    <a:pt x="7836" y="23"/>
                  </a:lnTo>
                  <a:lnTo>
                    <a:pt x="7841" y="21"/>
                  </a:lnTo>
                  <a:lnTo>
                    <a:pt x="7846" y="21"/>
                  </a:lnTo>
                  <a:lnTo>
                    <a:pt x="7852" y="22"/>
                  </a:lnTo>
                  <a:lnTo>
                    <a:pt x="7857" y="21"/>
                  </a:lnTo>
                  <a:lnTo>
                    <a:pt x="7862" y="21"/>
                  </a:lnTo>
                  <a:lnTo>
                    <a:pt x="7868" y="19"/>
                  </a:lnTo>
                  <a:lnTo>
                    <a:pt x="7873" y="20"/>
                  </a:lnTo>
                  <a:lnTo>
                    <a:pt x="7878" y="19"/>
                  </a:lnTo>
                  <a:lnTo>
                    <a:pt x="7883" y="20"/>
                  </a:lnTo>
                  <a:lnTo>
                    <a:pt x="7889" y="20"/>
                  </a:lnTo>
                  <a:lnTo>
                    <a:pt x="7894" y="18"/>
                  </a:lnTo>
                  <a:lnTo>
                    <a:pt x="7899" y="19"/>
                  </a:lnTo>
                  <a:lnTo>
                    <a:pt x="7905" y="19"/>
                  </a:lnTo>
                  <a:lnTo>
                    <a:pt x="7910" y="19"/>
                  </a:lnTo>
                  <a:lnTo>
                    <a:pt x="7915" y="19"/>
                  </a:lnTo>
                  <a:lnTo>
                    <a:pt x="7921" y="19"/>
                  </a:lnTo>
                  <a:lnTo>
                    <a:pt x="7926" y="18"/>
                  </a:lnTo>
                  <a:lnTo>
                    <a:pt x="7931" y="17"/>
                  </a:lnTo>
                  <a:lnTo>
                    <a:pt x="7937" y="19"/>
                  </a:lnTo>
                  <a:lnTo>
                    <a:pt x="7942" y="17"/>
                  </a:lnTo>
                  <a:lnTo>
                    <a:pt x="7947" y="17"/>
                  </a:lnTo>
                  <a:lnTo>
                    <a:pt x="7952" y="17"/>
                  </a:lnTo>
                  <a:lnTo>
                    <a:pt x="7958" y="16"/>
                  </a:lnTo>
                  <a:lnTo>
                    <a:pt x="7963" y="16"/>
                  </a:lnTo>
                  <a:lnTo>
                    <a:pt x="7968" y="14"/>
                  </a:lnTo>
                  <a:lnTo>
                    <a:pt x="7974" y="16"/>
                  </a:lnTo>
                  <a:lnTo>
                    <a:pt x="7979" y="16"/>
                  </a:lnTo>
                  <a:lnTo>
                    <a:pt x="7984" y="19"/>
                  </a:lnTo>
                  <a:lnTo>
                    <a:pt x="7990" y="22"/>
                  </a:lnTo>
                  <a:lnTo>
                    <a:pt x="7995" y="25"/>
                  </a:lnTo>
                  <a:lnTo>
                    <a:pt x="8000" y="26"/>
                  </a:lnTo>
                  <a:lnTo>
                    <a:pt x="8006" y="24"/>
                  </a:lnTo>
                  <a:lnTo>
                    <a:pt x="8011" y="21"/>
                  </a:lnTo>
                  <a:lnTo>
                    <a:pt x="8016" y="21"/>
                  </a:lnTo>
                  <a:lnTo>
                    <a:pt x="8021" y="19"/>
                  </a:lnTo>
                  <a:lnTo>
                    <a:pt x="8027" y="18"/>
                  </a:lnTo>
                  <a:lnTo>
                    <a:pt x="8032" y="17"/>
                  </a:lnTo>
                  <a:lnTo>
                    <a:pt x="8037" y="18"/>
                  </a:lnTo>
                  <a:lnTo>
                    <a:pt x="8043" y="21"/>
                  </a:lnTo>
                  <a:lnTo>
                    <a:pt x="8048" y="27"/>
                  </a:lnTo>
                  <a:lnTo>
                    <a:pt x="8053" y="34"/>
                  </a:lnTo>
                  <a:lnTo>
                    <a:pt x="8059" y="36"/>
                  </a:lnTo>
                  <a:lnTo>
                    <a:pt x="8064" y="33"/>
                  </a:lnTo>
                  <a:lnTo>
                    <a:pt x="8069" y="28"/>
                  </a:lnTo>
                  <a:lnTo>
                    <a:pt x="8075" y="24"/>
                  </a:lnTo>
                  <a:lnTo>
                    <a:pt x="8080" y="22"/>
                  </a:lnTo>
                  <a:lnTo>
                    <a:pt x="8085" y="20"/>
                  </a:lnTo>
                  <a:lnTo>
                    <a:pt x="8090" y="19"/>
                  </a:lnTo>
                  <a:lnTo>
                    <a:pt x="8096" y="18"/>
                  </a:lnTo>
                  <a:lnTo>
                    <a:pt x="8101" y="18"/>
                  </a:lnTo>
                  <a:lnTo>
                    <a:pt x="8106" y="17"/>
                  </a:lnTo>
                  <a:lnTo>
                    <a:pt x="8112" y="17"/>
                  </a:lnTo>
                  <a:lnTo>
                    <a:pt x="8117" y="19"/>
                  </a:lnTo>
                  <a:lnTo>
                    <a:pt x="8122" y="22"/>
                  </a:lnTo>
                  <a:lnTo>
                    <a:pt x="8128" y="30"/>
                  </a:lnTo>
                  <a:lnTo>
                    <a:pt x="8133" y="39"/>
                  </a:lnTo>
                  <a:lnTo>
                    <a:pt x="8138" y="43"/>
                  </a:lnTo>
                  <a:lnTo>
                    <a:pt x="8144" y="39"/>
                  </a:lnTo>
                  <a:lnTo>
                    <a:pt x="8149" y="32"/>
                  </a:lnTo>
                  <a:lnTo>
                    <a:pt x="8154" y="28"/>
                  </a:lnTo>
                  <a:lnTo>
                    <a:pt x="8159" y="24"/>
                  </a:lnTo>
                  <a:lnTo>
                    <a:pt x="8165" y="23"/>
                  </a:lnTo>
                  <a:lnTo>
                    <a:pt x="8170" y="21"/>
                  </a:lnTo>
                  <a:lnTo>
                    <a:pt x="8175" y="21"/>
                  </a:lnTo>
                  <a:lnTo>
                    <a:pt x="8181" y="19"/>
                  </a:lnTo>
                  <a:lnTo>
                    <a:pt x="8186" y="19"/>
                  </a:lnTo>
                  <a:lnTo>
                    <a:pt x="8191" y="19"/>
                  </a:lnTo>
                  <a:lnTo>
                    <a:pt x="8197" y="20"/>
                  </a:lnTo>
                  <a:lnTo>
                    <a:pt x="8202" y="22"/>
                  </a:lnTo>
                  <a:lnTo>
                    <a:pt x="8207" y="21"/>
                  </a:lnTo>
                  <a:lnTo>
                    <a:pt x="8213" y="22"/>
                  </a:lnTo>
                  <a:lnTo>
                    <a:pt x="8218" y="21"/>
                  </a:lnTo>
                  <a:lnTo>
                    <a:pt x="8223" y="19"/>
                  </a:lnTo>
                  <a:lnTo>
                    <a:pt x="8228" y="17"/>
                  </a:lnTo>
                  <a:lnTo>
                    <a:pt x="8234" y="16"/>
                  </a:lnTo>
                  <a:lnTo>
                    <a:pt x="8239" y="16"/>
                  </a:lnTo>
                  <a:lnTo>
                    <a:pt x="8244" y="14"/>
                  </a:lnTo>
                  <a:lnTo>
                    <a:pt x="8250" y="16"/>
                  </a:lnTo>
                  <a:lnTo>
                    <a:pt x="8255" y="14"/>
                  </a:lnTo>
                  <a:lnTo>
                    <a:pt x="8260" y="15"/>
                  </a:lnTo>
                  <a:lnTo>
                    <a:pt x="8266" y="15"/>
                  </a:lnTo>
                  <a:lnTo>
                    <a:pt x="8271" y="14"/>
                  </a:lnTo>
                  <a:lnTo>
                    <a:pt x="8276" y="13"/>
                  </a:lnTo>
                  <a:lnTo>
                    <a:pt x="8282" y="14"/>
                  </a:lnTo>
                  <a:lnTo>
                    <a:pt x="8287" y="12"/>
                  </a:lnTo>
                  <a:lnTo>
                    <a:pt x="8292" y="11"/>
                  </a:lnTo>
                  <a:lnTo>
                    <a:pt x="8297" y="12"/>
                  </a:lnTo>
                  <a:lnTo>
                    <a:pt x="8303" y="12"/>
                  </a:lnTo>
                  <a:lnTo>
                    <a:pt x="8308" y="12"/>
                  </a:lnTo>
                  <a:lnTo>
                    <a:pt x="8313" y="12"/>
                  </a:lnTo>
                  <a:lnTo>
                    <a:pt x="8319" y="11"/>
                  </a:lnTo>
                  <a:lnTo>
                    <a:pt x="8324" y="11"/>
                  </a:lnTo>
                  <a:lnTo>
                    <a:pt x="8329" y="11"/>
                  </a:lnTo>
                  <a:lnTo>
                    <a:pt x="8335" y="11"/>
                  </a:lnTo>
                  <a:lnTo>
                    <a:pt x="8340" y="11"/>
                  </a:lnTo>
                  <a:lnTo>
                    <a:pt x="8345" y="12"/>
                  </a:lnTo>
                  <a:lnTo>
                    <a:pt x="8351" y="13"/>
                  </a:lnTo>
                  <a:lnTo>
                    <a:pt x="8356" y="14"/>
                  </a:lnTo>
                  <a:lnTo>
                    <a:pt x="8361" y="13"/>
                  </a:lnTo>
                  <a:lnTo>
                    <a:pt x="8366" y="13"/>
                  </a:lnTo>
                  <a:lnTo>
                    <a:pt x="8372" y="12"/>
                  </a:lnTo>
                  <a:lnTo>
                    <a:pt x="8377" y="12"/>
                  </a:lnTo>
                  <a:lnTo>
                    <a:pt x="8382" y="10"/>
                  </a:lnTo>
                  <a:lnTo>
                    <a:pt x="8388" y="12"/>
                  </a:lnTo>
                  <a:lnTo>
                    <a:pt x="8393" y="10"/>
                  </a:lnTo>
                  <a:lnTo>
                    <a:pt x="8398" y="11"/>
                  </a:lnTo>
                  <a:lnTo>
                    <a:pt x="8404" y="10"/>
                  </a:lnTo>
                  <a:lnTo>
                    <a:pt x="8409" y="10"/>
                  </a:lnTo>
                  <a:lnTo>
                    <a:pt x="8414" y="10"/>
                  </a:lnTo>
                  <a:lnTo>
                    <a:pt x="8420" y="10"/>
                  </a:lnTo>
                  <a:lnTo>
                    <a:pt x="8425" y="9"/>
                  </a:lnTo>
                  <a:lnTo>
                    <a:pt x="8430" y="10"/>
                  </a:lnTo>
                  <a:lnTo>
                    <a:pt x="8435" y="9"/>
                  </a:lnTo>
                  <a:lnTo>
                    <a:pt x="8441" y="9"/>
                  </a:lnTo>
                  <a:lnTo>
                    <a:pt x="8446" y="10"/>
                  </a:lnTo>
                  <a:lnTo>
                    <a:pt x="8451" y="10"/>
                  </a:lnTo>
                  <a:lnTo>
                    <a:pt x="8457" y="11"/>
                  </a:lnTo>
                  <a:lnTo>
                    <a:pt x="8462" y="10"/>
                  </a:lnTo>
                  <a:lnTo>
                    <a:pt x="8467" y="10"/>
                  </a:lnTo>
                  <a:lnTo>
                    <a:pt x="8473" y="8"/>
                  </a:lnTo>
                  <a:lnTo>
                    <a:pt x="8478" y="9"/>
                  </a:lnTo>
                  <a:lnTo>
                    <a:pt x="8483" y="10"/>
                  </a:lnTo>
                  <a:lnTo>
                    <a:pt x="8489" y="10"/>
                  </a:lnTo>
                  <a:lnTo>
                    <a:pt x="8494" y="10"/>
                  </a:lnTo>
                  <a:lnTo>
                    <a:pt x="8499" y="11"/>
                  </a:lnTo>
                  <a:lnTo>
                    <a:pt x="8504" y="11"/>
                  </a:lnTo>
                  <a:lnTo>
                    <a:pt x="8510" y="10"/>
                  </a:lnTo>
                  <a:lnTo>
                    <a:pt x="8515" y="9"/>
                  </a:lnTo>
                  <a:lnTo>
                    <a:pt x="8520" y="10"/>
                  </a:lnTo>
                  <a:lnTo>
                    <a:pt x="8526" y="9"/>
                  </a:lnTo>
                  <a:lnTo>
                    <a:pt x="8531" y="9"/>
                  </a:lnTo>
                  <a:lnTo>
                    <a:pt x="8536" y="10"/>
                  </a:lnTo>
                  <a:lnTo>
                    <a:pt x="8542" y="7"/>
                  </a:lnTo>
                  <a:lnTo>
                    <a:pt x="8547" y="8"/>
                  </a:lnTo>
                  <a:lnTo>
                    <a:pt x="8552" y="9"/>
                  </a:lnTo>
                  <a:lnTo>
                    <a:pt x="8558" y="7"/>
                  </a:lnTo>
                  <a:lnTo>
                    <a:pt x="8563" y="8"/>
                  </a:lnTo>
                  <a:lnTo>
                    <a:pt x="8568" y="9"/>
                  </a:lnTo>
                  <a:lnTo>
                    <a:pt x="8573" y="7"/>
                  </a:lnTo>
                  <a:lnTo>
                    <a:pt x="8579" y="8"/>
                  </a:lnTo>
                  <a:lnTo>
                    <a:pt x="8584" y="7"/>
                  </a:lnTo>
                  <a:lnTo>
                    <a:pt x="8589" y="8"/>
                  </a:lnTo>
                  <a:lnTo>
                    <a:pt x="8595" y="7"/>
                  </a:lnTo>
                  <a:lnTo>
                    <a:pt x="8600" y="8"/>
                  </a:lnTo>
                  <a:lnTo>
                    <a:pt x="8605" y="8"/>
                  </a:lnTo>
                  <a:lnTo>
                    <a:pt x="8611" y="7"/>
                  </a:lnTo>
                  <a:lnTo>
                    <a:pt x="8616" y="7"/>
                  </a:lnTo>
                  <a:lnTo>
                    <a:pt x="8621" y="8"/>
                  </a:lnTo>
                  <a:lnTo>
                    <a:pt x="8627" y="6"/>
                  </a:lnTo>
                  <a:lnTo>
                    <a:pt x="8632" y="7"/>
                  </a:lnTo>
                  <a:lnTo>
                    <a:pt x="8637" y="7"/>
                  </a:lnTo>
                  <a:lnTo>
                    <a:pt x="8642" y="5"/>
                  </a:lnTo>
                  <a:lnTo>
                    <a:pt x="8648" y="7"/>
                  </a:lnTo>
                  <a:lnTo>
                    <a:pt x="8653" y="6"/>
                  </a:lnTo>
                  <a:lnTo>
                    <a:pt x="8658" y="5"/>
                  </a:lnTo>
                  <a:lnTo>
                    <a:pt x="8664" y="6"/>
                  </a:lnTo>
                  <a:lnTo>
                    <a:pt x="8669" y="7"/>
                  </a:lnTo>
                  <a:lnTo>
                    <a:pt x="8674" y="6"/>
                  </a:lnTo>
                  <a:lnTo>
                    <a:pt x="8680" y="6"/>
                  </a:lnTo>
                  <a:lnTo>
                    <a:pt x="8685" y="7"/>
                  </a:lnTo>
                  <a:lnTo>
                    <a:pt x="8690" y="7"/>
                  </a:lnTo>
                  <a:lnTo>
                    <a:pt x="8696" y="7"/>
                  </a:lnTo>
                  <a:lnTo>
                    <a:pt x="8701" y="8"/>
                  </a:lnTo>
                  <a:lnTo>
                    <a:pt x="8706" y="7"/>
                  </a:lnTo>
                  <a:lnTo>
                    <a:pt x="8711" y="7"/>
                  </a:lnTo>
                  <a:lnTo>
                    <a:pt x="8717" y="6"/>
                  </a:lnTo>
                  <a:lnTo>
                    <a:pt x="8722" y="6"/>
                  </a:lnTo>
                  <a:lnTo>
                    <a:pt x="8727" y="6"/>
                  </a:lnTo>
                  <a:lnTo>
                    <a:pt x="8733" y="7"/>
                  </a:lnTo>
                  <a:lnTo>
                    <a:pt x="8738" y="7"/>
                  </a:lnTo>
                  <a:lnTo>
                    <a:pt x="8743" y="7"/>
                  </a:lnTo>
                  <a:lnTo>
                    <a:pt x="8749" y="5"/>
                  </a:lnTo>
                  <a:lnTo>
                    <a:pt x="8754" y="6"/>
                  </a:lnTo>
                  <a:lnTo>
                    <a:pt x="8759" y="6"/>
                  </a:lnTo>
                  <a:lnTo>
                    <a:pt x="8765" y="6"/>
                  </a:lnTo>
                  <a:lnTo>
                    <a:pt x="8770" y="6"/>
                  </a:lnTo>
                  <a:lnTo>
                    <a:pt x="8775" y="7"/>
                  </a:lnTo>
                  <a:lnTo>
                    <a:pt x="8780" y="6"/>
                  </a:lnTo>
                  <a:lnTo>
                    <a:pt x="8786" y="6"/>
                  </a:lnTo>
                  <a:lnTo>
                    <a:pt x="8791" y="6"/>
                  </a:lnTo>
                  <a:lnTo>
                    <a:pt x="8796" y="6"/>
                  </a:lnTo>
                  <a:lnTo>
                    <a:pt x="8802" y="4"/>
                  </a:lnTo>
                  <a:lnTo>
                    <a:pt x="8807" y="6"/>
                  </a:lnTo>
                  <a:lnTo>
                    <a:pt x="8812" y="6"/>
                  </a:lnTo>
                  <a:lnTo>
                    <a:pt x="8818" y="6"/>
                  </a:lnTo>
                  <a:lnTo>
                    <a:pt x="8823" y="5"/>
                  </a:lnTo>
                  <a:lnTo>
                    <a:pt x="8828" y="6"/>
                  </a:lnTo>
                  <a:lnTo>
                    <a:pt x="8834" y="9"/>
                  </a:lnTo>
                  <a:lnTo>
                    <a:pt x="8839" y="11"/>
                  </a:lnTo>
                  <a:lnTo>
                    <a:pt x="8844" y="17"/>
                  </a:lnTo>
                  <a:lnTo>
                    <a:pt x="8849" y="28"/>
                  </a:lnTo>
                  <a:lnTo>
                    <a:pt x="8855" y="35"/>
                  </a:lnTo>
                  <a:lnTo>
                    <a:pt x="8860" y="39"/>
                  </a:lnTo>
                  <a:lnTo>
                    <a:pt x="8865" y="36"/>
                  </a:lnTo>
                  <a:lnTo>
                    <a:pt x="8871" y="30"/>
                  </a:lnTo>
                  <a:lnTo>
                    <a:pt x="8876" y="22"/>
                  </a:lnTo>
                  <a:lnTo>
                    <a:pt x="8881" y="18"/>
                  </a:lnTo>
                  <a:lnTo>
                    <a:pt x="8887" y="17"/>
                  </a:lnTo>
                  <a:lnTo>
                    <a:pt x="8892" y="15"/>
                  </a:lnTo>
                  <a:lnTo>
                    <a:pt x="8897" y="14"/>
                  </a:lnTo>
                  <a:lnTo>
                    <a:pt x="8903" y="14"/>
                  </a:lnTo>
                  <a:lnTo>
                    <a:pt x="8908" y="11"/>
                  </a:lnTo>
                  <a:lnTo>
                    <a:pt x="8913" y="12"/>
                  </a:lnTo>
                  <a:lnTo>
                    <a:pt x="8918" y="12"/>
                  </a:lnTo>
                  <a:lnTo>
                    <a:pt x="8924" y="9"/>
                  </a:lnTo>
                  <a:lnTo>
                    <a:pt x="8926" y="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Text Box 1074"/>
            <p:cNvSpPr/>
            <p:nvPr/>
          </p:nvSpPr>
          <p:spPr>
            <a:xfrm>
              <a:off x="3168000" y="3583080"/>
              <a:ext cx="136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lution time (min)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2" name="Rectangle 1075"/>
            <p:cNvSpPr/>
            <p:nvPr/>
          </p:nvSpPr>
          <p:spPr>
            <a:xfrm>
              <a:off x="6063480" y="342036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4.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03" name="Groupe 1079"/>
          <p:cNvGrpSpPr/>
          <p:nvPr/>
        </p:nvGrpSpPr>
        <p:grpSpPr>
          <a:xfrm>
            <a:off x="728640" y="3616200"/>
            <a:ext cx="5724720" cy="2691360"/>
            <a:chOff x="728640" y="3616200"/>
            <a:chExt cx="5724720" cy="2691360"/>
          </a:xfrm>
        </p:grpSpPr>
        <p:sp>
          <p:nvSpPr>
            <p:cNvPr id="204" name="Line 5"/>
            <p:cNvSpPr/>
            <p:nvPr/>
          </p:nvSpPr>
          <p:spPr>
            <a:xfrm>
              <a:off x="1116000" y="6097680"/>
              <a:ext cx="5337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Line 6"/>
            <p:cNvSpPr/>
            <p:nvPr/>
          </p:nvSpPr>
          <p:spPr>
            <a:xfrm flipV="1">
              <a:off x="11714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Line 7"/>
            <p:cNvSpPr/>
            <p:nvPr/>
          </p:nvSpPr>
          <p:spPr>
            <a:xfrm flipV="1">
              <a:off x="12254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Line 8"/>
            <p:cNvSpPr/>
            <p:nvPr/>
          </p:nvSpPr>
          <p:spPr>
            <a:xfrm flipV="1">
              <a:off x="12812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Line 9"/>
            <p:cNvSpPr/>
            <p:nvPr/>
          </p:nvSpPr>
          <p:spPr>
            <a:xfrm flipV="1">
              <a:off x="13366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Line 10"/>
            <p:cNvSpPr/>
            <p:nvPr/>
          </p:nvSpPr>
          <p:spPr>
            <a:xfrm flipV="1">
              <a:off x="13921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Line 11"/>
            <p:cNvSpPr/>
            <p:nvPr/>
          </p:nvSpPr>
          <p:spPr>
            <a:xfrm flipV="1">
              <a:off x="14479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Line 12"/>
            <p:cNvSpPr/>
            <p:nvPr/>
          </p:nvSpPr>
          <p:spPr>
            <a:xfrm flipV="1">
              <a:off x="15033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Line 13"/>
            <p:cNvSpPr/>
            <p:nvPr/>
          </p:nvSpPr>
          <p:spPr>
            <a:xfrm flipV="1">
              <a:off x="15573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3" name="Line 14"/>
            <p:cNvSpPr/>
            <p:nvPr/>
          </p:nvSpPr>
          <p:spPr>
            <a:xfrm flipV="1">
              <a:off x="16128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Line 15"/>
            <p:cNvSpPr/>
            <p:nvPr/>
          </p:nvSpPr>
          <p:spPr>
            <a:xfrm flipV="1">
              <a:off x="16686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Line 16"/>
            <p:cNvSpPr/>
            <p:nvPr/>
          </p:nvSpPr>
          <p:spPr>
            <a:xfrm flipV="1">
              <a:off x="17240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Line 17"/>
            <p:cNvSpPr/>
            <p:nvPr/>
          </p:nvSpPr>
          <p:spPr>
            <a:xfrm flipV="1">
              <a:off x="17794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Line 18"/>
            <p:cNvSpPr/>
            <p:nvPr/>
          </p:nvSpPr>
          <p:spPr>
            <a:xfrm flipV="1">
              <a:off x="18334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Line 19"/>
            <p:cNvSpPr/>
            <p:nvPr/>
          </p:nvSpPr>
          <p:spPr>
            <a:xfrm flipV="1">
              <a:off x="18892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Line 20"/>
            <p:cNvSpPr/>
            <p:nvPr/>
          </p:nvSpPr>
          <p:spPr>
            <a:xfrm flipV="1">
              <a:off x="19447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Line 21"/>
            <p:cNvSpPr/>
            <p:nvPr/>
          </p:nvSpPr>
          <p:spPr>
            <a:xfrm flipV="1">
              <a:off x="20001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Line 22"/>
            <p:cNvSpPr/>
            <p:nvPr/>
          </p:nvSpPr>
          <p:spPr>
            <a:xfrm flipV="1">
              <a:off x="20559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Line 23"/>
            <p:cNvSpPr/>
            <p:nvPr/>
          </p:nvSpPr>
          <p:spPr>
            <a:xfrm flipV="1">
              <a:off x="21099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Line 24"/>
            <p:cNvSpPr/>
            <p:nvPr/>
          </p:nvSpPr>
          <p:spPr>
            <a:xfrm flipV="1">
              <a:off x="21654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Line 25"/>
            <p:cNvSpPr/>
            <p:nvPr/>
          </p:nvSpPr>
          <p:spPr>
            <a:xfrm flipV="1">
              <a:off x="22208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Line 26"/>
            <p:cNvSpPr/>
            <p:nvPr/>
          </p:nvSpPr>
          <p:spPr>
            <a:xfrm flipV="1">
              <a:off x="22766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Line 27"/>
            <p:cNvSpPr/>
            <p:nvPr/>
          </p:nvSpPr>
          <p:spPr>
            <a:xfrm flipV="1">
              <a:off x="23320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7" name="Line 28"/>
            <p:cNvSpPr/>
            <p:nvPr/>
          </p:nvSpPr>
          <p:spPr>
            <a:xfrm flipV="1">
              <a:off x="23860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8" name="Line 29"/>
            <p:cNvSpPr/>
            <p:nvPr/>
          </p:nvSpPr>
          <p:spPr>
            <a:xfrm flipV="1">
              <a:off x="24415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9" name="Line 30"/>
            <p:cNvSpPr/>
            <p:nvPr/>
          </p:nvSpPr>
          <p:spPr>
            <a:xfrm flipV="1">
              <a:off x="24973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Line 31"/>
            <p:cNvSpPr/>
            <p:nvPr/>
          </p:nvSpPr>
          <p:spPr>
            <a:xfrm flipV="1">
              <a:off x="25542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Line 32"/>
            <p:cNvSpPr/>
            <p:nvPr/>
          </p:nvSpPr>
          <p:spPr>
            <a:xfrm flipV="1">
              <a:off x="26100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Line 33"/>
            <p:cNvSpPr/>
            <p:nvPr/>
          </p:nvSpPr>
          <p:spPr>
            <a:xfrm flipV="1">
              <a:off x="26640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Line 34"/>
            <p:cNvSpPr/>
            <p:nvPr/>
          </p:nvSpPr>
          <p:spPr>
            <a:xfrm flipV="1">
              <a:off x="27194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Line 35"/>
            <p:cNvSpPr/>
            <p:nvPr/>
          </p:nvSpPr>
          <p:spPr>
            <a:xfrm flipV="1">
              <a:off x="27748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Line 36"/>
            <p:cNvSpPr/>
            <p:nvPr/>
          </p:nvSpPr>
          <p:spPr>
            <a:xfrm flipV="1">
              <a:off x="28306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Line 37"/>
            <p:cNvSpPr/>
            <p:nvPr/>
          </p:nvSpPr>
          <p:spPr>
            <a:xfrm flipV="1">
              <a:off x="28861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Line 38"/>
            <p:cNvSpPr/>
            <p:nvPr/>
          </p:nvSpPr>
          <p:spPr>
            <a:xfrm flipV="1">
              <a:off x="29401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Line 39"/>
            <p:cNvSpPr/>
            <p:nvPr/>
          </p:nvSpPr>
          <p:spPr>
            <a:xfrm flipV="1">
              <a:off x="29955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Line 40"/>
            <p:cNvSpPr/>
            <p:nvPr/>
          </p:nvSpPr>
          <p:spPr>
            <a:xfrm flipV="1">
              <a:off x="30513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0" name="Line 41"/>
            <p:cNvSpPr/>
            <p:nvPr/>
          </p:nvSpPr>
          <p:spPr>
            <a:xfrm flipV="1">
              <a:off x="31068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1" name="Line 42"/>
            <p:cNvSpPr/>
            <p:nvPr/>
          </p:nvSpPr>
          <p:spPr>
            <a:xfrm flipV="1">
              <a:off x="31622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2" name="Line 43"/>
            <p:cNvSpPr/>
            <p:nvPr/>
          </p:nvSpPr>
          <p:spPr>
            <a:xfrm flipV="1">
              <a:off x="32162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3" name="Line 44"/>
            <p:cNvSpPr/>
            <p:nvPr/>
          </p:nvSpPr>
          <p:spPr>
            <a:xfrm flipV="1">
              <a:off x="32720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4" name="Line 45"/>
            <p:cNvSpPr/>
            <p:nvPr/>
          </p:nvSpPr>
          <p:spPr>
            <a:xfrm flipV="1">
              <a:off x="33274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5" name="Line 46"/>
            <p:cNvSpPr/>
            <p:nvPr/>
          </p:nvSpPr>
          <p:spPr>
            <a:xfrm flipV="1">
              <a:off x="33829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6" name="Line 47"/>
            <p:cNvSpPr/>
            <p:nvPr/>
          </p:nvSpPr>
          <p:spPr>
            <a:xfrm flipV="1">
              <a:off x="34387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7" name="Line 48"/>
            <p:cNvSpPr/>
            <p:nvPr/>
          </p:nvSpPr>
          <p:spPr>
            <a:xfrm flipV="1">
              <a:off x="34927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8" name="Line 49"/>
            <p:cNvSpPr/>
            <p:nvPr/>
          </p:nvSpPr>
          <p:spPr>
            <a:xfrm flipV="1">
              <a:off x="35481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9" name="Line 50"/>
            <p:cNvSpPr/>
            <p:nvPr/>
          </p:nvSpPr>
          <p:spPr>
            <a:xfrm flipV="1">
              <a:off x="36036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0" name="Line 51"/>
            <p:cNvSpPr/>
            <p:nvPr/>
          </p:nvSpPr>
          <p:spPr>
            <a:xfrm flipV="1">
              <a:off x="36594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1" name="Line 52"/>
            <p:cNvSpPr/>
            <p:nvPr/>
          </p:nvSpPr>
          <p:spPr>
            <a:xfrm flipV="1">
              <a:off x="37148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2" name="Line 53"/>
            <p:cNvSpPr/>
            <p:nvPr/>
          </p:nvSpPr>
          <p:spPr>
            <a:xfrm flipV="1">
              <a:off x="37688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3" name="Line 54"/>
            <p:cNvSpPr/>
            <p:nvPr/>
          </p:nvSpPr>
          <p:spPr>
            <a:xfrm flipV="1">
              <a:off x="38242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4" name="Line 55"/>
            <p:cNvSpPr/>
            <p:nvPr/>
          </p:nvSpPr>
          <p:spPr>
            <a:xfrm flipV="1">
              <a:off x="38800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5" name="Line 56"/>
            <p:cNvSpPr/>
            <p:nvPr/>
          </p:nvSpPr>
          <p:spPr>
            <a:xfrm flipV="1">
              <a:off x="39355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6" name="Line 57"/>
            <p:cNvSpPr/>
            <p:nvPr/>
          </p:nvSpPr>
          <p:spPr>
            <a:xfrm flipV="1">
              <a:off x="39913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7" name="Line 58"/>
            <p:cNvSpPr/>
            <p:nvPr/>
          </p:nvSpPr>
          <p:spPr>
            <a:xfrm flipV="1">
              <a:off x="40467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8" name="Line 59"/>
            <p:cNvSpPr/>
            <p:nvPr/>
          </p:nvSpPr>
          <p:spPr>
            <a:xfrm flipV="1">
              <a:off x="41007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9" name="Line 60"/>
            <p:cNvSpPr/>
            <p:nvPr/>
          </p:nvSpPr>
          <p:spPr>
            <a:xfrm flipV="1">
              <a:off x="41562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0" name="Line 61"/>
            <p:cNvSpPr/>
            <p:nvPr/>
          </p:nvSpPr>
          <p:spPr>
            <a:xfrm flipV="1">
              <a:off x="42120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1" name="Line 62"/>
            <p:cNvSpPr/>
            <p:nvPr/>
          </p:nvSpPr>
          <p:spPr>
            <a:xfrm flipV="1">
              <a:off x="42674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2" name="Line 63"/>
            <p:cNvSpPr/>
            <p:nvPr/>
          </p:nvSpPr>
          <p:spPr>
            <a:xfrm flipV="1">
              <a:off x="43228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3" name="Line 64"/>
            <p:cNvSpPr/>
            <p:nvPr/>
          </p:nvSpPr>
          <p:spPr>
            <a:xfrm flipV="1">
              <a:off x="43768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4" name="Line 65"/>
            <p:cNvSpPr/>
            <p:nvPr/>
          </p:nvSpPr>
          <p:spPr>
            <a:xfrm flipV="1">
              <a:off x="44326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5" name="Line 66"/>
            <p:cNvSpPr/>
            <p:nvPr/>
          </p:nvSpPr>
          <p:spPr>
            <a:xfrm flipV="1">
              <a:off x="44881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6" name="Line 67"/>
            <p:cNvSpPr/>
            <p:nvPr/>
          </p:nvSpPr>
          <p:spPr>
            <a:xfrm flipV="1">
              <a:off x="45435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7" name="Line 68"/>
            <p:cNvSpPr/>
            <p:nvPr/>
          </p:nvSpPr>
          <p:spPr>
            <a:xfrm flipV="1">
              <a:off x="45993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8" name="Line 69"/>
            <p:cNvSpPr/>
            <p:nvPr/>
          </p:nvSpPr>
          <p:spPr>
            <a:xfrm flipV="1">
              <a:off x="46533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9" name="Line 70"/>
            <p:cNvSpPr/>
            <p:nvPr/>
          </p:nvSpPr>
          <p:spPr>
            <a:xfrm flipV="1">
              <a:off x="47088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0" name="Line 71"/>
            <p:cNvSpPr/>
            <p:nvPr/>
          </p:nvSpPr>
          <p:spPr>
            <a:xfrm flipV="1">
              <a:off x="47642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1" name="Line 72"/>
            <p:cNvSpPr/>
            <p:nvPr/>
          </p:nvSpPr>
          <p:spPr>
            <a:xfrm flipV="1">
              <a:off x="48200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2" name="Line 73"/>
            <p:cNvSpPr/>
            <p:nvPr/>
          </p:nvSpPr>
          <p:spPr>
            <a:xfrm flipV="1">
              <a:off x="48754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3" name="Line 74"/>
            <p:cNvSpPr/>
            <p:nvPr/>
          </p:nvSpPr>
          <p:spPr>
            <a:xfrm flipV="1">
              <a:off x="49294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4" name="Line 75"/>
            <p:cNvSpPr/>
            <p:nvPr/>
          </p:nvSpPr>
          <p:spPr>
            <a:xfrm flipV="1">
              <a:off x="49849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5" name="Line 76"/>
            <p:cNvSpPr/>
            <p:nvPr/>
          </p:nvSpPr>
          <p:spPr>
            <a:xfrm flipV="1">
              <a:off x="50407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6" name="Line 77"/>
            <p:cNvSpPr/>
            <p:nvPr/>
          </p:nvSpPr>
          <p:spPr>
            <a:xfrm flipV="1">
              <a:off x="50961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7" name="Line 78"/>
            <p:cNvSpPr/>
            <p:nvPr/>
          </p:nvSpPr>
          <p:spPr>
            <a:xfrm flipV="1">
              <a:off x="51516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8" name="Line 79"/>
            <p:cNvSpPr/>
            <p:nvPr/>
          </p:nvSpPr>
          <p:spPr>
            <a:xfrm flipV="1">
              <a:off x="52056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9" name="Line 80"/>
            <p:cNvSpPr/>
            <p:nvPr/>
          </p:nvSpPr>
          <p:spPr>
            <a:xfrm flipV="1">
              <a:off x="52614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0" name="Line 81"/>
            <p:cNvSpPr/>
            <p:nvPr/>
          </p:nvSpPr>
          <p:spPr>
            <a:xfrm flipV="1">
              <a:off x="53168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1" name="Line 82"/>
            <p:cNvSpPr/>
            <p:nvPr/>
          </p:nvSpPr>
          <p:spPr>
            <a:xfrm flipV="1">
              <a:off x="53740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2" name="Line 83"/>
            <p:cNvSpPr/>
            <p:nvPr/>
          </p:nvSpPr>
          <p:spPr>
            <a:xfrm flipV="1">
              <a:off x="54295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3" name="Line 84"/>
            <p:cNvSpPr/>
            <p:nvPr/>
          </p:nvSpPr>
          <p:spPr>
            <a:xfrm flipV="1">
              <a:off x="54835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4" name="Line 85"/>
            <p:cNvSpPr/>
            <p:nvPr/>
          </p:nvSpPr>
          <p:spPr>
            <a:xfrm flipV="1">
              <a:off x="55389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5" name="Line 86"/>
            <p:cNvSpPr/>
            <p:nvPr/>
          </p:nvSpPr>
          <p:spPr>
            <a:xfrm flipV="1">
              <a:off x="55947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6" name="Line 87"/>
            <p:cNvSpPr/>
            <p:nvPr/>
          </p:nvSpPr>
          <p:spPr>
            <a:xfrm flipV="1">
              <a:off x="56502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7" name="Line 88"/>
            <p:cNvSpPr/>
            <p:nvPr/>
          </p:nvSpPr>
          <p:spPr>
            <a:xfrm flipV="1">
              <a:off x="57056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8" name="Line 89"/>
            <p:cNvSpPr/>
            <p:nvPr/>
          </p:nvSpPr>
          <p:spPr>
            <a:xfrm flipV="1">
              <a:off x="57596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9" name="Line 90"/>
            <p:cNvSpPr/>
            <p:nvPr/>
          </p:nvSpPr>
          <p:spPr>
            <a:xfrm flipV="1">
              <a:off x="58154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Line 91"/>
            <p:cNvSpPr/>
            <p:nvPr/>
          </p:nvSpPr>
          <p:spPr>
            <a:xfrm flipV="1">
              <a:off x="58708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1" name="Line 92"/>
            <p:cNvSpPr/>
            <p:nvPr/>
          </p:nvSpPr>
          <p:spPr>
            <a:xfrm flipV="1">
              <a:off x="59263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2" name="Line 93"/>
            <p:cNvSpPr/>
            <p:nvPr/>
          </p:nvSpPr>
          <p:spPr>
            <a:xfrm flipV="1">
              <a:off x="59821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3" name="Line 94"/>
            <p:cNvSpPr/>
            <p:nvPr/>
          </p:nvSpPr>
          <p:spPr>
            <a:xfrm flipV="1">
              <a:off x="603612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4" name="Line 95"/>
            <p:cNvSpPr/>
            <p:nvPr/>
          </p:nvSpPr>
          <p:spPr>
            <a:xfrm flipV="1">
              <a:off x="609156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5" name="Line 96"/>
            <p:cNvSpPr/>
            <p:nvPr/>
          </p:nvSpPr>
          <p:spPr>
            <a:xfrm flipV="1">
              <a:off x="61470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6" name="Line 97"/>
            <p:cNvSpPr/>
            <p:nvPr/>
          </p:nvSpPr>
          <p:spPr>
            <a:xfrm flipV="1">
              <a:off x="620280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7" name="Line 98"/>
            <p:cNvSpPr/>
            <p:nvPr/>
          </p:nvSpPr>
          <p:spPr>
            <a:xfrm flipV="1">
              <a:off x="62582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8" name="Line 99"/>
            <p:cNvSpPr/>
            <p:nvPr/>
          </p:nvSpPr>
          <p:spPr>
            <a:xfrm flipV="1">
              <a:off x="631224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9" name="Line 100"/>
            <p:cNvSpPr/>
            <p:nvPr/>
          </p:nvSpPr>
          <p:spPr>
            <a:xfrm flipV="1">
              <a:off x="63676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0" name="Line 101"/>
            <p:cNvSpPr/>
            <p:nvPr/>
          </p:nvSpPr>
          <p:spPr>
            <a:xfrm flipV="1">
              <a:off x="6423480" y="609768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1" name="Rectangle 102"/>
            <p:cNvSpPr/>
            <p:nvPr/>
          </p:nvSpPr>
          <p:spPr>
            <a:xfrm>
              <a:off x="117180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2" name="Rectangle 103"/>
            <p:cNvSpPr/>
            <p:nvPr/>
          </p:nvSpPr>
          <p:spPr>
            <a:xfrm>
              <a:off x="144792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3" name="Rectangle 104"/>
            <p:cNvSpPr/>
            <p:nvPr/>
          </p:nvSpPr>
          <p:spPr>
            <a:xfrm>
              <a:off x="172440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4" name="Rectangle 105"/>
            <p:cNvSpPr/>
            <p:nvPr/>
          </p:nvSpPr>
          <p:spPr>
            <a:xfrm>
              <a:off x="200052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5" name="Rectangle 106"/>
            <p:cNvSpPr/>
            <p:nvPr/>
          </p:nvSpPr>
          <p:spPr>
            <a:xfrm>
              <a:off x="227700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6" name="Rectangle 107"/>
            <p:cNvSpPr/>
            <p:nvPr/>
          </p:nvSpPr>
          <p:spPr>
            <a:xfrm>
              <a:off x="255456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7" name="Rectangle 108"/>
            <p:cNvSpPr/>
            <p:nvPr/>
          </p:nvSpPr>
          <p:spPr>
            <a:xfrm>
              <a:off x="283104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8" name="Rectangle 109"/>
            <p:cNvSpPr/>
            <p:nvPr/>
          </p:nvSpPr>
          <p:spPr>
            <a:xfrm>
              <a:off x="310716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9" name="Rectangle 110"/>
            <p:cNvSpPr/>
            <p:nvPr/>
          </p:nvSpPr>
          <p:spPr>
            <a:xfrm>
              <a:off x="338328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0" name="Rectangle 111"/>
            <p:cNvSpPr/>
            <p:nvPr/>
          </p:nvSpPr>
          <p:spPr>
            <a:xfrm>
              <a:off x="365976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1" name="Rectangle 112"/>
            <p:cNvSpPr/>
            <p:nvPr/>
          </p:nvSpPr>
          <p:spPr>
            <a:xfrm>
              <a:off x="393588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2" name="Rectangle 113"/>
            <p:cNvSpPr/>
            <p:nvPr/>
          </p:nvSpPr>
          <p:spPr>
            <a:xfrm>
              <a:off x="421380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3" name="Rectangle 114"/>
            <p:cNvSpPr/>
            <p:nvPr/>
          </p:nvSpPr>
          <p:spPr>
            <a:xfrm>
              <a:off x="448848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4" name="Rectangle 115"/>
            <p:cNvSpPr/>
            <p:nvPr/>
          </p:nvSpPr>
          <p:spPr>
            <a:xfrm>
              <a:off x="476460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5" name="Rectangle 116"/>
            <p:cNvSpPr/>
            <p:nvPr/>
          </p:nvSpPr>
          <p:spPr>
            <a:xfrm>
              <a:off x="504072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6" name="Rectangle 117"/>
            <p:cNvSpPr/>
            <p:nvPr/>
          </p:nvSpPr>
          <p:spPr>
            <a:xfrm>
              <a:off x="531864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7" name="Rectangle 118"/>
            <p:cNvSpPr/>
            <p:nvPr/>
          </p:nvSpPr>
          <p:spPr>
            <a:xfrm>
              <a:off x="559476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8" name="Rectangle 119"/>
            <p:cNvSpPr/>
            <p:nvPr/>
          </p:nvSpPr>
          <p:spPr>
            <a:xfrm>
              <a:off x="5872680" y="615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9" name="Rectangle 120"/>
            <p:cNvSpPr/>
            <p:nvPr/>
          </p:nvSpPr>
          <p:spPr>
            <a:xfrm>
              <a:off x="6147360" y="61534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0" name="Line 121"/>
            <p:cNvSpPr/>
            <p:nvPr/>
          </p:nvSpPr>
          <p:spPr>
            <a:xfrm flipV="1">
              <a:off x="128124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1" name="Line 122"/>
            <p:cNvSpPr/>
            <p:nvPr/>
          </p:nvSpPr>
          <p:spPr>
            <a:xfrm flipV="1">
              <a:off x="155736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2" name="Line 123"/>
            <p:cNvSpPr/>
            <p:nvPr/>
          </p:nvSpPr>
          <p:spPr>
            <a:xfrm flipV="1">
              <a:off x="183348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3" name="Line 124"/>
            <p:cNvSpPr/>
            <p:nvPr/>
          </p:nvSpPr>
          <p:spPr>
            <a:xfrm flipV="1">
              <a:off x="210996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4" name="Line 125"/>
            <p:cNvSpPr/>
            <p:nvPr/>
          </p:nvSpPr>
          <p:spPr>
            <a:xfrm flipV="1">
              <a:off x="238608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5" name="Line 126"/>
            <p:cNvSpPr/>
            <p:nvPr/>
          </p:nvSpPr>
          <p:spPr>
            <a:xfrm flipV="1">
              <a:off x="266400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6" name="Line 127"/>
            <p:cNvSpPr/>
            <p:nvPr/>
          </p:nvSpPr>
          <p:spPr>
            <a:xfrm flipV="1">
              <a:off x="294012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7" name="Line 128"/>
            <p:cNvSpPr/>
            <p:nvPr/>
          </p:nvSpPr>
          <p:spPr>
            <a:xfrm flipV="1">
              <a:off x="321624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8" name="Line 129"/>
            <p:cNvSpPr/>
            <p:nvPr/>
          </p:nvSpPr>
          <p:spPr>
            <a:xfrm flipV="1">
              <a:off x="349272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9" name="Line 130"/>
            <p:cNvSpPr/>
            <p:nvPr/>
          </p:nvSpPr>
          <p:spPr>
            <a:xfrm flipV="1">
              <a:off x="376884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0" name="Line 131"/>
            <p:cNvSpPr/>
            <p:nvPr/>
          </p:nvSpPr>
          <p:spPr>
            <a:xfrm flipV="1">
              <a:off x="404676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1" name="Line 132"/>
            <p:cNvSpPr/>
            <p:nvPr/>
          </p:nvSpPr>
          <p:spPr>
            <a:xfrm flipV="1">
              <a:off x="432288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2" name="Line 133"/>
            <p:cNvSpPr/>
            <p:nvPr/>
          </p:nvSpPr>
          <p:spPr>
            <a:xfrm flipV="1">
              <a:off x="459936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3" name="Line 134"/>
            <p:cNvSpPr/>
            <p:nvPr/>
          </p:nvSpPr>
          <p:spPr>
            <a:xfrm flipV="1">
              <a:off x="487548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4" name="Line 135"/>
            <p:cNvSpPr/>
            <p:nvPr/>
          </p:nvSpPr>
          <p:spPr>
            <a:xfrm flipV="1">
              <a:off x="515160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5" name="Line 136"/>
            <p:cNvSpPr/>
            <p:nvPr/>
          </p:nvSpPr>
          <p:spPr>
            <a:xfrm flipV="1">
              <a:off x="542952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6" name="Line 137"/>
            <p:cNvSpPr/>
            <p:nvPr/>
          </p:nvSpPr>
          <p:spPr>
            <a:xfrm flipV="1">
              <a:off x="570564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7" name="Line 138"/>
            <p:cNvSpPr/>
            <p:nvPr/>
          </p:nvSpPr>
          <p:spPr>
            <a:xfrm flipV="1">
              <a:off x="598212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8" name="Line 139"/>
            <p:cNvSpPr/>
            <p:nvPr/>
          </p:nvSpPr>
          <p:spPr>
            <a:xfrm flipV="1">
              <a:off x="6258240" y="609768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9" name="Line 140"/>
            <p:cNvSpPr/>
            <p:nvPr/>
          </p:nvSpPr>
          <p:spPr>
            <a:xfrm flipV="1">
              <a:off x="1116000" y="3841200"/>
              <a:ext cx="0" cy="225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0" name="Line 141"/>
            <p:cNvSpPr/>
            <p:nvPr/>
          </p:nvSpPr>
          <p:spPr>
            <a:xfrm>
              <a:off x="1108080" y="6097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1" name="Line 142"/>
            <p:cNvSpPr/>
            <p:nvPr/>
          </p:nvSpPr>
          <p:spPr>
            <a:xfrm>
              <a:off x="1108080" y="6070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2" name="Line 143"/>
            <p:cNvSpPr/>
            <p:nvPr/>
          </p:nvSpPr>
          <p:spPr>
            <a:xfrm>
              <a:off x="1108080" y="6045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3" name="Line 144"/>
            <p:cNvSpPr/>
            <p:nvPr/>
          </p:nvSpPr>
          <p:spPr>
            <a:xfrm>
              <a:off x="1108080" y="6018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4" name="Line 145"/>
            <p:cNvSpPr/>
            <p:nvPr/>
          </p:nvSpPr>
          <p:spPr>
            <a:xfrm>
              <a:off x="1108080" y="5992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5" name="Line 146"/>
            <p:cNvSpPr/>
            <p:nvPr/>
          </p:nvSpPr>
          <p:spPr>
            <a:xfrm>
              <a:off x="1108080" y="5965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6" name="Line 147"/>
            <p:cNvSpPr/>
            <p:nvPr/>
          </p:nvSpPr>
          <p:spPr>
            <a:xfrm>
              <a:off x="1108080" y="5940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7" name="Line 148"/>
            <p:cNvSpPr/>
            <p:nvPr/>
          </p:nvSpPr>
          <p:spPr>
            <a:xfrm>
              <a:off x="1108080" y="59151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8" name="Line 149"/>
            <p:cNvSpPr/>
            <p:nvPr/>
          </p:nvSpPr>
          <p:spPr>
            <a:xfrm>
              <a:off x="1108080" y="58881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9" name="Line 150"/>
            <p:cNvSpPr/>
            <p:nvPr/>
          </p:nvSpPr>
          <p:spPr>
            <a:xfrm>
              <a:off x="1108080" y="58629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0" name="Line 151"/>
            <p:cNvSpPr/>
            <p:nvPr/>
          </p:nvSpPr>
          <p:spPr>
            <a:xfrm>
              <a:off x="1108080" y="58374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1" name="Line 152"/>
            <p:cNvSpPr/>
            <p:nvPr/>
          </p:nvSpPr>
          <p:spPr>
            <a:xfrm>
              <a:off x="1108080" y="58104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2" name="Line 153"/>
            <p:cNvSpPr/>
            <p:nvPr/>
          </p:nvSpPr>
          <p:spPr>
            <a:xfrm>
              <a:off x="1108080" y="5784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3" name="Line 154"/>
            <p:cNvSpPr/>
            <p:nvPr/>
          </p:nvSpPr>
          <p:spPr>
            <a:xfrm>
              <a:off x="1108080" y="5757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4" name="Line 155"/>
            <p:cNvSpPr/>
            <p:nvPr/>
          </p:nvSpPr>
          <p:spPr>
            <a:xfrm>
              <a:off x="1108080" y="57326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5" name="Line 156"/>
            <p:cNvSpPr/>
            <p:nvPr/>
          </p:nvSpPr>
          <p:spPr>
            <a:xfrm>
              <a:off x="1108080" y="57056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6" name="Line 157"/>
            <p:cNvSpPr/>
            <p:nvPr/>
          </p:nvSpPr>
          <p:spPr>
            <a:xfrm>
              <a:off x="1108080" y="56786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7" name="Line 158"/>
            <p:cNvSpPr/>
            <p:nvPr/>
          </p:nvSpPr>
          <p:spPr>
            <a:xfrm>
              <a:off x="1108080" y="56530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8" name="Line 159"/>
            <p:cNvSpPr/>
            <p:nvPr/>
          </p:nvSpPr>
          <p:spPr>
            <a:xfrm>
              <a:off x="1108080" y="56278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9" name="Line 160"/>
            <p:cNvSpPr/>
            <p:nvPr/>
          </p:nvSpPr>
          <p:spPr>
            <a:xfrm>
              <a:off x="1108080" y="56008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0" name="Line 161"/>
            <p:cNvSpPr/>
            <p:nvPr/>
          </p:nvSpPr>
          <p:spPr>
            <a:xfrm>
              <a:off x="1108080" y="55753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1" name="Line 162"/>
            <p:cNvSpPr/>
            <p:nvPr/>
          </p:nvSpPr>
          <p:spPr>
            <a:xfrm>
              <a:off x="1108080" y="55501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2" name="Line 163"/>
            <p:cNvSpPr/>
            <p:nvPr/>
          </p:nvSpPr>
          <p:spPr>
            <a:xfrm>
              <a:off x="1108080" y="55231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3" name="Line 164"/>
            <p:cNvSpPr/>
            <p:nvPr/>
          </p:nvSpPr>
          <p:spPr>
            <a:xfrm>
              <a:off x="1108080" y="54975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4" name="Line 165"/>
            <p:cNvSpPr/>
            <p:nvPr/>
          </p:nvSpPr>
          <p:spPr>
            <a:xfrm>
              <a:off x="1108080" y="54705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5" name="Line 166"/>
            <p:cNvSpPr/>
            <p:nvPr/>
          </p:nvSpPr>
          <p:spPr>
            <a:xfrm>
              <a:off x="1108080" y="54453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6" name="Line 167"/>
            <p:cNvSpPr/>
            <p:nvPr/>
          </p:nvSpPr>
          <p:spPr>
            <a:xfrm>
              <a:off x="1108080" y="54198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7" name="Line 168"/>
            <p:cNvSpPr/>
            <p:nvPr/>
          </p:nvSpPr>
          <p:spPr>
            <a:xfrm>
              <a:off x="1108080" y="53928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8" name="Line 169"/>
            <p:cNvSpPr/>
            <p:nvPr/>
          </p:nvSpPr>
          <p:spPr>
            <a:xfrm>
              <a:off x="1108080" y="53672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9" name="Line 170"/>
            <p:cNvSpPr/>
            <p:nvPr/>
          </p:nvSpPr>
          <p:spPr>
            <a:xfrm>
              <a:off x="1108080" y="53420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0" name="Line 171"/>
            <p:cNvSpPr/>
            <p:nvPr/>
          </p:nvSpPr>
          <p:spPr>
            <a:xfrm>
              <a:off x="1108080" y="53132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1" name="Line 172"/>
            <p:cNvSpPr/>
            <p:nvPr/>
          </p:nvSpPr>
          <p:spPr>
            <a:xfrm>
              <a:off x="1108080" y="52880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2" name="Line 173"/>
            <p:cNvSpPr/>
            <p:nvPr/>
          </p:nvSpPr>
          <p:spPr>
            <a:xfrm>
              <a:off x="1108080" y="5262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3" name="Line 174"/>
            <p:cNvSpPr/>
            <p:nvPr/>
          </p:nvSpPr>
          <p:spPr>
            <a:xfrm>
              <a:off x="1108080" y="5235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4" name="Line 175"/>
            <p:cNvSpPr/>
            <p:nvPr/>
          </p:nvSpPr>
          <p:spPr>
            <a:xfrm>
              <a:off x="1108080" y="52102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5" name="Line 176"/>
            <p:cNvSpPr/>
            <p:nvPr/>
          </p:nvSpPr>
          <p:spPr>
            <a:xfrm>
              <a:off x="1108080" y="5184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6" name="Line 177"/>
            <p:cNvSpPr/>
            <p:nvPr/>
          </p:nvSpPr>
          <p:spPr>
            <a:xfrm>
              <a:off x="1108080" y="5157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7" name="Line 178"/>
            <p:cNvSpPr/>
            <p:nvPr/>
          </p:nvSpPr>
          <p:spPr>
            <a:xfrm>
              <a:off x="1108080" y="51325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8" name="Line 179"/>
            <p:cNvSpPr/>
            <p:nvPr/>
          </p:nvSpPr>
          <p:spPr>
            <a:xfrm>
              <a:off x="1108080" y="51055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9" name="Line 180"/>
            <p:cNvSpPr/>
            <p:nvPr/>
          </p:nvSpPr>
          <p:spPr>
            <a:xfrm>
              <a:off x="1108080" y="50799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0" name="Line 181"/>
            <p:cNvSpPr/>
            <p:nvPr/>
          </p:nvSpPr>
          <p:spPr>
            <a:xfrm>
              <a:off x="1108080" y="50547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1" name="Line 182"/>
            <p:cNvSpPr/>
            <p:nvPr/>
          </p:nvSpPr>
          <p:spPr>
            <a:xfrm>
              <a:off x="1108080" y="50277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2" name="Line 183"/>
            <p:cNvSpPr/>
            <p:nvPr/>
          </p:nvSpPr>
          <p:spPr>
            <a:xfrm>
              <a:off x="1108080" y="50022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3" name="Line 184"/>
            <p:cNvSpPr/>
            <p:nvPr/>
          </p:nvSpPr>
          <p:spPr>
            <a:xfrm>
              <a:off x="1108080" y="49766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4" name="Line 185"/>
            <p:cNvSpPr/>
            <p:nvPr/>
          </p:nvSpPr>
          <p:spPr>
            <a:xfrm>
              <a:off x="1108080" y="49482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5" name="Line 186"/>
            <p:cNvSpPr/>
            <p:nvPr/>
          </p:nvSpPr>
          <p:spPr>
            <a:xfrm>
              <a:off x="1108080" y="49226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6" name="Line 187"/>
            <p:cNvSpPr/>
            <p:nvPr/>
          </p:nvSpPr>
          <p:spPr>
            <a:xfrm>
              <a:off x="1108080" y="48974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7" name="Line 188"/>
            <p:cNvSpPr/>
            <p:nvPr/>
          </p:nvSpPr>
          <p:spPr>
            <a:xfrm>
              <a:off x="1108080" y="48704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8" name="Line 189"/>
            <p:cNvSpPr/>
            <p:nvPr/>
          </p:nvSpPr>
          <p:spPr>
            <a:xfrm>
              <a:off x="1108080" y="48448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9" name="Line 190"/>
            <p:cNvSpPr/>
            <p:nvPr/>
          </p:nvSpPr>
          <p:spPr>
            <a:xfrm>
              <a:off x="1108080" y="48178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0" name="Line 191"/>
            <p:cNvSpPr/>
            <p:nvPr/>
          </p:nvSpPr>
          <p:spPr>
            <a:xfrm>
              <a:off x="1108080" y="4792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1" name="Line 192"/>
            <p:cNvSpPr/>
            <p:nvPr/>
          </p:nvSpPr>
          <p:spPr>
            <a:xfrm>
              <a:off x="1108080" y="47671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2" name="Line 193"/>
            <p:cNvSpPr/>
            <p:nvPr/>
          </p:nvSpPr>
          <p:spPr>
            <a:xfrm>
              <a:off x="1108080" y="47401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3" name="Line 194"/>
            <p:cNvSpPr/>
            <p:nvPr/>
          </p:nvSpPr>
          <p:spPr>
            <a:xfrm>
              <a:off x="1108080" y="4714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4" name="Line 195"/>
            <p:cNvSpPr/>
            <p:nvPr/>
          </p:nvSpPr>
          <p:spPr>
            <a:xfrm>
              <a:off x="1108080" y="46893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5" name="Line 196"/>
            <p:cNvSpPr/>
            <p:nvPr/>
          </p:nvSpPr>
          <p:spPr>
            <a:xfrm>
              <a:off x="1108080" y="46623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6" name="Line 197"/>
            <p:cNvSpPr/>
            <p:nvPr/>
          </p:nvSpPr>
          <p:spPr>
            <a:xfrm>
              <a:off x="1108080" y="46371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7" name="Line 198"/>
            <p:cNvSpPr/>
            <p:nvPr/>
          </p:nvSpPr>
          <p:spPr>
            <a:xfrm>
              <a:off x="1108080" y="46101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8" name="Line 199"/>
            <p:cNvSpPr/>
            <p:nvPr/>
          </p:nvSpPr>
          <p:spPr>
            <a:xfrm>
              <a:off x="1108080" y="45831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9" name="Line 200"/>
            <p:cNvSpPr/>
            <p:nvPr/>
          </p:nvSpPr>
          <p:spPr>
            <a:xfrm>
              <a:off x="1108080" y="45576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0" name="Line 201"/>
            <p:cNvSpPr/>
            <p:nvPr/>
          </p:nvSpPr>
          <p:spPr>
            <a:xfrm>
              <a:off x="1108080" y="45306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1" name="Line 202"/>
            <p:cNvSpPr/>
            <p:nvPr/>
          </p:nvSpPr>
          <p:spPr>
            <a:xfrm>
              <a:off x="1108080" y="45050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2" name="Line 203"/>
            <p:cNvSpPr/>
            <p:nvPr/>
          </p:nvSpPr>
          <p:spPr>
            <a:xfrm>
              <a:off x="1108080" y="4479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3" name="Line 204"/>
            <p:cNvSpPr/>
            <p:nvPr/>
          </p:nvSpPr>
          <p:spPr>
            <a:xfrm>
              <a:off x="1108080" y="4452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4" name="Line 205"/>
            <p:cNvSpPr/>
            <p:nvPr/>
          </p:nvSpPr>
          <p:spPr>
            <a:xfrm>
              <a:off x="1108080" y="44272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5" name="Line 206"/>
            <p:cNvSpPr/>
            <p:nvPr/>
          </p:nvSpPr>
          <p:spPr>
            <a:xfrm>
              <a:off x="1108080" y="44020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6" name="Line 207"/>
            <p:cNvSpPr/>
            <p:nvPr/>
          </p:nvSpPr>
          <p:spPr>
            <a:xfrm>
              <a:off x="1108080" y="43750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7" name="Line 208"/>
            <p:cNvSpPr/>
            <p:nvPr/>
          </p:nvSpPr>
          <p:spPr>
            <a:xfrm>
              <a:off x="1108080" y="43495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8" name="Line 209"/>
            <p:cNvSpPr/>
            <p:nvPr/>
          </p:nvSpPr>
          <p:spPr>
            <a:xfrm>
              <a:off x="1108080" y="43225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9" name="Line 210"/>
            <p:cNvSpPr/>
            <p:nvPr/>
          </p:nvSpPr>
          <p:spPr>
            <a:xfrm>
              <a:off x="1108080" y="42973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0" name="Line 211"/>
            <p:cNvSpPr/>
            <p:nvPr/>
          </p:nvSpPr>
          <p:spPr>
            <a:xfrm>
              <a:off x="1108080" y="42717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1" name="Line 212"/>
            <p:cNvSpPr/>
            <p:nvPr/>
          </p:nvSpPr>
          <p:spPr>
            <a:xfrm>
              <a:off x="1108080" y="42447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2" name="Line 213"/>
            <p:cNvSpPr/>
            <p:nvPr/>
          </p:nvSpPr>
          <p:spPr>
            <a:xfrm>
              <a:off x="1108080" y="42177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3" name="Line 214"/>
            <p:cNvSpPr/>
            <p:nvPr/>
          </p:nvSpPr>
          <p:spPr>
            <a:xfrm>
              <a:off x="1108080" y="41925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4" name="Line 215"/>
            <p:cNvSpPr/>
            <p:nvPr/>
          </p:nvSpPr>
          <p:spPr>
            <a:xfrm>
              <a:off x="1108080" y="41655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5" name="Line 216"/>
            <p:cNvSpPr/>
            <p:nvPr/>
          </p:nvSpPr>
          <p:spPr>
            <a:xfrm>
              <a:off x="1108080" y="41400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6" name="Line 217"/>
            <p:cNvSpPr/>
            <p:nvPr/>
          </p:nvSpPr>
          <p:spPr>
            <a:xfrm>
              <a:off x="1108080" y="41144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7" name="Line 218"/>
            <p:cNvSpPr/>
            <p:nvPr/>
          </p:nvSpPr>
          <p:spPr>
            <a:xfrm>
              <a:off x="1108080" y="40874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8" name="Line 219"/>
            <p:cNvSpPr/>
            <p:nvPr/>
          </p:nvSpPr>
          <p:spPr>
            <a:xfrm>
              <a:off x="1108080" y="40622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9" name="Line 220"/>
            <p:cNvSpPr/>
            <p:nvPr/>
          </p:nvSpPr>
          <p:spPr>
            <a:xfrm>
              <a:off x="1108080" y="4036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0" name="Line 221"/>
            <p:cNvSpPr/>
            <p:nvPr/>
          </p:nvSpPr>
          <p:spPr>
            <a:xfrm>
              <a:off x="1108080" y="4009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1" name="Line 222"/>
            <p:cNvSpPr/>
            <p:nvPr/>
          </p:nvSpPr>
          <p:spPr>
            <a:xfrm>
              <a:off x="1108080" y="3984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2" name="Line 223"/>
            <p:cNvSpPr/>
            <p:nvPr/>
          </p:nvSpPr>
          <p:spPr>
            <a:xfrm>
              <a:off x="1108080" y="3957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3" name="Line 224"/>
            <p:cNvSpPr/>
            <p:nvPr/>
          </p:nvSpPr>
          <p:spPr>
            <a:xfrm>
              <a:off x="1108080" y="3931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4" name="Line 225"/>
            <p:cNvSpPr/>
            <p:nvPr/>
          </p:nvSpPr>
          <p:spPr>
            <a:xfrm>
              <a:off x="1108080" y="3906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5" name="Line 226"/>
            <p:cNvSpPr/>
            <p:nvPr/>
          </p:nvSpPr>
          <p:spPr>
            <a:xfrm>
              <a:off x="1108080" y="3879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6" name="Line 227"/>
            <p:cNvSpPr/>
            <p:nvPr/>
          </p:nvSpPr>
          <p:spPr>
            <a:xfrm>
              <a:off x="1108080" y="3852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7" name="Line 228"/>
            <p:cNvSpPr/>
            <p:nvPr/>
          </p:nvSpPr>
          <p:spPr>
            <a:xfrm>
              <a:off x="1100160" y="609768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8" name="Line 229"/>
            <p:cNvSpPr/>
            <p:nvPr/>
          </p:nvSpPr>
          <p:spPr>
            <a:xfrm>
              <a:off x="1100160" y="596592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9" name="Line 230"/>
            <p:cNvSpPr/>
            <p:nvPr/>
          </p:nvSpPr>
          <p:spPr>
            <a:xfrm>
              <a:off x="1100160" y="583740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0" name="Line 231"/>
            <p:cNvSpPr/>
            <p:nvPr/>
          </p:nvSpPr>
          <p:spPr>
            <a:xfrm>
              <a:off x="1100160" y="570564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1" name="Line 232"/>
            <p:cNvSpPr/>
            <p:nvPr/>
          </p:nvSpPr>
          <p:spPr>
            <a:xfrm>
              <a:off x="1100160" y="557532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2" name="Line 233"/>
            <p:cNvSpPr/>
            <p:nvPr/>
          </p:nvSpPr>
          <p:spPr>
            <a:xfrm>
              <a:off x="1100160" y="544536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3" name="Line 234"/>
            <p:cNvSpPr/>
            <p:nvPr/>
          </p:nvSpPr>
          <p:spPr>
            <a:xfrm>
              <a:off x="1100160" y="531324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4" name="Line 235"/>
            <p:cNvSpPr/>
            <p:nvPr/>
          </p:nvSpPr>
          <p:spPr>
            <a:xfrm>
              <a:off x="1100160" y="518472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5" name="Line 236"/>
            <p:cNvSpPr/>
            <p:nvPr/>
          </p:nvSpPr>
          <p:spPr>
            <a:xfrm>
              <a:off x="1100160" y="505476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6" name="Line 237"/>
            <p:cNvSpPr/>
            <p:nvPr/>
          </p:nvSpPr>
          <p:spPr>
            <a:xfrm>
              <a:off x="1100160" y="492264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7" name="Line 238"/>
            <p:cNvSpPr/>
            <p:nvPr/>
          </p:nvSpPr>
          <p:spPr>
            <a:xfrm>
              <a:off x="1100160" y="479268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8" name="Line 239"/>
            <p:cNvSpPr/>
            <p:nvPr/>
          </p:nvSpPr>
          <p:spPr>
            <a:xfrm>
              <a:off x="1100160" y="466236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9" name="Line 240"/>
            <p:cNvSpPr/>
            <p:nvPr/>
          </p:nvSpPr>
          <p:spPr>
            <a:xfrm>
              <a:off x="1100160" y="453060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0" name="Line 241"/>
            <p:cNvSpPr/>
            <p:nvPr/>
          </p:nvSpPr>
          <p:spPr>
            <a:xfrm>
              <a:off x="1100160" y="440208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1" name="Line 242"/>
            <p:cNvSpPr/>
            <p:nvPr/>
          </p:nvSpPr>
          <p:spPr>
            <a:xfrm>
              <a:off x="1100160" y="427176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2" name="Line 243"/>
            <p:cNvSpPr/>
            <p:nvPr/>
          </p:nvSpPr>
          <p:spPr>
            <a:xfrm>
              <a:off x="1100160" y="414000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3" name="Line 244"/>
            <p:cNvSpPr/>
            <p:nvPr/>
          </p:nvSpPr>
          <p:spPr>
            <a:xfrm>
              <a:off x="1100160" y="400968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4" name="Line 245"/>
            <p:cNvSpPr/>
            <p:nvPr/>
          </p:nvSpPr>
          <p:spPr>
            <a:xfrm>
              <a:off x="1100160" y="387972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5" name="Line 246"/>
            <p:cNvSpPr/>
            <p:nvPr/>
          </p:nvSpPr>
          <p:spPr>
            <a:xfrm>
              <a:off x="1282680" y="6031080"/>
              <a:ext cx="0" cy="66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6" name="Line 247"/>
            <p:cNvSpPr/>
            <p:nvPr/>
          </p:nvSpPr>
          <p:spPr>
            <a:xfrm>
              <a:off x="1295280" y="60692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7" name="Line 248"/>
            <p:cNvSpPr/>
            <p:nvPr/>
          </p:nvSpPr>
          <p:spPr>
            <a:xfrm>
              <a:off x="130968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8" name="Line 249"/>
            <p:cNvSpPr/>
            <p:nvPr/>
          </p:nvSpPr>
          <p:spPr>
            <a:xfrm>
              <a:off x="1322280" y="6078600"/>
              <a:ext cx="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9" name="Line 250"/>
            <p:cNvSpPr/>
            <p:nvPr/>
          </p:nvSpPr>
          <p:spPr>
            <a:xfrm>
              <a:off x="133668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0" name="Line 251"/>
            <p:cNvSpPr/>
            <p:nvPr/>
          </p:nvSpPr>
          <p:spPr>
            <a:xfrm>
              <a:off x="1352520" y="5224320"/>
              <a:ext cx="0" cy="873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1" name="Line 252"/>
            <p:cNvSpPr/>
            <p:nvPr/>
          </p:nvSpPr>
          <p:spPr>
            <a:xfrm>
              <a:off x="1365120" y="6045480"/>
              <a:ext cx="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2" name="Line 253"/>
            <p:cNvSpPr/>
            <p:nvPr/>
          </p:nvSpPr>
          <p:spPr>
            <a:xfrm>
              <a:off x="137952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3" name="Line 254"/>
            <p:cNvSpPr/>
            <p:nvPr/>
          </p:nvSpPr>
          <p:spPr>
            <a:xfrm>
              <a:off x="1393920" y="60771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4" name="Line 255"/>
            <p:cNvSpPr/>
            <p:nvPr/>
          </p:nvSpPr>
          <p:spPr>
            <a:xfrm>
              <a:off x="1406520" y="6078600"/>
              <a:ext cx="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5" name="Line 256"/>
            <p:cNvSpPr/>
            <p:nvPr/>
          </p:nvSpPr>
          <p:spPr>
            <a:xfrm>
              <a:off x="1420920" y="606744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6" name="Line 257"/>
            <p:cNvSpPr/>
            <p:nvPr/>
          </p:nvSpPr>
          <p:spPr>
            <a:xfrm>
              <a:off x="1433520" y="6058080"/>
              <a:ext cx="0" cy="3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7" name="Line 258"/>
            <p:cNvSpPr/>
            <p:nvPr/>
          </p:nvSpPr>
          <p:spPr>
            <a:xfrm>
              <a:off x="1447920" y="606600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8" name="Line 259"/>
            <p:cNvSpPr/>
            <p:nvPr/>
          </p:nvSpPr>
          <p:spPr>
            <a:xfrm>
              <a:off x="146196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9" name="Line 260"/>
            <p:cNvSpPr/>
            <p:nvPr/>
          </p:nvSpPr>
          <p:spPr>
            <a:xfrm>
              <a:off x="1477800" y="6075720"/>
              <a:ext cx="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0" name="Line 261"/>
            <p:cNvSpPr/>
            <p:nvPr/>
          </p:nvSpPr>
          <p:spPr>
            <a:xfrm>
              <a:off x="1490760" y="6043680"/>
              <a:ext cx="0" cy="53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1" name="Line 262"/>
            <p:cNvSpPr/>
            <p:nvPr/>
          </p:nvSpPr>
          <p:spPr>
            <a:xfrm>
              <a:off x="1503360" y="608184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2" name="Line 263"/>
            <p:cNvSpPr/>
            <p:nvPr/>
          </p:nvSpPr>
          <p:spPr>
            <a:xfrm>
              <a:off x="1515960" y="60692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3" name="Line 264"/>
            <p:cNvSpPr/>
            <p:nvPr/>
          </p:nvSpPr>
          <p:spPr>
            <a:xfrm>
              <a:off x="153036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4" name="Line 265"/>
            <p:cNvSpPr/>
            <p:nvPr/>
          </p:nvSpPr>
          <p:spPr>
            <a:xfrm>
              <a:off x="1542960" y="608184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5" name="Line 266"/>
            <p:cNvSpPr/>
            <p:nvPr/>
          </p:nvSpPr>
          <p:spPr>
            <a:xfrm>
              <a:off x="155736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6" name="Line 267"/>
            <p:cNvSpPr/>
            <p:nvPr/>
          </p:nvSpPr>
          <p:spPr>
            <a:xfrm>
              <a:off x="157176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7" name="Line 268"/>
            <p:cNvSpPr/>
            <p:nvPr/>
          </p:nvSpPr>
          <p:spPr>
            <a:xfrm>
              <a:off x="1587600" y="6073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8" name="Line 269"/>
            <p:cNvSpPr/>
            <p:nvPr/>
          </p:nvSpPr>
          <p:spPr>
            <a:xfrm>
              <a:off x="1598760" y="6075720"/>
              <a:ext cx="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9" name="Line 270"/>
            <p:cNvSpPr/>
            <p:nvPr/>
          </p:nvSpPr>
          <p:spPr>
            <a:xfrm>
              <a:off x="1612800" y="60771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0" name="Line 271"/>
            <p:cNvSpPr/>
            <p:nvPr/>
          </p:nvSpPr>
          <p:spPr>
            <a:xfrm>
              <a:off x="1627200" y="608184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1" name="Line 272"/>
            <p:cNvSpPr/>
            <p:nvPr/>
          </p:nvSpPr>
          <p:spPr>
            <a:xfrm>
              <a:off x="1641600" y="60692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2" name="Line 273"/>
            <p:cNvSpPr/>
            <p:nvPr/>
          </p:nvSpPr>
          <p:spPr>
            <a:xfrm>
              <a:off x="165420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3" name="Line 274"/>
            <p:cNvSpPr/>
            <p:nvPr/>
          </p:nvSpPr>
          <p:spPr>
            <a:xfrm>
              <a:off x="1670040" y="6078600"/>
              <a:ext cx="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4" name="Line 275"/>
            <p:cNvSpPr/>
            <p:nvPr/>
          </p:nvSpPr>
          <p:spPr>
            <a:xfrm>
              <a:off x="1682640" y="6061320"/>
              <a:ext cx="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5" name="Line 276"/>
            <p:cNvSpPr/>
            <p:nvPr/>
          </p:nvSpPr>
          <p:spPr>
            <a:xfrm>
              <a:off x="1697040" y="6075720"/>
              <a:ext cx="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6" name="Line 277"/>
            <p:cNvSpPr/>
            <p:nvPr/>
          </p:nvSpPr>
          <p:spPr>
            <a:xfrm>
              <a:off x="1709640" y="6075720"/>
              <a:ext cx="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7" name="Line 278"/>
            <p:cNvSpPr/>
            <p:nvPr/>
          </p:nvSpPr>
          <p:spPr>
            <a:xfrm>
              <a:off x="1724040" y="6048720"/>
              <a:ext cx="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8" name="Line 279"/>
            <p:cNvSpPr/>
            <p:nvPr/>
          </p:nvSpPr>
          <p:spPr>
            <a:xfrm>
              <a:off x="1739880" y="6080400"/>
              <a:ext cx="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9" name="Line 280"/>
            <p:cNvSpPr/>
            <p:nvPr/>
          </p:nvSpPr>
          <p:spPr>
            <a:xfrm>
              <a:off x="1752480" y="6066000"/>
              <a:ext cx="0" cy="3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0" name="Line 281"/>
            <p:cNvSpPr/>
            <p:nvPr/>
          </p:nvSpPr>
          <p:spPr>
            <a:xfrm>
              <a:off x="176544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1" name="Line 282"/>
            <p:cNvSpPr/>
            <p:nvPr/>
          </p:nvSpPr>
          <p:spPr>
            <a:xfrm>
              <a:off x="1781280" y="6031080"/>
              <a:ext cx="0" cy="66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2" name="Line 283"/>
            <p:cNvSpPr/>
            <p:nvPr/>
          </p:nvSpPr>
          <p:spPr>
            <a:xfrm>
              <a:off x="1793880" y="6075720"/>
              <a:ext cx="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3" name="Line 284"/>
            <p:cNvSpPr/>
            <p:nvPr/>
          </p:nvSpPr>
          <p:spPr>
            <a:xfrm>
              <a:off x="1806480" y="6072480"/>
              <a:ext cx="0" cy="25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4" name="Line 285"/>
            <p:cNvSpPr/>
            <p:nvPr/>
          </p:nvSpPr>
          <p:spPr>
            <a:xfrm>
              <a:off x="182088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5" name="Line 286"/>
            <p:cNvSpPr/>
            <p:nvPr/>
          </p:nvSpPr>
          <p:spPr>
            <a:xfrm>
              <a:off x="1835280" y="6080400"/>
              <a:ext cx="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6" name="Line 287"/>
            <p:cNvSpPr/>
            <p:nvPr/>
          </p:nvSpPr>
          <p:spPr>
            <a:xfrm>
              <a:off x="1847880" y="6080400"/>
              <a:ext cx="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7" name="Line 288"/>
            <p:cNvSpPr/>
            <p:nvPr/>
          </p:nvSpPr>
          <p:spPr>
            <a:xfrm>
              <a:off x="1862280" y="6078600"/>
              <a:ext cx="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8" name="Line 289"/>
            <p:cNvSpPr/>
            <p:nvPr/>
          </p:nvSpPr>
          <p:spPr>
            <a:xfrm>
              <a:off x="187632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9" name="Line 290"/>
            <p:cNvSpPr/>
            <p:nvPr/>
          </p:nvSpPr>
          <p:spPr>
            <a:xfrm>
              <a:off x="188928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0" name="Line 291"/>
            <p:cNvSpPr/>
            <p:nvPr/>
          </p:nvSpPr>
          <p:spPr>
            <a:xfrm>
              <a:off x="190332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1" name="Line 292"/>
            <p:cNvSpPr/>
            <p:nvPr/>
          </p:nvSpPr>
          <p:spPr>
            <a:xfrm>
              <a:off x="1917720" y="608832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2" name="Line 293"/>
            <p:cNvSpPr/>
            <p:nvPr/>
          </p:nvSpPr>
          <p:spPr>
            <a:xfrm>
              <a:off x="1932120" y="608184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3" name="Line 294"/>
            <p:cNvSpPr/>
            <p:nvPr/>
          </p:nvSpPr>
          <p:spPr>
            <a:xfrm>
              <a:off x="1944720" y="60771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4" name="Line 295"/>
            <p:cNvSpPr/>
            <p:nvPr/>
          </p:nvSpPr>
          <p:spPr>
            <a:xfrm>
              <a:off x="1960560" y="608184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5" name="Line 296"/>
            <p:cNvSpPr/>
            <p:nvPr/>
          </p:nvSpPr>
          <p:spPr>
            <a:xfrm>
              <a:off x="1973160" y="6073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6" name="Line 297"/>
            <p:cNvSpPr/>
            <p:nvPr/>
          </p:nvSpPr>
          <p:spPr>
            <a:xfrm>
              <a:off x="198756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7" name="Line 298"/>
            <p:cNvSpPr/>
            <p:nvPr/>
          </p:nvSpPr>
          <p:spPr>
            <a:xfrm>
              <a:off x="2001960" y="60771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8" name="Line 299"/>
            <p:cNvSpPr/>
            <p:nvPr/>
          </p:nvSpPr>
          <p:spPr>
            <a:xfrm>
              <a:off x="201456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9" name="Line 300"/>
            <p:cNvSpPr/>
            <p:nvPr/>
          </p:nvSpPr>
          <p:spPr>
            <a:xfrm>
              <a:off x="2030400" y="608184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0" name="Line 301"/>
            <p:cNvSpPr/>
            <p:nvPr/>
          </p:nvSpPr>
          <p:spPr>
            <a:xfrm>
              <a:off x="204300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1" name="Line 302"/>
            <p:cNvSpPr/>
            <p:nvPr/>
          </p:nvSpPr>
          <p:spPr>
            <a:xfrm>
              <a:off x="205740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2" name="Line 303"/>
            <p:cNvSpPr/>
            <p:nvPr/>
          </p:nvSpPr>
          <p:spPr>
            <a:xfrm>
              <a:off x="207180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3" name="Line 304"/>
            <p:cNvSpPr/>
            <p:nvPr/>
          </p:nvSpPr>
          <p:spPr>
            <a:xfrm>
              <a:off x="208440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4" name="Line 305"/>
            <p:cNvSpPr/>
            <p:nvPr/>
          </p:nvSpPr>
          <p:spPr>
            <a:xfrm>
              <a:off x="209700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5" name="Line 306"/>
            <p:cNvSpPr/>
            <p:nvPr/>
          </p:nvSpPr>
          <p:spPr>
            <a:xfrm>
              <a:off x="2111400" y="608184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6" name="Line 307"/>
            <p:cNvSpPr/>
            <p:nvPr/>
          </p:nvSpPr>
          <p:spPr>
            <a:xfrm>
              <a:off x="212580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7" name="Line 308"/>
            <p:cNvSpPr/>
            <p:nvPr/>
          </p:nvSpPr>
          <p:spPr>
            <a:xfrm>
              <a:off x="213984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8" name="Line 309"/>
            <p:cNvSpPr/>
            <p:nvPr/>
          </p:nvSpPr>
          <p:spPr>
            <a:xfrm>
              <a:off x="215280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9" name="Line 310"/>
            <p:cNvSpPr/>
            <p:nvPr/>
          </p:nvSpPr>
          <p:spPr>
            <a:xfrm>
              <a:off x="2166840" y="60692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0" name="Line 311"/>
            <p:cNvSpPr/>
            <p:nvPr/>
          </p:nvSpPr>
          <p:spPr>
            <a:xfrm>
              <a:off x="2181240" y="6080400"/>
              <a:ext cx="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1" name="Line 312"/>
            <p:cNvSpPr/>
            <p:nvPr/>
          </p:nvSpPr>
          <p:spPr>
            <a:xfrm>
              <a:off x="2193840" y="6070680"/>
              <a:ext cx="0" cy="26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2" name="Line 313"/>
            <p:cNvSpPr/>
            <p:nvPr/>
          </p:nvSpPr>
          <p:spPr>
            <a:xfrm>
              <a:off x="220824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3" name="Line 314"/>
            <p:cNvSpPr/>
            <p:nvPr/>
          </p:nvSpPr>
          <p:spPr>
            <a:xfrm>
              <a:off x="222264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4" name="Line 315"/>
            <p:cNvSpPr/>
            <p:nvPr/>
          </p:nvSpPr>
          <p:spPr>
            <a:xfrm>
              <a:off x="223668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5" name="Line 316"/>
            <p:cNvSpPr/>
            <p:nvPr/>
          </p:nvSpPr>
          <p:spPr>
            <a:xfrm>
              <a:off x="224964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6" name="Line 317"/>
            <p:cNvSpPr/>
            <p:nvPr/>
          </p:nvSpPr>
          <p:spPr>
            <a:xfrm>
              <a:off x="226548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7" name="Line 318"/>
            <p:cNvSpPr/>
            <p:nvPr/>
          </p:nvSpPr>
          <p:spPr>
            <a:xfrm>
              <a:off x="227808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8" name="Line 319"/>
            <p:cNvSpPr/>
            <p:nvPr/>
          </p:nvSpPr>
          <p:spPr>
            <a:xfrm>
              <a:off x="2290680" y="608832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9" name="Line 320"/>
            <p:cNvSpPr/>
            <p:nvPr/>
          </p:nvSpPr>
          <p:spPr>
            <a:xfrm>
              <a:off x="230832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0" name="Line 321"/>
            <p:cNvSpPr/>
            <p:nvPr/>
          </p:nvSpPr>
          <p:spPr>
            <a:xfrm>
              <a:off x="231948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1" name="Line 322"/>
            <p:cNvSpPr/>
            <p:nvPr/>
          </p:nvSpPr>
          <p:spPr>
            <a:xfrm>
              <a:off x="233352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2" name="Line 323"/>
            <p:cNvSpPr/>
            <p:nvPr/>
          </p:nvSpPr>
          <p:spPr>
            <a:xfrm>
              <a:off x="234792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3" name="Line 324"/>
            <p:cNvSpPr/>
            <p:nvPr/>
          </p:nvSpPr>
          <p:spPr>
            <a:xfrm>
              <a:off x="2360520" y="608832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4" name="Line 325"/>
            <p:cNvSpPr/>
            <p:nvPr/>
          </p:nvSpPr>
          <p:spPr>
            <a:xfrm>
              <a:off x="237168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5" name="Line 326"/>
            <p:cNvSpPr/>
            <p:nvPr/>
          </p:nvSpPr>
          <p:spPr>
            <a:xfrm>
              <a:off x="2387520" y="6053400"/>
              <a:ext cx="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6" name="Line 327"/>
            <p:cNvSpPr/>
            <p:nvPr/>
          </p:nvSpPr>
          <p:spPr>
            <a:xfrm>
              <a:off x="240192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7" name="Line 328"/>
            <p:cNvSpPr/>
            <p:nvPr/>
          </p:nvSpPr>
          <p:spPr>
            <a:xfrm>
              <a:off x="2416320" y="6034320"/>
              <a:ext cx="0" cy="63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8" name="Line 329"/>
            <p:cNvSpPr/>
            <p:nvPr/>
          </p:nvSpPr>
          <p:spPr>
            <a:xfrm>
              <a:off x="242892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9" name="Line 330"/>
            <p:cNvSpPr/>
            <p:nvPr/>
          </p:nvSpPr>
          <p:spPr>
            <a:xfrm>
              <a:off x="244476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0" name="Line 331"/>
            <p:cNvSpPr/>
            <p:nvPr/>
          </p:nvSpPr>
          <p:spPr>
            <a:xfrm>
              <a:off x="245736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1" name="Line 332"/>
            <p:cNvSpPr/>
            <p:nvPr/>
          </p:nvSpPr>
          <p:spPr>
            <a:xfrm>
              <a:off x="2473560" y="608652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2" name="Line 333"/>
            <p:cNvSpPr/>
            <p:nvPr/>
          </p:nvSpPr>
          <p:spPr>
            <a:xfrm>
              <a:off x="248616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3" name="Line 334"/>
            <p:cNvSpPr/>
            <p:nvPr/>
          </p:nvSpPr>
          <p:spPr>
            <a:xfrm>
              <a:off x="250056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4" name="Line 335"/>
            <p:cNvSpPr/>
            <p:nvPr/>
          </p:nvSpPr>
          <p:spPr>
            <a:xfrm>
              <a:off x="251316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5" name="Line 336"/>
            <p:cNvSpPr/>
            <p:nvPr/>
          </p:nvSpPr>
          <p:spPr>
            <a:xfrm>
              <a:off x="2527200" y="608832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6" name="Line 337"/>
            <p:cNvSpPr/>
            <p:nvPr/>
          </p:nvSpPr>
          <p:spPr>
            <a:xfrm>
              <a:off x="254160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7" name="Line 338"/>
            <p:cNvSpPr/>
            <p:nvPr/>
          </p:nvSpPr>
          <p:spPr>
            <a:xfrm>
              <a:off x="2554200" y="608832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8" name="Line 339"/>
            <p:cNvSpPr/>
            <p:nvPr/>
          </p:nvSpPr>
          <p:spPr>
            <a:xfrm>
              <a:off x="256860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9" name="Line 340"/>
            <p:cNvSpPr/>
            <p:nvPr/>
          </p:nvSpPr>
          <p:spPr>
            <a:xfrm>
              <a:off x="2583000" y="608832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0" name="Line 341"/>
            <p:cNvSpPr/>
            <p:nvPr/>
          </p:nvSpPr>
          <p:spPr>
            <a:xfrm>
              <a:off x="259740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1" name="Line 342"/>
            <p:cNvSpPr/>
            <p:nvPr/>
          </p:nvSpPr>
          <p:spPr>
            <a:xfrm>
              <a:off x="261000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2" name="Line 343"/>
            <p:cNvSpPr/>
            <p:nvPr/>
          </p:nvSpPr>
          <p:spPr>
            <a:xfrm>
              <a:off x="262404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3" name="Line 344"/>
            <p:cNvSpPr/>
            <p:nvPr/>
          </p:nvSpPr>
          <p:spPr>
            <a:xfrm>
              <a:off x="263700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4" name="Line 345"/>
            <p:cNvSpPr/>
            <p:nvPr/>
          </p:nvSpPr>
          <p:spPr>
            <a:xfrm>
              <a:off x="2652840" y="608832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5" name="Line 346"/>
            <p:cNvSpPr/>
            <p:nvPr/>
          </p:nvSpPr>
          <p:spPr>
            <a:xfrm>
              <a:off x="266400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6" name="Line 347"/>
            <p:cNvSpPr/>
            <p:nvPr/>
          </p:nvSpPr>
          <p:spPr>
            <a:xfrm>
              <a:off x="267804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7" name="Line 348"/>
            <p:cNvSpPr/>
            <p:nvPr/>
          </p:nvSpPr>
          <p:spPr>
            <a:xfrm>
              <a:off x="269100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8" name="Line 349"/>
            <p:cNvSpPr/>
            <p:nvPr/>
          </p:nvSpPr>
          <p:spPr>
            <a:xfrm>
              <a:off x="270684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9" name="Line 350"/>
            <p:cNvSpPr/>
            <p:nvPr/>
          </p:nvSpPr>
          <p:spPr>
            <a:xfrm>
              <a:off x="271944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0" name="Line 351"/>
            <p:cNvSpPr/>
            <p:nvPr/>
          </p:nvSpPr>
          <p:spPr>
            <a:xfrm>
              <a:off x="273384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1" name="Line 352"/>
            <p:cNvSpPr/>
            <p:nvPr/>
          </p:nvSpPr>
          <p:spPr>
            <a:xfrm>
              <a:off x="274788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2" name="Line 353"/>
            <p:cNvSpPr/>
            <p:nvPr/>
          </p:nvSpPr>
          <p:spPr>
            <a:xfrm>
              <a:off x="2760840" y="6078600"/>
              <a:ext cx="0" cy="18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3" name="Line 354"/>
            <p:cNvSpPr/>
            <p:nvPr/>
          </p:nvSpPr>
          <p:spPr>
            <a:xfrm>
              <a:off x="277488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4" name="Line 355"/>
            <p:cNvSpPr/>
            <p:nvPr/>
          </p:nvSpPr>
          <p:spPr>
            <a:xfrm>
              <a:off x="2803680" y="6072480"/>
              <a:ext cx="0" cy="25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5" name="Line 356"/>
            <p:cNvSpPr/>
            <p:nvPr/>
          </p:nvSpPr>
          <p:spPr>
            <a:xfrm>
              <a:off x="281628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6" name="Line 357"/>
            <p:cNvSpPr/>
            <p:nvPr/>
          </p:nvSpPr>
          <p:spPr>
            <a:xfrm>
              <a:off x="283068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7" name="Line 358"/>
            <p:cNvSpPr/>
            <p:nvPr/>
          </p:nvSpPr>
          <p:spPr>
            <a:xfrm>
              <a:off x="284472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8" name="Line 359"/>
            <p:cNvSpPr/>
            <p:nvPr/>
          </p:nvSpPr>
          <p:spPr>
            <a:xfrm>
              <a:off x="285912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9" name="Line 360"/>
            <p:cNvSpPr/>
            <p:nvPr/>
          </p:nvSpPr>
          <p:spPr>
            <a:xfrm>
              <a:off x="287172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0" name="Line 361"/>
            <p:cNvSpPr/>
            <p:nvPr/>
          </p:nvSpPr>
          <p:spPr>
            <a:xfrm>
              <a:off x="288612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1" name="Line 362"/>
            <p:cNvSpPr/>
            <p:nvPr/>
          </p:nvSpPr>
          <p:spPr>
            <a:xfrm>
              <a:off x="290196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2" name="Line 363"/>
            <p:cNvSpPr/>
            <p:nvPr/>
          </p:nvSpPr>
          <p:spPr>
            <a:xfrm>
              <a:off x="291492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3" name="Line 364"/>
            <p:cNvSpPr/>
            <p:nvPr/>
          </p:nvSpPr>
          <p:spPr>
            <a:xfrm>
              <a:off x="292572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4" name="Line 365"/>
            <p:cNvSpPr/>
            <p:nvPr/>
          </p:nvSpPr>
          <p:spPr>
            <a:xfrm>
              <a:off x="294192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5" name="Line 366"/>
            <p:cNvSpPr/>
            <p:nvPr/>
          </p:nvSpPr>
          <p:spPr>
            <a:xfrm>
              <a:off x="295272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6" name="Line 367"/>
            <p:cNvSpPr/>
            <p:nvPr/>
          </p:nvSpPr>
          <p:spPr>
            <a:xfrm>
              <a:off x="297180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7" name="Line 368"/>
            <p:cNvSpPr/>
            <p:nvPr/>
          </p:nvSpPr>
          <p:spPr>
            <a:xfrm>
              <a:off x="299736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8" name="Line 369"/>
            <p:cNvSpPr/>
            <p:nvPr/>
          </p:nvSpPr>
          <p:spPr>
            <a:xfrm>
              <a:off x="300996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9" name="Line 370"/>
            <p:cNvSpPr/>
            <p:nvPr/>
          </p:nvSpPr>
          <p:spPr>
            <a:xfrm>
              <a:off x="302256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0" name="Line 371"/>
            <p:cNvSpPr/>
            <p:nvPr/>
          </p:nvSpPr>
          <p:spPr>
            <a:xfrm>
              <a:off x="304020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1" name="Line 372"/>
            <p:cNvSpPr/>
            <p:nvPr/>
          </p:nvSpPr>
          <p:spPr>
            <a:xfrm>
              <a:off x="305280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2" name="Line 373"/>
            <p:cNvSpPr/>
            <p:nvPr/>
          </p:nvSpPr>
          <p:spPr>
            <a:xfrm>
              <a:off x="306396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3" name="Line 374"/>
            <p:cNvSpPr/>
            <p:nvPr/>
          </p:nvSpPr>
          <p:spPr>
            <a:xfrm>
              <a:off x="307836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4" name="Line 375"/>
            <p:cNvSpPr/>
            <p:nvPr/>
          </p:nvSpPr>
          <p:spPr>
            <a:xfrm>
              <a:off x="309420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5" name="Line 376"/>
            <p:cNvSpPr/>
            <p:nvPr/>
          </p:nvSpPr>
          <p:spPr>
            <a:xfrm>
              <a:off x="310536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6" name="Line 377"/>
            <p:cNvSpPr/>
            <p:nvPr/>
          </p:nvSpPr>
          <p:spPr>
            <a:xfrm>
              <a:off x="312120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7" name="Line 378"/>
            <p:cNvSpPr/>
            <p:nvPr/>
          </p:nvSpPr>
          <p:spPr>
            <a:xfrm>
              <a:off x="313560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8" name="Line 379"/>
            <p:cNvSpPr/>
            <p:nvPr/>
          </p:nvSpPr>
          <p:spPr>
            <a:xfrm>
              <a:off x="315144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9" name="Line 380"/>
            <p:cNvSpPr/>
            <p:nvPr/>
          </p:nvSpPr>
          <p:spPr>
            <a:xfrm>
              <a:off x="316224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0" name="Line 381"/>
            <p:cNvSpPr/>
            <p:nvPr/>
          </p:nvSpPr>
          <p:spPr>
            <a:xfrm>
              <a:off x="317664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1" name="Line 382"/>
            <p:cNvSpPr/>
            <p:nvPr/>
          </p:nvSpPr>
          <p:spPr>
            <a:xfrm>
              <a:off x="318924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2" name="Line 383"/>
            <p:cNvSpPr/>
            <p:nvPr/>
          </p:nvSpPr>
          <p:spPr>
            <a:xfrm>
              <a:off x="320364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3" name="Line 384"/>
            <p:cNvSpPr/>
            <p:nvPr/>
          </p:nvSpPr>
          <p:spPr>
            <a:xfrm>
              <a:off x="321624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4" name="Line 385"/>
            <p:cNvSpPr/>
            <p:nvPr/>
          </p:nvSpPr>
          <p:spPr>
            <a:xfrm>
              <a:off x="327528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5" name="Line 386"/>
            <p:cNvSpPr/>
            <p:nvPr/>
          </p:nvSpPr>
          <p:spPr>
            <a:xfrm>
              <a:off x="328608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6" name="Line 387"/>
            <p:cNvSpPr/>
            <p:nvPr/>
          </p:nvSpPr>
          <p:spPr>
            <a:xfrm>
              <a:off x="330228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7" name="Line 388"/>
            <p:cNvSpPr/>
            <p:nvPr/>
          </p:nvSpPr>
          <p:spPr>
            <a:xfrm>
              <a:off x="331488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8" name="Line 389"/>
            <p:cNvSpPr/>
            <p:nvPr/>
          </p:nvSpPr>
          <p:spPr>
            <a:xfrm>
              <a:off x="334188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9" name="Line 390"/>
            <p:cNvSpPr/>
            <p:nvPr/>
          </p:nvSpPr>
          <p:spPr>
            <a:xfrm>
              <a:off x="338616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0" name="Line 391"/>
            <p:cNvSpPr/>
            <p:nvPr/>
          </p:nvSpPr>
          <p:spPr>
            <a:xfrm>
              <a:off x="342612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1" name="Line 392"/>
            <p:cNvSpPr/>
            <p:nvPr/>
          </p:nvSpPr>
          <p:spPr>
            <a:xfrm>
              <a:off x="344016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2" name="Line 393"/>
            <p:cNvSpPr/>
            <p:nvPr/>
          </p:nvSpPr>
          <p:spPr>
            <a:xfrm>
              <a:off x="345312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3" name="Line 394"/>
            <p:cNvSpPr/>
            <p:nvPr/>
          </p:nvSpPr>
          <p:spPr>
            <a:xfrm>
              <a:off x="346572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4" name="Line 395"/>
            <p:cNvSpPr/>
            <p:nvPr/>
          </p:nvSpPr>
          <p:spPr>
            <a:xfrm>
              <a:off x="348156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5" name="Line 396"/>
            <p:cNvSpPr/>
            <p:nvPr/>
          </p:nvSpPr>
          <p:spPr>
            <a:xfrm>
              <a:off x="3495960" y="5180040"/>
              <a:ext cx="0" cy="9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6" name="Line 397"/>
            <p:cNvSpPr/>
            <p:nvPr/>
          </p:nvSpPr>
          <p:spPr>
            <a:xfrm>
              <a:off x="3506760" y="5972400"/>
              <a:ext cx="0" cy="125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7" name="Line 398"/>
            <p:cNvSpPr/>
            <p:nvPr/>
          </p:nvSpPr>
          <p:spPr>
            <a:xfrm>
              <a:off x="3521160" y="6080400"/>
              <a:ext cx="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8" name="Line 399"/>
            <p:cNvSpPr/>
            <p:nvPr/>
          </p:nvSpPr>
          <p:spPr>
            <a:xfrm>
              <a:off x="353700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9" name="Line 400"/>
            <p:cNvSpPr/>
            <p:nvPr/>
          </p:nvSpPr>
          <p:spPr>
            <a:xfrm>
              <a:off x="3576960" y="60836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0" name="Line 401"/>
            <p:cNvSpPr/>
            <p:nvPr/>
          </p:nvSpPr>
          <p:spPr>
            <a:xfrm>
              <a:off x="3730680" y="6061320"/>
              <a:ext cx="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1" name="Line 402"/>
            <p:cNvSpPr/>
            <p:nvPr/>
          </p:nvSpPr>
          <p:spPr>
            <a:xfrm>
              <a:off x="374184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2" name="Line 403"/>
            <p:cNvSpPr/>
            <p:nvPr/>
          </p:nvSpPr>
          <p:spPr>
            <a:xfrm>
              <a:off x="382752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3" name="Line 404"/>
            <p:cNvSpPr/>
            <p:nvPr/>
          </p:nvSpPr>
          <p:spPr>
            <a:xfrm>
              <a:off x="393408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4" name="Line 405"/>
            <p:cNvSpPr/>
            <p:nvPr/>
          </p:nvSpPr>
          <p:spPr>
            <a:xfrm>
              <a:off x="3953160" y="6091560"/>
              <a:ext cx="0" cy="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5" name="Line 406"/>
            <p:cNvSpPr/>
            <p:nvPr/>
          </p:nvSpPr>
          <p:spPr>
            <a:xfrm>
              <a:off x="518184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6" name="Line 407"/>
            <p:cNvSpPr/>
            <p:nvPr/>
          </p:nvSpPr>
          <p:spPr>
            <a:xfrm>
              <a:off x="526428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7" name="Line 408"/>
            <p:cNvSpPr/>
            <p:nvPr/>
          </p:nvSpPr>
          <p:spPr>
            <a:xfrm>
              <a:off x="5318280" y="60897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8" name="Line 409"/>
            <p:cNvSpPr/>
            <p:nvPr/>
          </p:nvSpPr>
          <p:spPr>
            <a:xfrm>
              <a:off x="5538960" y="6080400"/>
              <a:ext cx="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9" name="Line 410"/>
            <p:cNvSpPr/>
            <p:nvPr/>
          </p:nvSpPr>
          <p:spPr>
            <a:xfrm>
              <a:off x="555336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0" name="Line 411"/>
            <p:cNvSpPr/>
            <p:nvPr/>
          </p:nvSpPr>
          <p:spPr>
            <a:xfrm>
              <a:off x="556920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1" name="Line 412"/>
            <p:cNvSpPr/>
            <p:nvPr/>
          </p:nvSpPr>
          <p:spPr>
            <a:xfrm>
              <a:off x="573768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2" name="Line 413"/>
            <p:cNvSpPr/>
            <p:nvPr/>
          </p:nvSpPr>
          <p:spPr>
            <a:xfrm>
              <a:off x="5761440" y="3841560"/>
              <a:ext cx="0" cy="225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3" name="Line 414"/>
            <p:cNvSpPr/>
            <p:nvPr/>
          </p:nvSpPr>
          <p:spPr>
            <a:xfrm>
              <a:off x="5775480" y="5621400"/>
              <a:ext cx="0" cy="476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4" name="Line 415"/>
            <p:cNvSpPr/>
            <p:nvPr/>
          </p:nvSpPr>
          <p:spPr>
            <a:xfrm>
              <a:off x="5789880" y="6004080"/>
              <a:ext cx="0" cy="9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5" name="Line 416"/>
            <p:cNvSpPr/>
            <p:nvPr/>
          </p:nvSpPr>
          <p:spPr>
            <a:xfrm>
              <a:off x="5802480" y="608508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6" name="Line 417"/>
            <p:cNvSpPr/>
            <p:nvPr/>
          </p:nvSpPr>
          <p:spPr>
            <a:xfrm>
              <a:off x="581688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7" name="Line 418"/>
            <p:cNvSpPr/>
            <p:nvPr/>
          </p:nvSpPr>
          <p:spPr>
            <a:xfrm>
              <a:off x="5997960" y="6005520"/>
              <a:ext cx="0" cy="9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8" name="Line 419"/>
            <p:cNvSpPr/>
            <p:nvPr/>
          </p:nvSpPr>
          <p:spPr>
            <a:xfrm>
              <a:off x="6013800" y="60771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9" name="Line 420"/>
            <p:cNvSpPr/>
            <p:nvPr/>
          </p:nvSpPr>
          <p:spPr>
            <a:xfrm>
              <a:off x="6024960" y="6093000"/>
              <a:ext cx="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0" name="Line 421"/>
            <p:cNvSpPr/>
            <p:nvPr/>
          </p:nvSpPr>
          <p:spPr>
            <a:xfrm>
              <a:off x="6286680" y="6094440"/>
              <a:ext cx="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1" name="Text Box 422"/>
            <p:cNvSpPr/>
            <p:nvPr/>
          </p:nvSpPr>
          <p:spPr>
            <a:xfrm>
              <a:off x="5484240" y="361620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24.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2" name="Text Box 423"/>
            <p:cNvSpPr/>
            <p:nvPr/>
          </p:nvSpPr>
          <p:spPr>
            <a:xfrm>
              <a:off x="3212640" y="494352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0.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3" name="Text Box 424"/>
            <p:cNvSpPr/>
            <p:nvPr/>
          </p:nvSpPr>
          <p:spPr>
            <a:xfrm>
              <a:off x="1080360" y="500220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5.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4" name="Text Box 425"/>
            <p:cNvSpPr/>
            <p:nvPr/>
          </p:nvSpPr>
          <p:spPr>
            <a:xfrm>
              <a:off x="5738400" y="578016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41.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5" name="Text Box 1077"/>
            <p:cNvSpPr/>
            <p:nvPr/>
          </p:nvSpPr>
          <p:spPr>
            <a:xfrm>
              <a:off x="728640" y="3768480"/>
              <a:ext cx="358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CI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626" name="Groupe 1078"/>
          <p:cNvGrpSpPr/>
          <p:nvPr/>
        </p:nvGrpSpPr>
        <p:grpSpPr>
          <a:xfrm>
            <a:off x="726480" y="6272280"/>
            <a:ext cx="5750640" cy="2802240"/>
            <a:chOff x="726480" y="6272280"/>
            <a:chExt cx="5750640" cy="2802240"/>
          </a:xfrm>
        </p:grpSpPr>
        <p:sp>
          <p:nvSpPr>
            <p:cNvPr id="627" name="Line 428"/>
            <p:cNvSpPr/>
            <p:nvPr/>
          </p:nvSpPr>
          <p:spPr>
            <a:xfrm>
              <a:off x="1142640" y="8616240"/>
              <a:ext cx="5334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8" name="Line 429"/>
            <p:cNvSpPr/>
            <p:nvPr/>
          </p:nvSpPr>
          <p:spPr>
            <a:xfrm flipV="1">
              <a:off x="11901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9" name="Line 430"/>
            <p:cNvSpPr/>
            <p:nvPr/>
          </p:nvSpPr>
          <p:spPr>
            <a:xfrm flipV="1">
              <a:off x="1242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0" name="Line 431"/>
            <p:cNvSpPr/>
            <p:nvPr/>
          </p:nvSpPr>
          <p:spPr>
            <a:xfrm flipV="1">
              <a:off x="12942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1" name="Line 432"/>
            <p:cNvSpPr/>
            <p:nvPr/>
          </p:nvSpPr>
          <p:spPr>
            <a:xfrm flipV="1">
              <a:off x="13464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2" name="Line 433"/>
            <p:cNvSpPr/>
            <p:nvPr/>
          </p:nvSpPr>
          <p:spPr>
            <a:xfrm flipV="1">
              <a:off x="13986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3" name="Line 434"/>
            <p:cNvSpPr/>
            <p:nvPr/>
          </p:nvSpPr>
          <p:spPr>
            <a:xfrm flipV="1">
              <a:off x="14522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4" name="Line 435"/>
            <p:cNvSpPr/>
            <p:nvPr/>
          </p:nvSpPr>
          <p:spPr>
            <a:xfrm flipV="1">
              <a:off x="15040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5" name="Line 436"/>
            <p:cNvSpPr/>
            <p:nvPr/>
          </p:nvSpPr>
          <p:spPr>
            <a:xfrm flipV="1">
              <a:off x="15562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6" name="Line 437"/>
            <p:cNvSpPr/>
            <p:nvPr/>
          </p:nvSpPr>
          <p:spPr>
            <a:xfrm flipV="1">
              <a:off x="16084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7" name="Line 438"/>
            <p:cNvSpPr/>
            <p:nvPr/>
          </p:nvSpPr>
          <p:spPr>
            <a:xfrm flipV="1">
              <a:off x="16606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8" name="Line 439"/>
            <p:cNvSpPr/>
            <p:nvPr/>
          </p:nvSpPr>
          <p:spPr>
            <a:xfrm flipV="1">
              <a:off x="17125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9" name="Line 440"/>
            <p:cNvSpPr/>
            <p:nvPr/>
          </p:nvSpPr>
          <p:spPr>
            <a:xfrm flipV="1">
              <a:off x="17647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0" name="Line 441"/>
            <p:cNvSpPr/>
            <p:nvPr/>
          </p:nvSpPr>
          <p:spPr>
            <a:xfrm flipV="1">
              <a:off x="18183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1" name="Line 442"/>
            <p:cNvSpPr/>
            <p:nvPr/>
          </p:nvSpPr>
          <p:spPr>
            <a:xfrm flipV="1">
              <a:off x="18705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2" name="Line 443"/>
            <p:cNvSpPr/>
            <p:nvPr/>
          </p:nvSpPr>
          <p:spPr>
            <a:xfrm flipV="1">
              <a:off x="19224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3" name="Line 444"/>
            <p:cNvSpPr/>
            <p:nvPr/>
          </p:nvSpPr>
          <p:spPr>
            <a:xfrm flipV="1">
              <a:off x="19746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4" name="Line 445"/>
            <p:cNvSpPr/>
            <p:nvPr/>
          </p:nvSpPr>
          <p:spPr>
            <a:xfrm flipV="1">
              <a:off x="20268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5" name="Line 446"/>
            <p:cNvSpPr/>
            <p:nvPr/>
          </p:nvSpPr>
          <p:spPr>
            <a:xfrm flipV="1">
              <a:off x="2079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6" name="Line 447"/>
            <p:cNvSpPr/>
            <p:nvPr/>
          </p:nvSpPr>
          <p:spPr>
            <a:xfrm flipV="1">
              <a:off x="21308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7" name="Line 448"/>
            <p:cNvSpPr/>
            <p:nvPr/>
          </p:nvSpPr>
          <p:spPr>
            <a:xfrm flipV="1">
              <a:off x="21844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8" name="Line 449"/>
            <p:cNvSpPr/>
            <p:nvPr/>
          </p:nvSpPr>
          <p:spPr>
            <a:xfrm flipV="1">
              <a:off x="22366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9" name="Line 450"/>
            <p:cNvSpPr/>
            <p:nvPr/>
          </p:nvSpPr>
          <p:spPr>
            <a:xfrm flipV="1">
              <a:off x="22888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0" name="Line 451"/>
            <p:cNvSpPr/>
            <p:nvPr/>
          </p:nvSpPr>
          <p:spPr>
            <a:xfrm flipV="1">
              <a:off x="23410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1" name="Line 452"/>
            <p:cNvSpPr/>
            <p:nvPr/>
          </p:nvSpPr>
          <p:spPr>
            <a:xfrm flipV="1">
              <a:off x="23929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2" name="Line 453"/>
            <p:cNvSpPr/>
            <p:nvPr/>
          </p:nvSpPr>
          <p:spPr>
            <a:xfrm flipV="1">
              <a:off x="24451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3" name="Line 454"/>
            <p:cNvSpPr/>
            <p:nvPr/>
          </p:nvSpPr>
          <p:spPr>
            <a:xfrm flipV="1">
              <a:off x="24973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4" name="Line 455"/>
            <p:cNvSpPr/>
            <p:nvPr/>
          </p:nvSpPr>
          <p:spPr>
            <a:xfrm flipV="1">
              <a:off x="25509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5" name="Line 456"/>
            <p:cNvSpPr/>
            <p:nvPr/>
          </p:nvSpPr>
          <p:spPr>
            <a:xfrm flipV="1">
              <a:off x="26031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6" name="Line 457"/>
            <p:cNvSpPr/>
            <p:nvPr/>
          </p:nvSpPr>
          <p:spPr>
            <a:xfrm flipV="1">
              <a:off x="2655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7" name="Line 458"/>
            <p:cNvSpPr/>
            <p:nvPr/>
          </p:nvSpPr>
          <p:spPr>
            <a:xfrm flipV="1">
              <a:off x="27072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8" name="Line 459"/>
            <p:cNvSpPr/>
            <p:nvPr/>
          </p:nvSpPr>
          <p:spPr>
            <a:xfrm flipV="1">
              <a:off x="27594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9" name="Line 460"/>
            <p:cNvSpPr/>
            <p:nvPr/>
          </p:nvSpPr>
          <p:spPr>
            <a:xfrm flipV="1">
              <a:off x="28112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0" name="Line 461"/>
            <p:cNvSpPr/>
            <p:nvPr/>
          </p:nvSpPr>
          <p:spPr>
            <a:xfrm flipV="1">
              <a:off x="28634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1" name="Line 462"/>
            <p:cNvSpPr/>
            <p:nvPr/>
          </p:nvSpPr>
          <p:spPr>
            <a:xfrm flipV="1">
              <a:off x="29170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2" name="Line 463"/>
            <p:cNvSpPr/>
            <p:nvPr/>
          </p:nvSpPr>
          <p:spPr>
            <a:xfrm flipV="1">
              <a:off x="29692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3" name="Line 464"/>
            <p:cNvSpPr/>
            <p:nvPr/>
          </p:nvSpPr>
          <p:spPr>
            <a:xfrm flipV="1">
              <a:off x="30214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4" name="Line 465"/>
            <p:cNvSpPr/>
            <p:nvPr/>
          </p:nvSpPr>
          <p:spPr>
            <a:xfrm flipV="1">
              <a:off x="30733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5" name="Line 466"/>
            <p:cNvSpPr/>
            <p:nvPr/>
          </p:nvSpPr>
          <p:spPr>
            <a:xfrm flipV="1">
              <a:off x="31255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6" name="Line 467"/>
            <p:cNvSpPr/>
            <p:nvPr/>
          </p:nvSpPr>
          <p:spPr>
            <a:xfrm flipV="1">
              <a:off x="31777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7" name="Line 468"/>
            <p:cNvSpPr/>
            <p:nvPr/>
          </p:nvSpPr>
          <p:spPr>
            <a:xfrm flipV="1">
              <a:off x="32299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8" name="Line 469"/>
            <p:cNvSpPr/>
            <p:nvPr/>
          </p:nvSpPr>
          <p:spPr>
            <a:xfrm flipV="1">
              <a:off x="32835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9" name="Line 470"/>
            <p:cNvSpPr/>
            <p:nvPr/>
          </p:nvSpPr>
          <p:spPr>
            <a:xfrm flipV="1">
              <a:off x="33354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0" name="Line 471"/>
            <p:cNvSpPr/>
            <p:nvPr/>
          </p:nvSpPr>
          <p:spPr>
            <a:xfrm flipV="1">
              <a:off x="33876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1" name="Line 472"/>
            <p:cNvSpPr/>
            <p:nvPr/>
          </p:nvSpPr>
          <p:spPr>
            <a:xfrm flipV="1">
              <a:off x="34398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2" name="Line 473"/>
            <p:cNvSpPr/>
            <p:nvPr/>
          </p:nvSpPr>
          <p:spPr>
            <a:xfrm flipV="1">
              <a:off x="3492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3" name="Line 474"/>
            <p:cNvSpPr/>
            <p:nvPr/>
          </p:nvSpPr>
          <p:spPr>
            <a:xfrm flipV="1">
              <a:off x="35438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4" name="Line 475"/>
            <p:cNvSpPr/>
            <p:nvPr/>
          </p:nvSpPr>
          <p:spPr>
            <a:xfrm flipV="1">
              <a:off x="35960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5" name="Line 476"/>
            <p:cNvSpPr/>
            <p:nvPr/>
          </p:nvSpPr>
          <p:spPr>
            <a:xfrm flipV="1">
              <a:off x="36496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6" name="Line 477"/>
            <p:cNvSpPr/>
            <p:nvPr/>
          </p:nvSpPr>
          <p:spPr>
            <a:xfrm flipV="1">
              <a:off x="37018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7" name="Line 478"/>
            <p:cNvSpPr/>
            <p:nvPr/>
          </p:nvSpPr>
          <p:spPr>
            <a:xfrm flipV="1">
              <a:off x="37540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8" name="Line 479"/>
            <p:cNvSpPr/>
            <p:nvPr/>
          </p:nvSpPr>
          <p:spPr>
            <a:xfrm flipV="1">
              <a:off x="38059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9" name="Line 480"/>
            <p:cNvSpPr/>
            <p:nvPr/>
          </p:nvSpPr>
          <p:spPr>
            <a:xfrm flipV="1">
              <a:off x="38581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0" name="Line 481"/>
            <p:cNvSpPr/>
            <p:nvPr/>
          </p:nvSpPr>
          <p:spPr>
            <a:xfrm flipV="1">
              <a:off x="39103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1" name="Line 482"/>
            <p:cNvSpPr/>
            <p:nvPr/>
          </p:nvSpPr>
          <p:spPr>
            <a:xfrm flipV="1">
              <a:off x="39621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2" name="Line 483"/>
            <p:cNvSpPr/>
            <p:nvPr/>
          </p:nvSpPr>
          <p:spPr>
            <a:xfrm flipV="1">
              <a:off x="40161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3" name="Line 484"/>
            <p:cNvSpPr/>
            <p:nvPr/>
          </p:nvSpPr>
          <p:spPr>
            <a:xfrm flipV="1">
              <a:off x="4068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4" name="Line 485"/>
            <p:cNvSpPr/>
            <p:nvPr/>
          </p:nvSpPr>
          <p:spPr>
            <a:xfrm flipV="1">
              <a:off x="41202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5" name="Line 486"/>
            <p:cNvSpPr/>
            <p:nvPr/>
          </p:nvSpPr>
          <p:spPr>
            <a:xfrm flipV="1">
              <a:off x="41724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6" name="Line 487"/>
            <p:cNvSpPr/>
            <p:nvPr/>
          </p:nvSpPr>
          <p:spPr>
            <a:xfrm flipV="1">
              <a:off x="42242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7" name="Line 488"/>
            <p:cNvSpPr/>
            <p:nvPr/>
          </p:nvSpPr>
          <p:spPr>
            <a:xfrm flipV="1">
              <a:off x="42764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8" name="Line 489"/>
            <p:cNvSpPr/>
            <p:nvPr/>
          </p:nvSpPr>
          <p:spPr>
            <a:xfrm flipV="1">
              <a:off x="43286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9" name="Line 490"/>
            <p:cNvSpPr/>
            <p:nvPr/>
          </p:nvSpPr>
          <p:spPr>
            <a:xfrm flipV="1">
              <a:off x="43822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0" name="Line 491"/>
            <p:cNvSpPr/>
            <p:nvPr/>
          </p:nvSpPr>
          <p:spPr>
            <a:xfrm flipV="1">
              <a:off x="44344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1" name="Line 492"/>
            <p:cNvSpPr/>
            <p:nvPr/>
          </p:nvSpPr>
          <p:spPr>
            <a:xfrm flipV="1">
              <a:off x="44863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2" name="Line 493"/>
            <p:cNvSpPr/>
            <p:nvPr/>
          </p:nvSpPr>
          <p:spPr>
            <a:xfrm flipV="1">
              <a:off x="45385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3" name="Line 494"/>
            <p:cNvSpPr/>
            <p:nvPr/>
          </p:nvSpPr>
          <p:spPr>
            <a:xfrm flipV="1">
              <a:off x="45907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4" name="Line 495"/>
            <p:cNvSpPr/>
            <p:nvPr/>
          </p:nvSpPr>
          <p:spPr>
            <a:xfrm flipV="1">
              <a:off x="46429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5" name="Line 496"/>
            <p:cNvSpPr/>
            <p:nvPr/>
          </p:nvSpPr>
          <p:spPr>
            <a:xfrm flipV="1">
              <a:off x="46947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6" name="Line 497"/>
            <p:cNvSpPr/>
            <p:nvPr/>
          </p:nvSpPr>
          <p:spPr>
            <a:xfrm flipV="1">
              <a:off x="47484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7" name="Line 498"/>
            <p:cNvSpPr/>
            <p:nvPr/>
          </p:nvSpPr>
          <p:spPr>
            <a:xfrm flipV="1">
              <a:off x="48006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8" name="Line 499"/>
            <p:cNvSpPr/>
            <p:nvPr/>
          </p:nvSpPr>
          <p:spPr>
            <a:xfrm flipV="1">
              <a:off x="48528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9" name="Line 500"/>
            <p:cNvSpPr/>
            <p:nvPr/>
          </p:nvSpPr>
          <p:spPr>
            <a:xfrm flipV="1">
              <a:off x="4905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0" name="Line 501"/>
            <p:cNvSpPr/>
            <p:nvPr/>
          </p:nvSpPr>
          <p:spPr>
            <a:xfrm flipV="1">
              <a:off x="49568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1" name="Line 502"/>
            <p:cNvSpPr/>
            <p:nvPr/>
          </p:nvSpPr>
          <p:spPr>
            <a:xfrm flipV="1">
              <a:off x="50090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2" name="Line 503"/>
            <p:cNvSpPr/>
            <p:nvPr/>
          </p:nvSpPr>
          <p:spPr>
            <a:xfrm flipV="1">
              <a:off x="50612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3" name="Line 504"/>
            <p:cNvSpPr/>
            <p:nvPr/>
          </p:nvSpPr>
          <p:spPr>
            <a:xfrm flipV="1">
              <a:off x="51148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4" name="Line 505"/>
            <p:cNvSpPr/>
            <p:nvPr/>
          </p:nvSpPr>
          <p:spPr>
            <a:xfrm flipV="1">
              <a:off x="51670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5" name="Line 506"/>
            <p:cNvSpPr/>
            <p:nvPr/>
          </p:nvSpPr>
          <p:spPr>
            <a:xfrm flipV="1">
              <a:off x="52189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6" name="Line 507"/>
            <p:cNvSpPr/>
            <p:nvPr/>
          </p:nvSpPr>
          <p:spPr>
            <a:xfrm flipV="1">
              <a:off x="52711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7" name="Line 508"/>
            <p:cNvSpPr/>
            <p:nvPr/>
          </p:nvSpPr>
          <p:spPr>
            <a:xfrm flipV="1">
              <a:off x="53233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8" name="Line 509"/>
            <p:cNvSpPr/>
            <p:nvPr/>
          </p:nvSpPr>
          <p:spPr>
            <a:xfrm flipV="1">
              <a:off x="53751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9" name="Line 510"/>
            <p:cNvSpPr/>
            <p:nvPr/>
          </p:nvSpPr>
          <p:spPr>
            <a:xfrm flipV="1">
              <a:off x="54273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0" name="Line 511"/>
            <p:cNvSpPr/>
            <p:nvPr/>
          </p:nvSpPr>
          <p:spPr>
            <a:xfrm flipV="1">
              <a:off x="5481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1" name="Line 512"/>
            <p:cNvSpPr/>
            <p:nvPr/>
          </p:nvSpPr>
          <p:spPr>
            <a:xfrm flipV="1">
              <a:off x="55332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2" name="Line 513"/>
            <p:cNvSpPr/>
            <p:nvPr/>
          </p:nvSpPr>
          <p:spPr>
            <a:xfrm flipV="1">
              <a:off x="55854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3" name="Line 514"/>
            <p:cNvSpPr/>
            <p:nvPr/>
          </p:nvSpPr>
          <p:spPr>
            <a:xfrm flipV="1">
              <a:off x="56372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4" name="Line 515"/>
            <p:cNvSpPr/>
            <p:nvPr/>
          </p:nvSpPr>
          <p:spPr>
            <a:xfrm flipV="1">
              <a:off x="56894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5" name="Line 516"/>
            <p:cNvSpPr/>
            <p:nvPr/>
          </p:nvSpPr>
          <p:spPr>
            <a:xfrm flipV="1">
              <a:off x="57416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6" name="Line 517"/>
            <p:cNvSpPr/>
            <p:nvPr/>
          </p:nvSpPr>
          <p:spPr>
            <a:xfrm flipV="1">
              <a:off x="57938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7" name="Line 518"/>
            <p:cNvSpPr/>
            <p:nvPr/>
          </p:nvSpPr>
          <p:spPr>
            <a:xfrm flipV="1">
              <a:off x="584748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8" name="Line 519"/>
            <p:cNvSpPr/>
            <p:nvPr/>
          </p:nvSpPr>
          <p:spPr>
            <a:xfrm flipV="1">
              <a:off x="58993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9" name="Line 520"/>
            <p:cNvSpPr/>
            <p:nvPr/>
          </p:nvSpPr>
          <p:spPr>
            <a:xfrm flipV="1">
              <a:off x="59515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0" name="Line 521"/>
            <p:cNvSpPr/>
            <p:nvPr/>
          </p:nvSpPr>
          <p:spPr>
            <a:xfrm flipV="1">
              <a:off x="60037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1" name="Line 522"/>
            <p:cNvSpPr/>
            <p:nvPr/>
          </p:nvSpPr>
          <p:spPr>
            <a:xfrm flipV="1">
              <a:off x="605592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2" name="Line 523"/>
            <p:cNvSpPr/>
            <p:nvPr/>
          </p:nvSpPr>
          <p:spPr>
            <a:xfrm flipV="1">
              <a:off x="61077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3" name="Line 524"/>
            <p:cNvSpPr/>
            <p:nvPr/>
          </p:nvSpPr>
          <p:spPr>
            <a:xfrm flipV="1">
              <a:off x="615996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4" name="Line 525"/>
            <p:cNvSpPr/>
            <p:nvPr/>
          </p:nvSpPr>
          <p:spPr>
            <a:xfrm flipV="1">
              <a:off x="62136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5" name="Line 526"/>
            <p:cNvSpPr/>
            <p:nvPr/>
          </p:nvSpPr>
          <p:spPr>
            <a:xfrm flipV="1">
              <a:off x="62658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6" name="Line 527"/>
            <p:cNvSpPr/>
            <p:nvPr/>
          </p:nvSpPr>
          <p:spPr>
            <a:xfrm flipV="1">
              <a:off x="631800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7" name="Line 528"/>
            <p:cNvSpPr/>
            <p:nvPr/>
          </p:nvSpPr>
          <p:spPr>
            <a:xfrm flipV="1">
              <a:off x="63698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8" name="Line 529"/>
            <p:cNvSpPr/>
            <p:nvPr/>
          </p:nvSpPr>
          <p:spPr>
            <a:xfrm flipV="1">
              <a:off x="64220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9" name="Line 530"/>
            <p:cNvSpPr/>
            <p:nvPr/>
          </p:nvSpPr>
          <p:spPr>
            <a:xfrm flipV="1">
              <a:off x="6474240" y="861588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0" name="Rectangle 531"/>
            <p:cNvSpPr/>
            <p:nvPr/>
          </p:nvSpPr>
          <p:spPr>
            <a:xfrm>
              <a:off x="1232280" y="86767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1" name="Rectangle 532"/>
            <p:cNvSpPr/>
            <p:nvPr/>
          </p:nvSpPr>
          <p:spPr>
            <a:xfrm>
              <a:off x="1494360" y="86767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2" name="Rectangle 533"/>
            <p:cNvSpPr/>
            <p:nvPr/>
          </p:nvSpPr>
          <p:spPr>
            <a:xfrm>
              <a:off x="1756440" y="86767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3" name="Rectangle 534"/>
            <p:cNvSpPr/>
            <p:nvPr/>
          </p:nvSpPr>
          <p:spPr>
            <a:xfrm>
              <a:off x="197172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4" name="Rectangle 535"/>
            <p:cNvSpPr/>
            <p:nvPr/>
          </p:nvSpPr>
          <p:spPr>
            <a:xfrm>
              <a:off x="223380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5" name="Rectangle 536"/>
            <p:cNvSpPr/>
            <p:nvPr/>
          </p:nvSpPr>
          <p:spPr>
            <a:xfrm>
              <a:off x="249588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6" name="Rectangle 537"/>
            <p:cNvSpPr/>
            <p:nvPr/>
          </p:nvSpPr>
          <p:spPr>
            <a:xfrm>
              <a:off x="275652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7" name="Rectangle 538"/>
            <p:cNvSpPr/>
            <p:nvPr/>
          </p:nvSpPr>
          <p:spPr>
            <a:xfrm>
              <a:off x="301788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8" name="Rectangle 539"/>
            <p:cNvSpPr/>
            <p:nvPr/>
          </p:nvSpPr>
          <p:spPr>
            <a:xfrm>
              <a:off x="327996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9" name="Rectangle 540"/>
            <p:cNvSpPr/>
            <p:nvPr/>
          </p:nvSpPr>
          <p:spPr>
            <a:xfrm>
              <a:off x="354204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0" name="Rectangle 541"/>
            <p:cNvSpPr/>
            <p:nvPr/>
          </p:nvSpPr>
          <p:spPr>
            <a:xfrm>
              <a:off x="380232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1" name="Rectangle 542"/>
            <p:cNvSpPr/>
            <p:nvPr/>
          </p:nvSpPr>
          <p:spPr>
            <a:xfrm>
              <a:off x="406512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2" name="Rectangle 543"/>
            <p:cNvSpPr/>
            <p:nvPr/>
          </p:nvSpPr>
          <p:spPr>
            <a:xfrm>
              <a:off x="432720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2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3" name="Rectangle 544"/>
            <p:cNvSpPr/>
            <p:nvPr/>
          </p:nvSpPr>
          <p:spPr>
            <a:xfrm>
              <a:off x="458784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4" name="Rectangle 545"/>
            <p:cNvSpPr/>
            <p:nvPr/>
          </p:nvSpPr>
          <p:spPr>
            <a:xfrm>
              <a:off x="484992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5" name="Rectangle 546"/>
            <p:cNvSpPr/>
            <p:nvPr/>
          </p:nvSpPr>
          <p:spPr>
            <a:xfrm>
              <a:off x="511200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6" name="Rectangle 547"/>
            <p:cNvSpPr/>
            <p:nvPr/>
          </p:nvSpPr>
          <p:spPr>
            <a:xfrm>
              <a:off x="537408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7" name="Rectangle 548"/>
            <p:cNvSpPr/>
            <p:nvPr/>
          </p:nvSpPr>
          <p:spPr>
            <a:xfrm>
              <a:off x="563436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3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8" name="Rectangle 549"/>
            <p:cNvSpPr/>
            <p:nvPr/>
          </p:nvSpPr>
          <p:spPr>
            <a:xfrm>
              <a:off x="5896440" y="8676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9" name="Rectangle 550"/>
            <p:cNvSpPr/>
            <p:nvPr/>
          </p:nvSpPr>
          <p:spPr>
            <a:xfrm>
              <a:off x="6158520" y="86752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0" name="Line 551"/>
            <p:cNvSpPr/>
            <p:nvPr/>
          </p:nvSpPr>
          <p:spPr>
            <a:xfrm flipV="1">
              <a:off x="129420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1" name="Line 552"/>
            <p:cNvSpPr/>
            <p:nvPr/>
          </p:nvSpPr>
          <p:spPr>
            <a:xfrm flipV="1">
              <a:off x="155628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2" name="Line 553"/>
            <p:cNvSpPr/>
            <p:nvPr/>
          </p:nvSpPr>
          <p:spPr>
            <a:xfrm flipV="1">
              <a:off x="181836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3" name="Line 554"/>
            <p:cNvSpPr/>
            <p:nvPr/>
          </p:nvSpPr>
          <p:spPr>
            <a:xfrm flipV="1">
              <a:off x="207900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4" name="Line 555"/>
            <p:cNvSpPr/>
            <p:nvPr/>
          </p:nvSpPr>
          <p:spPr>
            <a:xfrm flipV="1">
              <a:off x="234108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5" name="Line 556"/>
            <p:cNvSpPr/>
            <p:nvPr/>
          </p:nvSpPr>
          <p:spPr>
            <a:xfrm flipV="1">
              <a:off x="260316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6" name="Line 557"/>
            <p:cNvSpPr/>
            <p:nvPr/>
          </p:nvSpPr>
          <p:spPr>
            <a:xfrm flipV="1">
              <a:off x="286344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7" name="Line 558"/>
            <p:cNvSpPr/>
            <p:nvPr/>
          </p:nvSpPr>
          <p:spPr>
            <a:xfrm flipV="1">
              <a:off x="312552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8" name="Line 559"/>
            <p:cNvSpPr/>
            <p:nvPr/>
          </p:nvSpPr>
          <p:spPr>
            <a:xfrm flipV="1">
              <a:off x="338760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9" name="Line 560"/>
            <p:cNvSpPr/>
            <p:nvPr/>
          </p:nvSpPr>
          <p:spPr>
            <a:xfrm flipV="1">
              <a:off x="364968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0" name="Line 561"/>
            <p:cNvSpPr/>
            <p:nvPr/>
          </p:nvSpPr>
          <p:spPr>
            <a:xfrm flipV="1">
              <a:off x="391032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1" name="Line 562"/>
            <p:cNvSpPr/>
            <p:nvPr/>
          </p:nvSpPr>
          <p:spPr>
            <a:xfrm flipV="1">
              <a:off x="417240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2" name="Line 563"/>
            <p:cNvSpPr/>
            <p:nvPr/>
          </p:nvSpPr>
          <p:spPr>
            <a:xfrm flipV="1">
              <a:off x="443448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3" name="Line 564"/>
            <p:cNvSpPr/>
            <p:nvPr/>
          </p:nvSpPr>
          <p:spPr>
            <a:xfrm flipV="1">
              <a:off x="469476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4" name="Line 565"/>
            <p:cNvSpPr/>
            <p:nvPr/>
          </p:nvSpPr>
          <p:spPr>
            <a:xfrm flipV="1">
              <a:off x="495684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5" name="Line 566"/>
            <p:cNvSpPr/>
            <p:nvPr/>
          </p:nvSpPr>
          <p:spPr>
            <a:xfrm flipV="1">
              <a:off x="521892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6" name="Line 567"/>
            <p:cNvSpPr/>
            <p:nvPr/>
          </p:nvSpPr>
          <p:spPr>
            <a:xfrm flipV="1">
              <a:off x="548100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7" name="Line 568"/>
            <p:cNvSpPr/>
            <p:nvPr/>
          </p:nvSpPr>
          <p:spPr>
            <a:xfrm flipV="1">
              <a:off x="574164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8" name="Line 569"/>
            <p:cNvSpPr/>
            <p:nvPr/>
          </p:nvSpPr>
          <p:spPr>
            <a:xfrm flipV="1">
              <a:off x="600372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9" name="Line 570"/>
            <p:cNvSpPr/>
            <p:nvPr/>
          </p:nvSpPr>
          <p:spPr>
            <a:xfrm flipV="1">
              <a:off x="6265800" y="86158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0" name="Line 571"/>
            <p:cNvSpPr/>
            <p:nvPr/>
          </p:nvSpPr>
          <p:spPr>
            <a:xfrm flipV="1">
              <a:off x="1142640" y="6489360"/>
              <a:ext cx="0" cy="212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1" name="Line 572"/>
            <p:cNvSpPr/>
            <p:nvPr/>
          </p:nvSpPr>
          <p:spPr>
            <a:xfrm>
              <a:off x="1133280" y="86162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2" name="Line 573"/>
            <p:cNvSpPr/>
            <p:nvPr/>
          </p:nvSpPr>
          <p:spPr>
            <a:xfrm>
              <a:off x="1133280" y="85834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3" name="Line 574"/>
            <p:cNvSpPr/>
            <p:nvPr/>
          </p:nvSpPr>
          <p:spPr>
            <a:xfrm>
              <a:off x="1133280" y="85492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4" name="Line 575"/>
            <p:cNvSpPr/>
            <p:nvPr/>
          </p:nvSpPr>
          <p:spPr>
            <a:xfrm>
              <a:off x="1133280" y="85150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5" name="Line 576"/>
            <p:cNvSpPr/>
            <p:nvPr/>
          </p:nvSpPr>
          <p:spPr>
            <a:xfrm>
              <a:off x="1133280" y="84808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6" name="Line 577"/>
            <p:cNvSpPr/>
            <p:nvPr/>
          </p:nvSpPr>
          <p:spPr>
            <a:xfrm>
              <a:off x="1133280" y="84466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7" name="Line 578"/>
            <p:cNvSpPr/>
            <p:nvPr/>
          </p:nvSpPr>
          <p:spPr>
            <a:xfrm>
              <a:off x="1133280" y="84124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8" name="Line 579"/>
            <p:cNvSpPr/>
            <p:nvPr/>
          </p:nvSpPr>
          <p:spPr>
            <a:xfrm>
              <a:off x="1133280" y="83782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9" name="Line 580"/>
            <p:cNvSpPr/>
            <p:nvPr/>
          </p:nvSpPr>
          <p:spPr>
            <a:xfrm>
              <a:off x="1133280" y="83440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0" name="Line 581"/>
            <p:cNvSpPr/>
            <p:nvPr/>
          </p:nvSpPr>
          <p:spPr>
            <a:xfrm>
              <a:off x="1133280" y="83098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1" name="Line 582"/>
            <p:cNvSpPr/>
            <p:nvPr/>
          </p:nvSpPr>
          <p:spPr>
            <a:xfrm>
              <a:off x="1133280" y="82756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2" name="Line 583"/>
            <p:cNvSpPr/>
            <p:nvPr/>
          </p:nvSpPr>
          <p:spPr>
            <a:xfrm>
              <a:off x="1133280" y="82414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3" name="Line 584"/>
            <p:cNvSpPr/>
            <p:nvPr/>
          </p:nvSpPr>
          <p:spPr>
            <a:xfrm>
              <a:off x="1133280" y="82072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4" name="Line 585"/>
            <p:cNvSpPr/>
            <p:nvPr/>
          </p:nvSpPr>
          <p:spPr>
            <a:xfrm>
              <a:off x="1133280" y="81745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5" name="Line 586"/>
            <p:cNvSpPr/>
            <p:nvPr/>
          </p:nvSpPr>
          <p:spPr>
            <a:xfrm>
              <a:off x="1133280" y="81403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6" name="Line 587"/>
            <p:cNvSpPr/>
            <p:nvPr/>
          </p:nvSpPr>
          <p:spPr>
            <a:xfrm>
              <a:off x="1133280" y="81061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7" name="Line 588"/>
            <p:cNvSpPr/>
            <p:nvPr/>
          </p:nvSpPr>
          <p:spPr>
            <a:xfrm>
              <a:off x="1133280" y="80719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8" name="Line 589"/>
            <p:cNvSpPr/>
            <p:nvPr/>
          </p:nvSpPr>
          <p:spPr>
            <a:xfrm>
              <a:off x="1133280" y="80377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9" name="Line 590"/>
            <p:cNvSpPr/>
            <p:nvPr/>
          </p:nvSpPr>
          <p:spPr>
            <a:xfrm>
              <a:off x="1133280" y="80035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0" name="Line 591"/>
            <p:cNvSpPr/>
            <p:nvPr/>
          </p:nvSpPr>
          <p:spPr>
            <a:xfrm>
              <a:off x="1133280" y="79693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1" name="Line 592"/>
            <p:cNvSpPr/>
            <p:nvPr/>
          </p:nvSpPr>
          <p:spPr>
            <a:xfrm>
              <a:off x="1133280" y="79351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2" name="Line 593"/>
            <p:cNvSpPr/>
            <p:nvPr/>
          </p:nvSpPr>
          <p:spPr>
            <a:xfrm>
              <a:off x="1133280" y="79009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3" name="Line 594"/>
            <p:cNvSpPr/>
            <p:nvPr/>
          </p:nvSpPr>
          <p:spPr>
            <a:xfrm>
              <a:off x="1133280" y="78667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4" name="Line 595"/>
            <p:cNvSpPr/>
            <p:nvPr/>
          </p:nvSpPr>
          <p:spPr>
            <a:xfrm>
              <a:off x="1133280" y="783252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5" name="Line 596"/>
            <p:cNvSpPr/>
            <p:nvPr/>
          </p:nvSpPr>
          <p:spPr>
            <a:xfrm>
              <a:off x="1133280" y="77997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6" name="Line 597"/>
            <p:cNvSpPr/>
            <p:nvPr/>
          </p:nvSpPr>
          <p:spPr>
            <a:xfrm>
              <a:off x="1133280" y="77655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7" name="Line 598"/>
            <p:cNvSpPr/>
            <p:nvPr/>
          </p:nvSpPr>
          <p:spPr>
            <a:xfrm>
              <a:off x="1133280" y="77313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8" name="Line 599"/>
            <p:cNvSpPr/>
            <p:nvPr/>
          </p:nvSpPr>
          <p:spPr>
            <a:xfrm>
              <a:off x="1133280" y="76971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9" name="Line 600"/>
            <p:cNvSpPr/>
            <p:nvPr/>
          </p:nvSpPr>
          <p:spPr>
            <a:xfrm>
              <a:off x="1133280" y="76629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0" name="Line 601"/>
            <p:cNvSpPr/>
            <p:nvPr/>
          </p:nvSpPr>
          <p:spPr>
            <a:xfrm>
              <a:off x="1133280" y="76287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1" name="Line 602"/>
            <p:cNvSpPr/>
            <p:nvPr/>
          </p:nvSpPr>
          <p:spPr>
            <a:xfrm>
              <a:off x="1133280" y="75945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2" name="Line 603"/>
            <p:cNvSpPr/>
            <p:nvPr/>
          </p:nvSpPr>
          <p:spPr>
            <a:xfrm>
              <a:off x="1133280" y="75603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3" name="Line 604"/>
            <p:cNvSpPr/>
            <p:nvPr/>
          </p:nvSpPr>
          <p:spPr>
            <a:xfrm>
              <a:off x="1133280" y="75261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4" name="Line 605"/>
            <p:cNvSpPr/>
            <p:nvPr/>
          </p:nvSpPr>
          <p:spPr>
            <a:xfrm>
              <a:off x="1133280" y="74919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5" name="Line 606"/>
            <p:cNvSpPr/>
            <p:nvPr/>
          </p:nvSpPr>
          <p:spPr>
            <a:xfrm>
              <a:off x="1133280" y="74577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6" name="Line 607"/>
            <p:cNvSpPr/>
            <p:nvPr/>
          </p:nvSpPr>
          <p:spPr>
            <a:xfrm>
              <a:off x="1133280" y="742356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7" name="Line 608"/>
            <p:cNvSpPr/>
            <p:nvPr/>
          </p:nvSpPr>
          <p:spPr>
            <a:xfrm>
              <a:off x="1133280" y="73908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8" name="Line 609"/>
            <p:cNvSpPr/>
            <p:nvPr/>
          </p:nvSpPr>
          <p:spPr>
            <a:xfrm>
              <a:off x="1133280" y="73566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9" name="Line 610"/>
            <p:cNvSpPr/>
            <p:nvPr/>
          </p:nvSpPr>
          <p:spPr>
            <a:xfrm>
              <a:off x="1133280" y="73224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0" name="Line 611"/>
            <p:cNvSpPr/>
            <p:nvPr/>
          </p:nvSpPr>
          <p:spPr>
            <a:xfrm>
              <a:off x="1133280" y="72882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1" name="Line 612"/>
            <p:cNvSpPr/>
            <p:nvPr/>
          </p:nvSpPr>
          <p:spPr>
            <a:xfrm>
              <a:off x="1133280" y="72540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2" name="Line 613"/>
            <p:cNvSpPr/>
            <p:nvPr/>
          </p:nvSpPr>
          <p:spPr>
            <a:xfrm>
              <a:off x="1133280" y="72198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3" name="Line 614"/>
            <p:cNvSpPr/>
            <p:nvPr/>
          </p:nvSpPr>
          <p:spPr>
            <a:xfrm>
              <a:off x="1133280" y="71856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4" name="Line 615"/>
            <p:cNvSpPr/>
            <p:nvPr/>
          </p:nvSpPr>
          <p:spPr>
            <a:xfrm>
              <a:off x="1133280" y="71514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5" name="Line 616"/>
            <p:cNvSpPr/>
            <p:nvPr/>
          </p:nvSpPr>
          <p:spPr>
            <a:xfrm>
              <a:off x="1133280" y="71172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6" name="Line 617"/>
            <p:cNvSpPr/>
            <p:nvPr/>
          </p:nvSpPr>
          <p:spPr>
            <a:xfrm>
              <a:off x="1133280" y="70830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7" name="Line 618"/>
            <p:cNvSpPr/>
            <p:nvPr/>
          </p:nvSpPr>
          <p:spPr>
            <a:xfrm>
              <a:off x="1133280" y="70488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8" name="Line 619"/>
            <p:cNvSpPr/>
            <p:nvPr/>
          </p:nvSpPr>
          <p:spPr>
            <a:xfrm>
              <a:off x="1133280" y="701460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9" name="Line 620"/>
            <p:cNvSpPr/>
            <p:nvPr/>
          </p:nvSpPr>
          <p:spPr>
            <a:xfrm>
              <a:off x="1133280" y="69818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0" name="Line 621"/>
            <p:cNvSpPr/>
            <p:nvPr/>
          </p:nvSpPr>
          <p:spPr>
            <a:xfrm>
              <a:off x="1133280" y="69476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1" name="Line 622"/>
            <p:cNvSpPr/>
            <p:nvPr/>
          </p:nvSpPr>
          <p:spPr>
            <a:xfrm>
              <a:off x="1133280" y="69134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2" name="Line 623"/>
            <p:cNvSpPr/>
            <p:nvPr/>
          </p:nvSpPr>
          <p:spPr>
            <a:xfrm>
              <a:off x="1133280" y="68792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3" name="Line 624"/>
            <p:cNvSpPr/>
            <p:nvPr/>
          </p:nvSpPr>
          <p:spPr>
            <a:xfrm>
              <a:off x="1133280" y="68450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4" name="Line 625"/>
            <p:cNvSpPr/>
            <p:nvPr/>
          </p:nvSpPr>
          <p:spPr>
            <a:xfrm>
              <a:off x="1133280" y="68108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5" name="Line 626"/>
            <p:cNvSpPr/>
            <p:nvPr/>
          </p:nvSpPr>
          <p:spPr>
            <a:xfrm>
              <a:off x="1133280" y="67766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6" name="Line 627"/>
            <p:cNvSpPr/>
            <p:nvPr/>
          </p:nvSpPr>
          <p:spPr>
            <a:xfrm>
              <a:off x="1133280" y="67424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7" name="Line 628"/>
            <p:cNvSpPr/>
            <p:nvPr/>
          </p:nvSpPr>
          <p:spPr>
            <a:xfrm>
              <a:off x="1133280" y="67082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8" name="Line 629"/>
            <p:cNvSpPr/>
            <p:nvPr/>
          </p:nvSpPr>
          <p:spPr>
            <a:xfrm>
              <a:off x="1133280" y="66740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9" name="Line 630"/>
            <p:cNvSpPr/>
            <p:nvPr/>
          </p:nvSpPr>
          <p:spPr>
            <a:xfrm>
              <a:off x="1133280" y="66398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0" name="Line 631"/>
            <p:cNvSpPr/>
            <p:nvPr/>
          </p:nvSpPr>
          <p:spPr>
            <a:xfrm>
              <a:off x="1133280" y="660564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1" name="Line 632"/>
            <p:cNvSpPr/>
            <p:nvPr/>
          </p:nvSpPr>
          <p:spPr>
            <a:xfrm>
              <a:off x="1133280" y="65728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2" name="Line 633"/>
            <p:cNvSpPr/>
            <p:nvPr/>
          </p:nvSpPr>
          <p:spPr>
            <a:xfrm>
              <a:off x="1133280" y="65386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3" name="Line 634"/>
            <p:cNvSpPr/>
            <p:nvPr/>
          </p:nvSpPr>
          <p:spPr>
            <a:xfrm>
              <a:off x="1133280" y="6504480"/>
              <a:ext cx="9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4" name="Line 635"/>
            <p:cNvSpPr/>
            <p:nvPr/>
          </p:nvSpPr>
          <p:spPr>
            <a:xfrm>
              <a:off x="1123560" y="861624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5" name="Line 636"/>
            <p:cNvSpPr/>
            <p:nvPr/>
          </p:nvSpPr>
          <p:spPr>
            <a:xfrm>
              <a:off x="1123560" y="844668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6" name="Line 637"/>
            <p:cNvSpPr/>
            <p:nvPr/>
          </p:nvSpPr>
          <p:spPr>
            <a:xfrm>
              <a:off x="1123560" y="827568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7" name="Line 638"/>
            <p:cNvSpPr/>
            <p:nvPr/>
          </p:nvSpPr>
          <p:spPr>
            <a:xfrm>
              <a:off x="1123560" y="810612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8" name="Line 639"/>
            <p:cNvSpPr/>
            <p:nvPr/>
          </p:nvSpPr>
          <p:spPr>
            <a:xfrm>
              <a:off x="1123560" y="793512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9" name="Line 640"/>
            <p:cNvSpPr/>
            <p:nvPr/>
          </p:nvSpPr>
          <p:spPr>
            <a:xfrm>
              <a:off x="1123560" y="776556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0" name="Line 641"/>
            <p:cNvSpPr/>
            <p:nvPr/>
          </p:nvSpPr>
          <p:spPr>
            <a:xfrm>
              <a:off x="1123560" y="759456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1" name="Line 642"/>
            <p:cNvSpPr/>
            <p:nvPr/>
          </p:nvSpPr>
          <p:spPr>
            <a:xfrm>
              <a:off x="1123560" y="742356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2" name="Line 643"/>
            <p:cNvSpPr/>
            <p:nvPr/>
          </p:nvSpPr>
          <p:spPr>
            <a:xfrm>
              <a:off x="1123560" y="725400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3" name="Line 644"/>
            <p:cNvSpPr/>
            <p:nvPr/>
          </p:nvSpPr>
          <p:spPr>
            <a:xfrm>
              <a:off x="1123560" y="708300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4" name="Line 645"/>
            <p:cNvSpPr/>
            <p:nvPr/>
          </p:nvSpPr>
          <p:spPr>
            <a:xfrm>
              <a:off x="1123560" y="691344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5" name="Line 646"/>
            <p:cNvSpPr/>
            <p:nvPr/>
          </p:nvSpPr>
          <p:spPr>
            <a:xfrm>
              <a:off x="1123560" y="674244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6" name="Line 647"/>
            <p:cNvSpPr/>
            <p:nvPr/>
          </p:nvSpPr>
          <p:spPr>
            <a:xfrm>
              <a:off x="1123560" y="657288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7" name="Line 648"/>
            <p:cNvSpPr/>
            <p:nvPr/>
          </p:nvSpPr>
          <p:spPr>
            <a:xfrm>
              <a:off x="1308600" y="8524800"/>
              <a:ext cx="0" cy="9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8" name="Line 649"/>
            <p:cNvSpPr/>
            <p:nvPr/>
          </p:nvSpPr>
          <p:spPr>
            <a:xfrm>
              <a:off x="1322640" y="8546760"/>
              <a:ext cx="0" cy="69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9" name="Line 650"/>
            <p:cNvSpPr/>
            <p:nvPr/>
          </p:nvSpPr>
          <p:spPr>
            <a:xfrm>
              <a:off x="1335240" y="8435880"/>
              <a:ext cx="0" cy="180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0" name="Line 651"/>
            <p:cNvSpPr/>
            <p:nvPr/>
          </p:nvSpPr>
          <p:spPr>
            <a:xfrm>
              <a:off x="1347840" y="8345520"/>
              <a:ext cx="0" cy="270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1" name="Line 652"/>
            <p:cNvSpPr/>
            <p:nvPr/>
          </p:nvSpPr>
          <p:spPr>
            <a:xfrm>
              <a:off x="1360440" y="8062560"/>
              <a:ext cx="0" cy="553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2" name="Line 653"/>
            <p:cNvSpPr/>
            <p:nvPr/>
          </p:nvSpPr>
          <p:spPr>
            <a:xfrm>
              <a:off x="1374840" y="8602560"/>
              <a:ext cx="0" cy="13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3" name="Line 654"/>
            <p:cNvSpPr/>
            <p:nvPr/>
          </p:nvSpPr>
          <p:spPr>
            <a:xfrm>
              <a:off x="1387440" y="8602560"/>
              <a:ext cx="0" cy="13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4" name="Line 655"/>
            <p:cNvSpPr/>
            <p:nvPr/>
          </p:nvSpPr>
          <p:spPr>
            <a:xfrm>
              <a:off x="14252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5" name="Line 656"/>
            <p:cNvSpPr/>
            <p:nvPr/>
          </p:nvSpPr>
          <p:spPr>
            <a:xfrm>
              <a:off x="14378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6" name="Line 657"/>
            <p:cNvSpPr/>
            <p:nvPr/>
          </p:nvSpPr>
          <p:spPr>
            <a:xfrm>
              <a:off x="14522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7" name="Line 658"/>
            <p:cNvSpPr/>
            <p:nvPr/>
          </p:nvSpPr>
          <p:spPr>
            <a:xfrm>
              <a:off x="1466280" y="8594640"/>
              <a:ext cx="0" cy="21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8" name="Line 659"/>
            <p:cNvSpPr/>
            <p:nvPr/>
          </p:nvSpPr>
          <p:spPr>
            <a:xfrm>
              <a:off x="1478880" y="86083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9" name="Line 660"/>
            <p:cNvSpPr/>
            <p:nvPr/>
          </p:nvSpPr>
          <p:spPr>
            <a:xfrm>
              <a:off x="1491480" y="8561520"/>
              <a:ext cx="0" cy="54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560" bIns="7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0" name="Line 661"/>
            <p:cNvSpPr/>
            <p:nvPr/>
          </p:nvSpPr>
          <p:spPr>
            <a:xfrm>
              <a:off x="1505880" y="8499960"/>
              <a:ext cx="0" cy="115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1" name="Line 662"/>
            <p:cNvSpPr/>
            <p:nvPr/>
          </p:nvSpPr>
          <p:spPr>
            <a:xfrm>
              <a:off x="1518480" y="8572680"/>
              <a:ext cx="0" cy="43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2" name="Line 663"/>
            <p:cNvSpPr/>
            <p:nvPr/>
          </p:nvSpPr>
          <p:spPr>
            <a:xfrm>
              <a:off x="1531080" y="857808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3" name="Line 664"/>
            <p:cNvSpPr/>
            <p:nvPr/>
          </p:nvSpPr>
          <p:spPr>
            <a:xfrm>
              <a:off x="1543680" y="8415360"/>
              <a:ext cx="0" cy="20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4" name="Line 665"/>
            <p:cNvSpPr/>
            <p:nvPr/>
          </p:nvSpPr>
          <p:spPr>
            <a:xfrm>
              <a:off x="1556280" y="860688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5" name="Line 666"/>
            <p:cNvSpPr/>
            <p:nvPr/>
          </p:nvSpPr>
          <p:spPr>
            <a:xfrm>
              <a:off x="157068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6" name="Line 667"/>
            <p:cNvSpPr/>
            <p:nvPr/>
          </p:nvSpPr>
          <p:spPr>
            <a:xfrm>
              <a:off x="162252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7" name="Line 668"/>
            <p:cNvSpPr/>
            <p:nvPr/>
          </p:nvSpPr>
          <p:spPr>
            <a:xfrm>
              <a:off x="16351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8" name="Line 669"/>
            <p:cNvSpPr/>
            <p:nvPr/>
          </p:nvSpPr>
          <p:spPr>
            <a:xfrm>
              <a:off x="1647720" y="860688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9" name="Line 670"/>
            <p:cNvSpPr/>
            <p:nvPr/>
          </p:nvSpPr>
          <p:spPr>
            <a:xfrm>
              <a:off x="1662120" y="8567280"/>
              <a:ext cx="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0" name="Line 671"/>
            <p:cNvSpPr/>
            <p:nvPr/>
          </p:nvSpPr>
          <p:spPr>
            <a:xfrm>
              <a:off x="1673280" y="857952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1" name="Line 672"/>
            <p:cNvSpPr/>
            <p:nvPr/>
          </p:nvSpPr>
          <p:spPr>
            <a:xfrm>
              <a:off x="1687320" y="857952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2" name="Line 673"/>
            <p:cNvSpPr/>
            <p:nvPr/>
          </p:nvSpPr>
          <p:spPr>
            <a:xfrm>
              <a:off x="1701720" y="8088480"/>
              <a:ext cx="0" cy="527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3" name="Line 674"/>
            <p:cNvSpPr/>
            <p:nvPr/>
          </p:nvSpPr>
          <p:spPr>
            <a:xfrm>
              <a:off x="1714320" y="8350920"/>
              <a:ext cx="0" cy="265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4" name="Line 675"/>
            <p:cNvSpPr/>
            <p:nvPr/>
          </p:nvSpPr>
          <p:spPr>
            <a:xfrm>
              <a:off x="1726920" y="8547840"/>
              <a:ext cx="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5" name="Line 676"/>
            <p:cNvSpPr/>
            <p:nvPr/>
          </p:nvSpPr>
          <p:spPr>
            <a:xfrm>
              <a:off x="1740960" y="8562960"/>
              <a:ext cx="0" cy="53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6" name="Line 677"/>
            <p:cNvSpPr/>
            <p:nvPr/>
          </p:nvSpPr>
          <p:spPr>
            <a:xfrm>
              <a:off x="1753560" y="8539920"/>
              <a:ext cx="0" cy="76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7" name="Line 678"/>
            <p:cNvSpPr/>
            <p:nvPr/>
          </p:nvSpPr>
          <p:spPr>
            <a:xfrm>
              <a:off x="176616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8" name="Line 679"/>
            <p:cNvSpPr/>
            <p:nvPr/>
          </p:nvSpPr>
          <p:spPr>
            <a:xfrm>
              <a:off x="177876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9" name="Line 680"/>
            <p:cNvSpPr/>
            <p:nvPr/>
          </p:nvSpPr>
          <p:spPr>
            <a:xfrm>
              <a:off x="17913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0" name="Line 681"/>
            <p:cNvSpPr/>
            <p:nvPr/>
          </p:nvSpPr>
          <p:spPr>
            <a:xfrm>
              <a:off x="180252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1" name="Line 682"/>
            <p:cNvSpPr/>
            <p:nvPr/>
          </p:nvSpPr>
          <p:spPr>
            <a:xfrm>
              <a:off x="18183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2" name="Line 683"/>
            <p:cNvSpPr/>
            <p:nvPr/>
          </p:nvSpPr>
          <p:spPr>
            <a:xfrm>
              <a:off x="1832760" y="859716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3" name="Line 684"/>
            <p:cNvSpPr/>
            <p:nvPr/>
          </p:nvSpPr>
          <p:spPr>
            <a:xfrm>
              <a:off x="1845360" y="8594640"/>
              <a:ext cx="0" cy="21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4" name="Line 685"/>
            <p:cNvSpPr/>
            <p:nvPr/>
          </p:nvSpPr>
          <p:spPr>
            <a:xfrm>
              <a:off x="1857960" y="8576640"/>
              <a:ext cx="0" cy="3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5" name="Line 686"/>
            <p:cNvSpPr/>
            <p:nvPr/>
          </p:nvSpPr>
          <p:spPr>
            <a:xfrm>
              <a:off x="1872000" y="8572680"/>
              <a:ext cx="0" cy="43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6" name="Line 687"/>
            <p:cNvSpPr/>
            <p:nvPr/>
          </p:nvSpPr>
          <p:spPr>
            <a:xfrm>
              <a:off x="1884600" y="8472600"/>
              <a:ext cx="0" cy="143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7" name="Line 688"/>
            <p:cNvSpPr/>
            <p:nvPr/>
          </p:nvSpPr>
          <p:spPr>
            <a:xfrm>
              <a:off x="1897200" y="8574120"/>
              <a:ext cx="0" cy="42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8" name="Line 689"/>
            <p:cNvSpPr/>
            <p:nvPr/>
          </p:nvSpPr>
          <p:spPr>
            <a:xfrm>
              <a:off x="1909800" y="7659000"/>
              <a:ext cx="0" cy="957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9" name="Line 690"/>
            <p:cNvSpPr/>
            <p:nvPr/>
          </p:nvSpPr>
          <p:spPr>
            <a:xfrm>
              <a:off x="1924200" y="8323560"/>
              <a:ext cx="0" cy="292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0" name="Line 691"/>
            <p:cNvSpPr/>
            <p:nvPr/>
          </p:nvSpPr>
          <p:spPr>
            <a:xfrm>
              <a:off x="1936800" y="8337240"/>
              <a:ext cx="0" cy="279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1" name="Line 692"/>
            <p:cNvSpPr/>
            <p:nvPr/>
          </p:nvSpPr>
          <p:spPr>
            <a:xfrm>
              <a:off x="1947960" y="860544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2" name="Line 693"/>
            <p:cNvSpPr/>
            <p:nvPr/>
          </p:nvSpPr>
          <p:spPr>
            <a:xfrm>
              <a:off x="196200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3" name="Line 694"/>
            <p:cNvSpPr/>
            <p:nvPr/>
          </p:nvSpPr>
          <p:spPr>
            <a:xfrm>
              <a:off x="19764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4" name="Line 695"/>
            <p:cNvSpPr/>
            <p:nvPr/>
          </p:nvSpPr>
          <p:spPr>
            <a:xfrm>
              <a:off x="198900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5" name="Line 696"/>
            <p:cNvSpPr/>
            <p:nvPr/>
          </p:nvSpPr>
          <p:spPr>
            <a:xfrm>
              <a:off x="2001600" y="8502840"/>
              <a:ext cx="0" cy="11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6" name="Line 697"/>
            <p:cNvSpPr/>
            <p:nvPr/>
          </p:nvSpPr>
          <p:spPr>
            <a:xfrm>
              <a:off x="2015640" y="8575200"/>
              <a:ext cx="0" cy="40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7" name="Line 698"/>
            <p:cNvSpPr/>
            <p:nvPr/>
          </p:nvSpPr>
          <p:spPr>
            <a:xfrm>
              <a:off x="2028240" y="858888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8" name="Line 699"/>
            <p:cNvSpPr/>
            <p:nvPr/>
          </p:nvSpPr>
          <p:spPr>
            <a:xfrm>
              <a:off x="2040840" y="858636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9" name="Line 700"/>
            <p:cNvSpPr/>
            <p:nvPr/>
          </p:nvSpPr>
          <p:spPr>
            <a:xfrm>
              <a:off x="2055240" y="8167680"/>
              <a:ext cx="0" cy="448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0" name="Line 701"/>
            <p:cNvSpPr/>
            <p:nvPr/>
          </p:nvSpPr>
          <p:spPr>
            <a:xfrm>
              <a:off x="2067840" y="8533080"/>
              <a:ext cx="0" cy="83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1" name="Line 702"/>
            <p:cNvSpPr/>
            <p:nvPr/>
          </p:nvSpPr>
          <p:spPr>
            <a:xfrm>
              <a:off x="2080440" y="8435880"/>
              <a:ext cx="0" cy="180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2" name="Line 703"/>
            <p:cNvSpPr/>
            <p:nvPr/>
          </p:nvSpPr>
          <p:spPr>
            <a:xfrm>
              <a:off x="2093040" y="8217000"/>
              <a:ext cx="0" cy="399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3" name="Line 704"/>
            <p:cNvSpPr/>
            <p:nvPr/>
          </p:nvSpPr>
          <p:spPr>
            <a:xfrm>
              <a:off x="2107440" y="8517960"/>
              <a:ext cx="0" cy="98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4" name="Line 705"/>
            <p:cNvSpPr/>
            <p:nvPr/>
          </p:nvSpPr>
          <p:spPr>
            <a:xfrm>
              <a:off x="2118240" y="8595720"/>
              <a:ext cx="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5" name="Line 706"/>
            <p:cNvSpPr/>
            <p:nvPr/>
          </p:nvSpPr>
          <p:spPr>
            <a:xfrm>
              <a:off x="21326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6" name="Line 707"/>
            <p:cNvSpPr/>
            <p:nvPr/>
          </p:nvSpPr>
          <p:spPr>
            <a:xfrm>
              <a:off x="214524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7" name="Line 708"/>
            <p:cNvSpPr/>
            <p:nvPr/>
          </p:nvSpPr>
          <p:spPr>
            <a:xfrm>
              <a:off x="21592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8" name="Line 709"/>
            <p:cNvSpPr/>
            <p:nvPr/>
          </p:nvSpPr>
          <p:spPr>
            <a:xfrm>
              <a:off x="21704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9" name="Line 710"/>
            <p:cNvSpPr/>
            <p:nvPr/>
          </p:nvSpPr>
          <p:spPr>
            <a:xfrm>
              <a:off x="2184480" y="8602560"/>
              <a:ext cx="0" cy="13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0" name="Line 711"/>
            <p:cNvSpPr/>
            <p:nvPr/>
          </p:nvSpPr>
          <p:spPr>
            <a:xfrm>
              <a:off x="2200320" y="86083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1" name="Line 712"/>
            <p:cNvSpPr/>
            <p:nvPr/>
          </p:nvSpPr>
          <p:spPr>
            <a:xfrm>
              <a:off x="2211480" y="85834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2" name="Line 713"/>
            <p:cNvSpPr/>
            <p:nvPr/>
          </p:nvSpPr>
          <p:spPr>
            <a:xfrm>
              <a:off x="2224080" y="8547840"/>
              <a:ext cx="0" cy="68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3" name="Line 714"/>
            <p:cNvSpPr/>
            <p:nvPr/>
          </p:nvSpPr>
          <p:spPr>
            <a:xfrm>
              <a:off x="2238480" y="8574120"/>
              <a:ext cx="0" cy="42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4" name="Line 715"/>
            <p:cNvSpPr/>
            <p:nvPr/>
          </p:nvSpPr>
          <p:spPr>
            <a:xfrm>
              <a:off x="2251080" y="8593200"/>
              <a:ext cx="0" cy="23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5" name="Line 716"/>
            <p:cNvSpPr/>
            <p:nvPr/>
          </p:nvSpPr>
          <p:spPr>
            <a:xfrm>
              <a:off x="2261880" y="8559000"/>
              <a:ext cx="0" cy="57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6" name="Line 717"/>
            <p:cNvSpPr/>
            <p:nvPr/>
          </p:nvSpPr>
          <p:spPr>
            <a:xfrm>
              <a:off x="2276280" y="8008920"/>
              <a:ext cx="0" cy="606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7" name="Line 718"/>
            <p:cNvSpPr/>
            <p:nvPr/>
          </p:nvSpPr>
          <p:spPr>
            <a:xfrm>
              <a:off x="2290320" y="8501400"/>
              <a:ext cx="0" cy="114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8" name="Line 719"/>
            <p:cNvSpPr/>
            <p:nvPr/>
          </p:nvSpPr>
          <p:spPr>
            <a:xfrm>
              <a:off x="2302920" y="8595720"/>
              <a:ext cx="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9" name="Line 720"/>
            <p:cNvSpPr/>
            <p:nvPr/>
          </p:nvSpPr>
          <p:spPr>
            <a:xfrm>
              <a:off x="23173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0" name="Line 721"/>
            <p:cNvSpPr/>
            <p:nvPr/>
          </p:nvSpPr>
          <p:spPr>
            <a:xfrm>
              <a:off x="232992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1" name="Line 722"/>
            <p:cNvSpPr/>
            <p:nvPr/>
          </p:nvSpPr>
          <p:spPr>
            <a:xfrm>
              <a:off x="23410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2" name="Line 723"/>
            <p:cNvSpPr/>
            <p:nvPr/>
          </p:nvSpPr>
          <p:spPr>
            <a:xfrm>
              <a:off x="235188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3" name="Line 724"/>
            <p:cNvSpPr/>
            <p:nvPr/>
          </p:nvSpPr>
          <p:spPr>
            <a:xfrm>
              <a:off x="2367720" y="85834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4" name="Line 725"/>
            <p:cNvSpPr/>
            <p:nvPr/>
          </p:nvSpPr>
          <p:spPr>
            <a:xfrm>
              <a:off x="2380320" y="859716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5" name="Line 726"/>
            <p:cNvSpPr/>
            <p:nvPr/>
          </p:nvSpPr>
          <p:spPr>
            <a:xfrm>
              <a:off x="2394720" y="8561520"/>
              <a:ext cx="0" cy="54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560" bIns="7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6" name="Line 727"/>
            <p:cNvSpPr/>
            <p:nvPr/>
          </p:nvSpPr>
          <p:spPr>
            <a:xfrm>
              <a:off x="2407320" y="8588880"/>
              <a:ext cx="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7" name="Line 728"/>
            <p:cNvSpPr/>
            <p:nvPr/>
          </p:nvSpPr>
          <p:spPr>
            <a:xfrm>
              <a:off x="2421360" y="8448120"/>
              <a:ext cx="0" cy="168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8" name="Line 729"/>
            <p:cNvSpPr/>
            <p:nvPr/>
          </p:nvSpPr>
          <p:spPr>
            <a:xfrm>
              <a:off x="2433960" y="8564400"/>
              <a:ext cx="0" cy="51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9" name="Line 730"/>
            <p:cNvSpPr/>
            <p:nvPr/>
          </p:nvSpPr>
          <p:spPr>
            <a:xfrm>
              <a:off x="2446560" y="8508240"/>
              <a:ext cx="0" cy="108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0" name="Line 731"/>
            <p:cNvSpPr/>
            <p:nvPr/>
          </p:nvSpPr>
          <p:spPr>
            <a:xfrm>
              <a:off x="2459520" y="6489360"/>
              <a:ext cx="0" cy="212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1" name="Line 732"/>
            <p:cNvSpPr/>
            <p:nvPr/>
          </p:nvSpPr>
          <p:spPr>
            <a:xfrm>
              <a:off x="2473560" y="8359200"/>
              <a:ext cx="0" cy="257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2" name="Line 733"/>
            <p:cNvSpPr/>
            <p:nvPr/>
          </p:nvSpPr>
          <p:spPr>
            <a:xfrm>
              <a:off x="2486160" y="858204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3" name="Line 734"/>
            <p:cNvSpPr/>
            <p:nvPr/>
          </p:nvSpPr>
          <p:spPr>
            <a:xfrm>
              <a:off x="24987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4" name="Line 735"/>
            <p:cNvSpPr/>
            <p:nvPr/>
          </p:nvSpPr>
          <p:spPr>
            <a:xfrm>
              <a:off x="2513160" y="8601480"/>
              <a:ext cx="0" cy="14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5" name="Line 736"/>
            <p:cNvSpPr/>
            <p:nvPr/>
          </p:nvSpPr>
          <p:spPr>
            <a:xfrm>
              <a:off x="252576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6" name="Line 737"/>
            <p:cNvSpPr/>
            <p:nvPr/>
          </p:nvSpPr>
          <p:spPr>
            <a:xfrm>
              <a:off x="25383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7" name="Line 738"/>
            <p:cNvSpPr/>
            <p:nvPr/>
          </p:nvSpPr>
          <p:spPr>
            <a:xfrm>
              <a:off x="25509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8" name="Line 739"/>
            <p:cNvSpPr/>
            <p:nvPr/>
          </p:nvSpPr>
          <p:spPr>
            <a:xfrm>
              <a:off x="25635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9" name="Line 740"/>
            <p:cNvSpPr/>
            <p:nvPr/>
          </p:nvSpPr>
          <p:spPr>
            <a:xfrm>
              <a:off x="2577600" y="859716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0" name="Line 741"/>
            <p:cNvSpPr/>
            <p:nvPr/>
          </p:nvSpPr>
          <p:spPr>
            <a:xfrm>
              <a:off x="2588760" y="8609400"/>
              <a:ext cx="0" cy="6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1" name="Line 742"/>
            <p:cNvSpPr/>
            <p:nvPr/>
          </p:nvSpPr>
          <p:spPr>
            <a:xfrm>
              <a:off x="2604600" y="858204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2" name="Line 743"/>
            <p:cNvSpPr/>
            <p:nvPr/>
          </p:nvSpPr>
          <p:spPr>
            <a:xfrm>
              <a:off x="2617200" y="8598600"/>
              <a:ext cx="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3" name="Line 744"/>
            <p:cNvSpPr/>
            <p:nvPr/>
          </p:nvSpPr>
          <p:spPr>
            <a:xfrm>
              <a:off x="2629800" y="7713720"/>
              <a:ext cx="0" cy="90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4" name="Line 745"/>
            <p:cNvSpPr/>
            <p:nvPr/>
          </p:nvSpPr>
          <p:spPr>
            <a:xfrm>
              <a:off x="2642400" y="8521920"/>
              <a:ext cx="0" cy="94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5" name="Line 746"/>
            <p:cNvSpPr/>
            <p:nvPr/>
          </p:nvSpPr>
          <p:spPr>
            <a:xfrm>
              <a:off x="2656800" y="859716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6" name="Line 747"/>
            <p:cNvSpPr/>
            <p:nvPr/>
          </p:nvSpPr>
          <p:spPr>
            <a:xfrm>
              <a:off x="2669400" y="860004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7" name="Line 748"/>
            <p:cNvSpPr/>
            <p:nvPr/>
          </p:nvSpPr>
          <p:spPr>
            <a:xfrm>
              <a:off x="2680200" y="860688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8" name="Line 749"/>
            <p:cNvSpPr/>
            <p:nvPr/>
          </p:nvSpPr>
          <p:spPr>
            <a:xfrm>
              <a:off x="2696040" y="8391960"/>
              <a:ext cx="0" cy="22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9" name="Line 750"/>
            <p:cNvSpPr/>
            <p:nvPr/>
          </p:nvSpPr>
          <p:spPr>
            <a:xfrm>
              <a:off x="2707200" y="860004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0" name="Line 751"/>
            <p:cNvSpPr/>
            <p:nvPr/>
          </p:nvSpPr>
          <p:spPr>
            <a:xfrm>
              <a:off x="272160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1" name="Line 752"/>
            <p:cNvSpPr/>
            <p:nvPr/>
          </p:nvSpPr>
          <p:spPr>
            <a:xfrm>
              <a:off x="27468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2" name="Line 753"/>
            <p:cNvSpPr/>
            <p:nvPr/>
          </p:nvSpPr>
          <p:spPr>
            <a:xfrm>
              <a:off x="2760840" y="857808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3" name="Line 754"/>
            <p:cNvSpPr/>
            <p:nvPr/>
          </p:nvSpPr>
          <p:spPr>
            <a:xfrm>
              <a:off x="2772000" y="8597160"/>
              <a:ext cx="0" cy="1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4" name="Line 755"/>
            <p:cNvSpPr/>
            <p:nvPr/>
          </p:nvSpPr>
          <p:spPr>
            <a:xfrm>
              <a:off x="2787840" y="8457840"/>
              <a:ext cx="0" cy="158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5" name="Line 756"/>
            <p:cNvSpPr/>
            <p:nvPr/>
          </p:nvSpPr>
          <p:spPr>
            <a:xfrm>
              <a:off x="2798640" y="8556120"/>
              <a:ext cx="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6" name="Line 757"/>
            <p:cNvSpPr/>
            <p:nvPr/>
          </p:nvSpPr>
          <p:spPr>
            <a:xfrm>
              <a:off x="2813040" y="85834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7" name="Line 758"/>
            <p:cNvSpPr/>
            <p:nvPr/>
          </p:nvSpPr>
          <p:spPr>
            <a:xfrm>
              <a:off x="2825640" y="860004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8" name="Line 759"/>
            <p:cNvSpPr/>
            <p:nvPr/>
          </p:nvSpPr>
          <p:spPr>
            <a:xfrm>
              <a:off x="2839680" y="8549280"/>
              <a:ext cx="0" cy="66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9" name="Line 760"/>
            <p:cNvSpPr/>
            <p:nvPr/>
          </p:nvSpPr>
          <p:spPr>
            <a:xfrm>
              <a:off x="2852640" y="860544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0" name="Line 761"/>
            <p:cNvSpPr/>
            <p:nvPr/>
          </p:nvSpPr>
          <p:spPr>
            <a:xfrm>
              <a:off x="28652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1" name="Line 762"/>
            <p:cNvSpPr/>
            <p:nvPr/>
          </p:nvSpPr>
          <p:spPr>
            <a:xfrm>
              <a:off x="287928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2" name="Line 763"/>
            <p:cNvSpPr/>
            <p:nvPr/>
          </p:nvSpPr>
          <p:spPr>
            <a:xfrm>
              <a:off x="29030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3" name="Line 764"/>
            <p:cNvSpPr/>
            <p:nvPr/>
          </p:nvSpPr>
          <p:spPr>
            <a:xfrm>
              <a:off x="29170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4" name="Line 765"/>
            <p:cNvSpPr/>
            <p:nvPr/>
          </p:nvSpPr>
          <p:spPr>
            <a:xfrm>
              <a:off x="293148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5" name="Line 766"/>
            <p:cNvSpPr/>
            <p:nvPr/>
          </p:nvSpPr>
          <p:spPr>
            <a:xfrm>
              <a:off x="294408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6" name="Line 767"/>
            <p:cNvSpPr/>
            <p:nvPr/>
          </p:nvSpPr>
          <p:spPr>
            <a:xfrm>
              <a:off x="2956680" y="860688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7" name="Line 768"/>
            <p:cNvSpPr/>
            <p:nvPr/>
          </p:nvSpPr>
          <p:spPr>
            <a:xfrm>
              <a:off x="2970720" y="8574120"/>
              <a:ext cx="0" cy="42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8" name="Line 769"/>
            <p:cNvSpPr/>
            <p:nvPr/>
          </p:nvSpPr>
          <p:spPr>
            <a:xfrm>
              <a:off x="2983680" y="86083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9" name="Line 770"/>
            <p:cNvSpPr/>
            <p:nvPr/>
          </p:nvSpPr>
          <p:spPr>
            <a:xfrm>
              <a:off x="2996280" y="8601480"/>
              <a:ext cx="0" cy="14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0" name="Line 771"/>
            <p:cNvSpPr/>
            <p:nvPr/>
          </p:nvSpPr>
          <p:spPr>
            <a:xfrm>
              <a:off x="301032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1" name="Line 772"/>
            <p:cNvSpPr/>
            <p:nvPr/>
          </p:nvSpPr>
          <p:spPr>
            <a:xfrm>
              <a:off x="3022920" y="8601480"/>
              <a:ext cx="0" cy="14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2" name="Line 773"/>
            <p:cNvSpPr/>
            <p:nvPr/>
          </p:nvSpPr>
          <p:spPr>
            <a:xfrm>
              <a:off x="303408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3" name="Line 774"/>
            <p:cNvSpPr/>
            <p:nvPr/>
          </p:nvSpPr>
          <p:spPr>
            <a:xfrm>
              <a:off x="304812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4" name="Line 775"/>
            <p:cNvSpPr/>
            <p:nvPr/>
          </p:nvSpPr>
          <p:spPr>
            <a:xfrm>
              <a:off x="30607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5" name="Line 776"/>
            <p:cNvSpPr/>
            <p:nvPr/>
          </p:nvSpPr>
          <p:spPr>
            <a:xfrm>
              <a:off x="308628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6" name="Line 777"/>
            <p:cNvSpPr/>
            <p:nvPr/>
          </p:nvSpPr>
          <p:spPr>
            <a:xfrm>
              <a:off x="310032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7" name="Line 778"/>
            <p:cNvSpPr/>
            <p:nvPr/>
          </p:nvSpPr>
          <p:spPr>
            <a:xfrm>
              <a:off x="31129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8" name="Line 779"/>
            <p:cNvSpPr/>
            <p:nvPr/>
          </p:nvSpPr>
          <p:spPr>
            <a:xfrm>
              <a:off x="31255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9" name="Line 780"/>
            <p:cNvSpPr/>
            <p:nvPr/>
          </p:nvSpPr>
          <p:spPr>
            <a:xfrm>
              <a:off x="31381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0" name="Line 781"/>
            <p:cNvSpPr/>
            <p:nvPr/>
          </p:nvSpPr>
          <p:spPr>
            <a:xfrm>
              <a:off x="3153960" y="8521920"/>
              <a:ext cx="0" cy="94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1" name="Line 782"/>
            <p:cNvSpPr/>
            <p:nvPr/>
          </p:nvSpPr>
          <p:spPr>
            <a:xfrm>
              <a:off x="3166560" y="860688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2" name="Line 783"/>
            <p:cNvSpPr/>
            <p:nvPr/>
          </p:nvSpPr>
          <p:spPr>
            <a:xfrm>
              <a:off x="3177720" y="8595720"/>
              <a:ext cx="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3" name="Line 784"/>
            <p:cNvSpPr/>
            <p:nvPr/>
          </p:nvSpPr>
          <p:spPr>
            <a:xfrm>
              <a:off x="31917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4" name="Line 785"/>
            <p:cNvSpPr/>
            <p:nvPr/>
          </p:nvSpPr>
          <p:spPr>
            <a:xfrm>
              <a:off x="3206160" y="8531640"/>
              <a:ext cx="0" cy="84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5" name="Line 786"/>
            <p:cNvSpPr/>
            <p:nvPr/>
          </p:nvSpPr>
          <p:spPr>
            <a:xfrm>
              <a:off x="3218760" y="8574120"/>
              <a:ext cx="0" cy="42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6" name="Line 787"/>
            <p:cNvSpPr/>
            <p:nvPr/>
          </p:nvSpPr>
          <p:spPr>
            <a:xfrm>
              <a:off x="3231360" y="860688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7" name="Line 788"/>
            <p:cNvSpPr/>
            <p:nvPr/>
          </p:nvSpPr>
          <p:spPr>
            <a:xfrm>
              <a:off x="324396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8" name="Line 789"/>
            <p:cNvSpPr/>
            <p:nvPr/>
          </p:nvSpPr>
          <p:spPr>
            <a:xfrm>
              <a:off x="3270960" y="858636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9" name="Line 790"/>
            <p:cNvSpPr/>
            <p:nvPr/>
          </p:nvSpPr>
          <p:spPr>
            <a:xfrm>
              <a:off x="328356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0" name="Line 791"/>
            <p:cNvSpPr/>
            <p:nvPr/>
          </p:nvSpPr>
          <p:spPr>
            <a:xfrm>
              <a:off x="329760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1" name="Line 792"/>
            <p:cNvSpPr/>
            <p:nvPr/>
          </p:nvSpPr>
          <p:spPr>
            <a:xfrm>
              <a:off x="33087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2" name="Line 793"/>
            <p:cNvSpPr/>
            <p:nvPr/>
          </p:nvSpPr>
          <p:spPr>
            <a:xfrm>
              <a:off x="332280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3" name="Line 794"/>
            <p:cNvSpPr/>
            <p:nvPr/>
          </p:nvSpPr>
          <p:spPr>
            <a:xfrm>
              <a:off x="3337200" y="8556120"/>
              <a:ext cx="0" cy="6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4" name="Line 795"/>
            <p:cNvSpPr/>
            <p:nvPr/>
          </p:nvSpPr>
          <p:spPr>
            <a:xfrm>
              <a:off x="3348360" y="86083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5" name="Line 796"/>
            <p:cNvSpPr/>
            <p:nvPr/>
          </p:nvSpPr>
          <p:spPr>
            <a:xfrm>
              <a:off x="336240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6" name="Line 797"/>
            <p:cNvSpPr/>
            <p:nvPr/>
          </p:nvSpPr>
          <p:spPr>
            <a:xfrm>
              <a:off x="3375000" y="8580960"/>
              <a:ext cx="0" cy="35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7" name="Line 798"/>
            <p:cNvSpPr/>
            <p:nvPr/>
          </p:nvSpPr>
          <p:spPr>
            <a:xfrm>
              <a:off x="3389400" y="8598600"/>
              <a:ext cx="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8" name="Line 799"/>
            <p:cNvSpPr/>
            <p:nvPr/>
          </p:nvSpPr>
          <p:spPr>
            <a:xfrm>
              <a:off x="3402000" y="8569800"/>
              <a:ext cx="0" cy="46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9" name="Line 800"/>
            <p:cNvSpPr/>
            <p:nvPr/>
          </p:nvSpPr>
          <p:spPr>
            <a:xfrm>
              <a:off x="341460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0" name="Line 801"/>
            <p:cNvSpPr/>
            <p:nvPr/>
          </p:nvSpPr>
          <p:spPr>
            <a:xfrm>
              <a:off x="3427200" y="8602560"/>
              <a:ext cx="0" cy="13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1" name="Line 802"/>
            <p:cNvSpPr/>
            <p:nvPr/>
          </p:nvSpPr>
          <p:spPr>
            <a:xfrm>
              <a:off x="34412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2" name="Line 803"/>
            <p:cNvSpPr/>
            <p:nvPr/>
          </p:nvSpPr>
          <p:spPr>
            <a:xfrm>
              <a:off x="345384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3" name="Line 804"/>
            <p:cNvSpPr/>
            <p:nvPr/>
          </p:nvSpPr>
          <p:spPr>
            <a:xfrm>
              <a:off x="34682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4" name="Line 805"/>
            <p:cNvSpPr/>
            <p:nvPr/>
          </p:nvSpPr>
          <p:spPr>
            <a:xfrm>
              <a:off x="3480840" y="7741080"/>
              <a:ext cx="0" cy="875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5" name="Line 806"/>
            <p:cNvSpPr/>
            <p:nvPr/>
          </p:nvSpPr>
          <p:spPr>
            <a:xfrm>
              <a:off x="3493440" y="8523360"/>
              <a:ext cx="0" cy="9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080" bIns="460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6" name="Line 807"/>
            <p:cNvSpPr/>
            <p:nvPr/>
          </p:nvSpPr>
          <p:spPr>
            <a:xfrm>
              <a:off x="3506040" y="8602560"/>
              <a:ext cx="0" cy="13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7" name="Line 808"/>
            <p:cNvSpPr/>
            <p:nvPr/>
          </p:nvSpPr>
          <p:spPr>
            <a:xfrm>
              <a:off x="35186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8" name="Line 809"/>
            <p:cNvSpPr/>
            <p:nvPr/>
          </p:nvSpPr>
          <p:spPr>
            <a:xfrm>
              <a:off x="354564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9" name="Line 810"/>
            <p:cNvSpPr/>
            <p:nvPr/>
          </p:nvSpPr>
          <p:spPr>
            <a:xfrm>
              <a:off x="357084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0" name="Line 811"/>
            <p:cNvSpPr/>
            <p:nvPr/>
          </p:nvSpPr>
          <p:spPr>
            <a:xfrm>
              <a:off x="35834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1" name="Line 812"/>
            <p:cNvSpPr/>
            <p:nvPr/>
          </p:nvSpPr>
          <p:spPr>
            <a:xfrm>
              <a:off x="3597480" y="8594640"/>
              <a:ext cx="0" cy="21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2" name="Line 813"/>
            <p:cNvSpPr/>
            <p:nvPr/>
          </p:nvSpPr>
          <p:spPr>
            <a:xfrm>
              <a:off x="3611880" y="8341560"/>
              <a:ext cx="0" cy="27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3" name="Line 814"/>
            <p:cNvSpPr/>
            <p:nvPr/>
          </p:nvSpPr>
          <p:spPr>
            <a:xfrm>
              <a:off x="3624480" y="8576640"/>
              <a:ext cx="0" cy="3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4" name="Line 815"/>
            <p:cNvSpPr/>
            <p:nvPr/>
          </p:nvSpPr>
          <p:spPr>
            <a:xfrm>
              <a:off x="3638520" y="860544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5" name="Line 816"/>
            <p:cNvSpPr/>
            <p:nvPr/>
          </p:nvSpPr>
          <p:spPr>
            <a:xfrm>
              <a:off x="364968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6" name="Line 817"/>
            <p:cNvSpPr/>
            <p:nvPr/>
          </p:nvSpPr>
          <p:spPr>
            <a:xfrm>
              <a:off x="368748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7" name="Line 818"/>
            <p:cNvSpPr/>
            <p:nvPr/>
          </p:nvSpPr>
          <p:spPr>
            <a:xfrm>
              <a:off x="371592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8" name="Line 819"/>
            <p:cNvSpPr/>
            <p:nvPr/>
          </p:nvSpPr>
          <p:spPr>
            <a:xfrm>
              <a:off x="372708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9" name="Line 820"/>
            <p:cNvSpPr/>
            <p:nvPr/>
          </p:nvSpPr>
          <p:spPr>
            <a:xfrm>
              <a:off x="374292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0" name="Line 821"/>
            <p:cNvSpPr/>
            <p:nvPr/>
          </p:nvSpPr>
          <p:spPr>
            <a:xfrm>
              <a:off x="3755520" y="8371440"/>
              <a:ext cx="0" cy="24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1" name="Line 822"/>
            <p:cNvSpPr/>
            <p:nvPr/>
          </p:nvSpPr>
          <p:spPr>
            <a:xfrm>
              <a:off x="3768120" y="8583480"/>
              <a:ext cx="0" cy="3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2" name="Line 823"/>
            <p:cNvSpPr/>
            <p:nvPr/>
          </p:nvSpPr>
          <p:spPr>
            <a:xfrm>
              <a:off x="3780720" y="8609400"/>
              <a:ext cx="0" cy="6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3" name="Line 824"/>
            <p:cNvSpPr/>
            <p:nvPr/>
          </p:nvSpPr>
          <p:spPr>
            <a:xfrm>
              <a:off x="37951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4" name="Line 825"/>
            <p:cNvSpPr/>
            <p:nvPr/>
          </p:nvSpPr>
          <p:spPr>
            <a:xfrm>
              <a:off x="38091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5" name="Line 826"/>
            <p:cNvSpPr/>
            <p:nvPr/>
          </p:nvSpPr>
          <p:spPr>
            <a:xfrm>
              <a:off x="3821760" y="86083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6" name="Line 827"/>
            <p:cNvSpPr/>
            <p:nvPr/>
          </p:nvSpPr>
          <p:spPr>
            <a:xfrm>
              <a:off x="3832920" y="86083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7" name="Line 828"/>
            <p:cNvSpPr/>
            <p:nvPr/>
          </p:nvSpPr>
          <p:spPr>
            <a:xfrm>
              <a:off x="38469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8" name="Line 829"/>
            <p:cNvSpPr/>
            <p:nvPr/>
          </p:nvSpPr>
          <p:spPr>
            <a:xfrm>
              <a:off x="38739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9" name="Line 830"/>
            <p:cNvSpPr/>
            <p:nvPr/>
          </p:nvSpPr>
          <p:spPr>
            <a:xfrm>
              <a:off x="389916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0" name="Line 831"/>
            <p:cNvSpPr/>
            <p:nvPr/>
          </p:nvSpPr>
          <p:spPr>
            <a:xfrm>
              <a:off x="39117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1" name="Line 832"/>
            <p:cNvSpPr/>
            <p:nvPr/>
          </p:nvSpPr>
          <p:spPr>
            <a:xfrm>
              <a:off x="39243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2" name="Line 833"/>
            <p:cNvSpPr/>
            <p:nvPr/>
          </p:nvSpPr>
          <p:spPr>
            <a:xfrm>
              <a:off x="39387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3" name="Line 834"/>
            <p:cNvSpPr/>
            <p:nvPr/>
          </p:nvSpPr>
          <p:spPr>
            <a:xfrm>
              <a:off x="3963960" y="860544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4" name="Line 835"/>
            <p:cNvSpPr/>
            <p:nvPr/>
          </p:nvSpPr>
          <p:spPr>
            <a:xfrm>
              <a:off x="39798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5" name="Line 836"/>
            <p:cNvSpPr/>
            <p:nvPr/>
          </p:nvSpPr>
          <p:spPr>
            <a:xfrm>
              <a:off x="39906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6" name="Line 837"/>
            <p:cNvSpPr/>
            <p:nvPr/>
          </p:nvSpPr>
          <p:spPr>
            <a:xfrm>
              <a:off x="40035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7" name="Line 838"/>
            <p:cNvSpPr/>
            <p:nvPr/>
          </p:nvSpPr>
          <p:spPr>
            <a:xfrm>
              <a:off x="40176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8" name="Line 839"/>
            <p:cNvSpPr/>
            <p:nvPr/>
          </p:nvSpPr>
          <p:spPr>
            <a:xfrm>
              <a:off x="4031640" y="7918920"/>
              <a:ext cx="0" cy="697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9" name="Line 840"/>
            <p:cNvSpPr/>
            <p:nvPr/>
          </p:nvSpPr>
          <p:spPr>
            <a:xfrm>
              <a:off x="4044600" y="8537040"/>
              <a:ext cx="0" cy="79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0" name="Line 841"/>
            <p:cNvSpPr/>
            <p:nvPr/>
          </p:nvSpPr>
          <p:spPr>
            <a:xfrm>
              <a:off x="4055400" y="8598600"/>
              <a:ext cx="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1" name="Line 842"/>
            <p:cNvSpPr/>
            <p:nvPr/>
          </p:nvSpPr>
          <p:spPr>
            <a:xfrm>
              <a:off x="40698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2" name="Line 843"/>
            <p:cNvSpPr/>
            <p:nvPr/>
          </p:nvSpPr>
          <p:spPr>
            <a:xfrm>
              <a:off x="408240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3" name="Line 844"/>
            <p:cNvSpPr/>
            <p:nvPr/>
          </p:nvSpPr>
          <p:spPr>
            <a:xfrm>
              <a:off x="40932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4" name="Line 845"/>
            <p:cNvSpPr/>
            <p:nvPr/>
          </p:nvSpPr>
          <p:spPr>
            <a:xfrm>
              <a:off x="41076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5" name="Line 846"/>
            <p:cNvSpPr/>
            <p:nvPr/>
          </p:nvSpPr>
          <p:spPr>
            <a:xfrm>
              <a:off x="41216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6" name="Line 847"/>
            <p:cNvSpPr/>
            <p:nvPr/>
          </p:nvSpPr>
          <p:spPr>
            <a:xfrm>
              <a:off x="413604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7" name="Line 848"/>
            <p:cNvSpPr/>
            <p:nvPr/>
          </p:nvSpPr>
          <p:spPr>
            <a:xfrm>
              <a:off x="414720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8" name="Line 849"/>
            <p:cNvSpPr/>
            <p:nvPr/>
          </p:nvSpPr>
          <p:spPr>
            <a:xfrm>
              <a:off x="4161240" y="860544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9" name="Line 850"/>
            <p:cNvSpPr/>
            <p:nvPr/>
          </p:nvSpPr>
          <p:spPr>
            <a:xfrm>
              <a:off x="4173840" y="8552160"/>
              <a:ext cx="0" cy="64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0" name="Line 851"/>
            <p:cNvSpPr/>
            <p:nvPr/>
          </p:nvSpPr>
          <p:spPr>
            <a:xfrm>
              <a:off x="4188240" y="860004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1" name="Line 852"/>
            <p:cNvSpPr/>
            <p:nvPr/>
          </p:nvSpPr>
          <p:spPr>
            <a:xfrm>
              <a:off x="419904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2" name="Line 853"/>
            <p:cNvSpPr/>
            <p:nvPr/>
          </p:nvSpPr>
          <p:spPr>
            <a:xfrm>
              <a:off x="4344480" y="8576640"/>
              <a:ext cx="0" cy="3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3" name="Line 854"/>
            <p:cNvSpPr/>
            <p:nvPr/>
          </p:nvSpPr>
          <p:spPr>
            <a:xfrm>
              <a:off x="435708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4" name="Line 855"/>
            <p:cNvSpPr/>
            <p:nvPr/>
          </p:nvSpPr>
          <p:spPr>
            <a:xfrm>
              <a:off x="436968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5" name="Line 856"/>
            <p:cNvSpPr/>
            <p:nvPr/>
          </p:nvSpPr>
          <p:spPr>
            <a:xfrm>
              <a:off x="438372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6" name="Line 857"/>
            <p:cNvSpPr/>
            <p:nvPr/>
          </p:nvSpPr>
          <p:spPr>
            <a:xfrm>
              <a:off x="439632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7" name="Line 858"/>
            <p:cNvSpPr/>
            <p:nvPr/>
          </p:nvSpPr>
          <p:spPr>
            <a:xfrm>
              <a:off x="44092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8" name="Line 859"/>
            <p:cNvSpPr/>
            <p:nvPr/>
          </p:nvSpPr>
          <p:spPr>
            <a:xfrm>
              <a:off x="444708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9" name="Line 860"/>
            <p:cNvSpPr/>
            <p:nvPr/>
          </p:nvSpPr>
          <p:spPr>
            <a:xfrm>
              <a:off x="45370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0" name="Line 861"/>
            <p:cNvSpPr/>
            <p:nvPr/>
          </p:nvSpPr>
          <p:spPr>
            <a:xfrm>
              <a:off x="45417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1" name="Line 862"/>
            <p:cNvSpPr/>
            <p:nvPr/>
          </p:nvSpPr>
          <p:spPr>
            <a:xfrm>
              <a:off x="45684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2" name="Line 863"/>
            <p:cNvSpPr/>
            <p:nvPr/>
          </p:nvSpPr>
          <p:spPr>
            <a:xfrm>
              <a:off x="45813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3" name="Line 864"/>
            <p:cNvSpPr/>
            <p:nvPr/>
          </p:nvSpPr>
          <p:spPr>
            <a:xfrm>
              <a:off x="459396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4" name="Line 865"/>
            <p:cNvSpPr/>
            <p:nvPr/>
          </p:nvSpPr>
          <p:spPr>
            <a:xfrm>
              <a:off x="468396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5" name="Line 866"/>
            <p:cNvSpPr/>
            <p:nvPr/>
          </p:nvSpPr>
          <p:spPr>
            <a:xfrm>
              <a:off x="469656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6" name="Line 867"/>
            <p:cNvSpPr/>
            <p:nvPr/>
          </p:nvSpPr>
          <p:spPr>
            <a:xfrm>
              <a:off x="471060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7" name="Line 868"/>
            <p:cNvSpPr/>
            <p:nvPr/>
          </p:nvSpPr>
          <p:spPr>
            <a:xfrm>
              <a:off x="4750200" y="8604000"/>
              <a:ext cx="0" cy="12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8" name="Line 869"/>
            <p:cNvSpPr/>
            <p:nvPr/>
          </p:nvSpPr>
          <p:spPr>
            <a:xfrm>
              <a:off x="476280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9" name="Line 870"/>
            <p:cNvSpPr/>
            <p:nvPr/>
          </p:nvSpPr>
          <p:spPr>
            <a:xfrm>
              <a:off x="47768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0" name="Line 871"/>
            <p:cNvSpPr/>
            <p:nvPr/>
          </p:nvSpPr>
          <p:spPr>
            <a:xfrm>
              <a:off x="486540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1" name="Line 872"/>
            <p:cNvSpPr/>
            <p:nvPr/>
          </p:nvSpPr>
          <p:spPr>
            <a:xfrm>
              <a:off x="49064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2" name="Line 873"/>
            <p:cNvSpPr/>
            <p:nvPr/>
          </p:nvSpPr>
          <p:spPr>
            <a:xfrm>
              <a:off x="49204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3" name="Line 874"/>
            <p:cNvSpPr/>
            <p:nvPr/>
          </p:nvSpPr>
          <p:spPr>
            <a:xfrm>
              <a:off x="4931640" y="8605440"/>
              <a:ext cx="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4" name="Line 875"/>
            <p:cNvSpPr/>
            <p:nvPr/>
          </p:nvSpPr>
          <p:spPr>
            <a:xfrm>
              <a:off x="49474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5" name="Line 876"/>
            <p:cNvSpPr/>
            <p:nvPr/>
          </p:nvSpPr>
          <p:spPr>
            <a:xfrm>
              <a:off x="4960080" y="8600040"/>
              <a:ext cx="0" cy="16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6" name="Line 877"/>
            <p:cNvSpPr/>
            <p:nvPr/>
          </p:nvSpPr>
          <p:spPr>
            <a:xfrm>
              <a:off x="49712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7" name="Line 878"/>
            <p:cNvSpPr/>
            <p:nvPr/>
          </p:nvSpPr>
          <p:spPr>
            <a:xfrm>
              <a:off x="498528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8" name="Line 879"/>
            <p:cNvSpPr/>
            <p:nvPr/>
          </p:nvSpPr>
          <p:spPr>
            <a:xfrm>
              <a:off x="504864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9" name="Line 880"/>
            <p:cNvSpPr/>
            <p:nvPr/>
          </p:nvSpPr>
          <p:spPr>
            <a:xfrm>
              <a:off x="506124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0" name="Line 881"/>
            <p:cNvSpPr/>
            <p:nvPr/>
          </p:nvSpPr>
          <p:spPr>
            <a:xfrm>
              <a:off x="50896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1" name="Line 882"/>
            <p:cNvSpPr/>
            <p:nvPr/>
          </p:nvSpPr>
          <p:spPr>
            <a:xfrm>
              <a:off x="514152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2" name="Line 883"/>
            <p:cNvSpPr/>
            <p:nvPr/>
          </p:nvSpPr>
          <p:spPr>
            <a:xfrm>
              <a:off x="52599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3" name="Line 884"/>
            <p:cNvSpPr/>
            <p:nvPr/>
          </p:nvSpPr>
          <p:spPr>
            <a:xfrm>
              <a:off x="52725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4" name="Line 885"/>
            <p:cNvSpPr/>
            <p:nvPr/>
          </p:nvSpPr>
          <p:spPr>
            <a:xfrm>
              <a:off x="529812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5" name="Line 886"/>
            <p:cNvSpPr/>
            <p:nvPr/>
          </p:nvSpPr>
          <p:spPr>
            <a:xfrm>
              <a:off x="534060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6" name="Line 887"/>
            <p:cNvSpPr/>
            <p:nvPr/>
          </p:nvSpPr>
          <p:spPr>
            <a:xfrm>
              <a:off x="5351760" y="8580960"/>
              <a:ext cx="0" cy="35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7" name="Line 888"/>
            <p:cNvSpPr/>
            <p:nvPr/>
          </p:nvSpPr>
          <p:spPr>
            <a:xfrm>
              <a:off x="5365800" y="8609400"/>
              <a:ext cx="0" cy="6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8" name="Line 889"/>
            <p:cNvSpPr/>
            <p:nvPr/>
          </p:nvSpPr>
          <p:spPr>
            <a:xfrm>
              <a:off x="53769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9" name="Line 890"/>
            <p:cNvSpPr/>
            <p:nvPr/>
          </p:nvSpPr>
          <p:spPr>
            <a:xfrm>
              <a:off x="54856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0" name="Line 891"/>
            <p:cNvSpPr/>
            <p:nvPr/>
          </p:nvSpPr>
          <p:spPr>
            <a:xfrm>
              <a:off x="56782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1" name="Line 892"/>
            <p:cNvSpPr/>
            <p:nvPr/>
          </p:nvSpPr>
          <p:spPr>
            <a:xfrm>
              <a:off x="5692680" y="8612280"/>
              <a:ext cx="0" cy="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2" name="Line 893"/>
            <p:cNvSpPr/>
            <p:nvPr/>
          </p:nvSpPr>
          <p:spPr>
            <a:xfrm>
              <a:off x="57052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3" name="Line 894"/>
            <p:cNvSpPr/>
            <p:nvPr/>
          </p:nvSpPr>
          <p:spPr>
            <a:xfrm>
              <a:off x="5719320" y="8610840"/>
              <a:ext cx="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4" name="Line 895"/>
            <p:cNvSpPr/>
            <p:nvPr/>
          </p:nvSpPr>
          <p:spPr>
            <a:xfrm>
              <a:off x="5902560" y="8606880"/>
              <a:ext cx="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5" name="Line 896"/>
            <p:cNvSpPr/>
            <p:nvPr/>
          </p:nvSpPr>
          <p:spPr>
            <a:xfrm>
              <a:off x="592956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6" name="Line 897"/>
            <p:cNvSpPr/>
            <p:nvPr/>
          </p:nvSpPr>
          <p:spPr>
            <a:xfrm>
              <a:off x="6111000" y="8613720"/>
              <a:ext cx="0" cy="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7" name="Line 898"/>
            <p:cNvSpPr/>
            <p:nvPr/>
          </p:nvSpPr>
          <p:spPr>
            <a:xfrm>
              <a:off x="6310080" y="8615160"/>
              <a:ext cx="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8" name="Text Box 899"/>
            <p:cNvSpPr/>
            <p:nvPr/>
          </p:nvSpPr>
          <p:spPr>
            <a:xfrm>
              <a:off x="3594240" y="814320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9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9" name="Text Box 900"/>
            <p:cNvSpPr/>
            <p:nvPr/>
          </p:nvSpPr>
          <p:spPr>
            <a:xfrm>
              <a:off x="3248280" y="749628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7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0" name="Text Box 901"/>
            <p:cNvSpPr/>
            <p:nvPr/>
          </p:nvSpPr>
          <p:spPr>
            <a:xfrm>
              <a:off x="2231640" y="627228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29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1" name="Text Box 902"/>
            <p:cNvSpPr/>
            <p:nvPr/>
          </p:nvSpPr>
          <p:spPr>
            <a:xfrm>
              <a:off x="1731600" y="74307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7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2" name="Text Box 903"/>
            <p:cNvSpPr/>
            <p:nvPr/>
          </p:nvSpPr>
          <p:spPr>
            <a:xfrm>
              <a:off x="1185120" y="784224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5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3" name="Text Box 904"/>
            <p:cNvSpPr/>
            <p:nvPr/>
          </p:nvSpPr>
          <p:spPr>
            <a:xfrm>
              <a:off x="3394080" y="802296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17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4" name="Text Box 905"/>
            <p:cNvSpPr/>
            <p:nvPr/>
          </p:nvSpPr>
          <p:spPr>
            <a:xfrm>
              <a:off x="3808800" y="768924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28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5" name="Text Box 906"/>
            <p:cNvSpPr/>
            <p:nvPr/>
          </p:nvSpPr>
          <p:spPr>
            <a:xfrm>
              <a:off x="2363040" y="748800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4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6" name="Text Box 907"/>
            <p:cNvSpPr/>
            <p:nvPr/>
          </p:nvSpPr>
          <p:spPr>
            <a:xfrm>
              <a:off x="2522520" y="814860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47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7" name="Text Box 908"/>
            <p:cNvSpPr/>
            <p:nvPr/>
          </p:nvSpPr>
          <p:spPr>
            <a:xfrm>
              <a:off x="5119560" y="835812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5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8" name="Text Box 909"/>
            <p:cNvSpPr/>
            <p:nvPr/>
          </p:nvSpPr>
          <p:spPr>
            <a:xfrm>
              <a:off x="2083680" y="763164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15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9" name="Text Box 910"/>
            <p:cNvSpPr/>
            <p:nvPr/>
          </p:nvSpPr>
          <p:spPr>
            <a:xfrm>
              <a:off x="3954600" y="820764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0" name="Text Box 911"/>
            <p:cNvSpPr/>
            <p:nvPr/>
          </p:nvSpPr>
          <p:spPr>
            <a:xfrm>
              <a:off x="1927080" y="787104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1" name="Text Box 912"/>
            <p:cNvSpPr/>
            <p:nvPr/>
          </p:nvSpPr>
          <p:spPr>
            <a:xfrm>
              <a:off x="1837440" y="76971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2" name="Text Box 1076"/>
            <p:cNvSpPr/>
            <p:nvPr/>
          </p:nvSpPr>
          <p:spPr>
            <a:xfrm>
              <a:off x="3430440" y="8798040"/>
              <a:ext cx="1189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on mass (m/z)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3" name="Text Box 1078"/>
            <p:cNvSpPr/>
            <p:nvPr/>
          </p:nvSpPr>
          <p:spPr>
            <a:xfrm>
              <a:off x="726480" y="6522840"/>
              <a:ext cx="349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I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114" name="Text Box 1079"/>
          <p:cNvSpPr/>
          <p:nvPr/>
        </p:nvSpPr>
        <p:spPr>
          <a:xfrm>
            <a:off x="644040" y="1095480"/>
            <a:ext cx="46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IC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5" name="Rectangle 1080"/>
          <p:cNvSpPr/>
          <p:nvPr/>
        </p:nvSpPr>
        <p:spPr>
          <a:xfrm>
            <a:off x="3056760" y="6335640"/>
            <a:ext cx="1523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on mass (m/z)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116" name="Groupe 1081"/>
          <p:cNvGrpSpPr/>
          <p:nvPr/>
        </p:nvGrpSpPr>
        <p:grpSpPr>
          <a:xfrm>
            <a:off x="1778400" y="202680"/>
            <a:ext cx="3010320" cy="2536200"/>
            <a:chOff x="1778400" y="202680"/>
            <a:chExt cx="3010320" cy="2536200"/>
          </a:xfrm>
        </p:grpSpPr>
        <p:sp>
          <p:nvSpPr>
            <p:cNvPr id="1117" name="Rectangle 23"/>
            <p:cNvSpPr/>
            <p:nvPr/>
          </p:nvSpPr>
          <p:spPr>
            <a:xfrm>
              <a:off x="2962440" y="1334520"/>
              <a:ext cx="11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8" name="Line 24"/>
            <p:cNvSpPr/>
            <p:nvPr/>
          </p:nvSpPr>
          <p:spPr>
            <a:xfrm flipH="1" flipV="1">
              <a:off x="2357640" y="1388880"/>
              <a:ext cx="164160" cy="266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9" name="Freeform 25"/>
            <p:cNvSpPr/>
            <p:nvPr/>
          </p:nvSpPr>
          <p:spPr>
            <a:xfrm>
              <a:off x="2351880" y="1386720"/>
              <a:ext cx="192240" cy="271440"/>
            </a:xfrm>
            <a:custGeom>
              <a:avLst/>
              <a:gdLst>
                <a:gd name="textAreaLeft" fmla="*/ 0 w 192240"/>
                <a:gd name="textAreaRight" fmla="*/ 192600 w 192240"/>
                <a:gd name="textAreaTop" fmla="*/ 0 h 271440"/>
                <a:gd name="textAreaBottom" fmla="*/ 271800 h 271440"/>
              </a:gdLst>
              <a:ahLst/>
              <a:rect l="textAreaLeft" t="textAreaTop" r="textAreaRight" b="textAreaBottom"/>
              <a:pathLst>
                <a:path w="275" h="417">
                  <a:moveTo>
                    <a:pt x="275" y="374"/>
                  </a:moveTo>
                  <a:lnTo>
                    <a:pt x="246" y="417"/>
                  </a:lnTo>
                  <a:lnTo>
                    <a:pt x="181" y="390"/>
                  </a:lnTo>
                  <a:lnTo>
                    <a:pt x="0" y="10"/>
                  </a:lnTo>
                  <a:lnTo>
                    <a:pt x="6" y="0"/>
                  </a:lnTo>
                  <a:lnTo>
                    <a:pt x="25" y="14"/>
                  </a:lnTo>
                  <a:lnTo>
                    <a:pt x="275" y="37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0" name="Line 26"/>
            <p:cNvSpPr/>
            <p:nvPr/>
          </p:nvSpPr>
          <p:spPr>
            <a:xfrm flipH="1">
              <a:off x="2526120" y="1578600"/>
              <a:ext cx="321840" cy="79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1" name="Freeform 27"/>
            <p:cNvSpPr/>
            <p:nvPr/>
          </p:nvSpPr>
          <p:spPr>
            <a:xfrm>
              <a:off x="2524680" y="1552320"/>
              <a:ext cx="347040" cy="118440"/>
            </a:xfrm>
            <a:custGeom>
              <a:avLst/>
              <a:gdLst>
                <a:gd name="textAreaLeft" fmla="*/ 0 w 347040"/>
                <a:gd name="textAreaRight" fmla="*/ 347400 w 347040"/>
                <a:gd name="textAreaTop" fmla="*/ 0 h 118440"/>
                <a:gd name="textAreaBottom" fmla="*/ 118800 h 118440"/>
              </a:gdLst>
              <a:ahLst/>
              <a:rect l="textAreaLeft" t="textAreaTop" r="textAreaRight" b="textAreaBottom"/>
              <a:pathLst>
                <a:path w="493" h="182">
                  <a:moveTo>
                    <a:pt x="493" y="0"/>
                  </a:moveTo>
                  <a:lnTo>
                    <a:pt x="465" y="40"/>
                  </a:lnTo>
                  <a:lnTo>
                    <a:pt x="482" y="69"/>
                  </a:lnTo>
                  <a:lnTo>
                    <a:pt x="46" y="182"/>
                  </a:lnTo>
                  <a:lnTo>
                    <a:pt x="0" y="163"/>
                  </a:lnTo>
                  <a:lnTo>
                    <a:pt x="29" y="120"/>
                  </a:lnTo>
                  <a:lnTo>
                    <a:pt x="49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2" name="Line 28"/>
            <p:cNvSpPr/>
            <p:nvPr/>
          </p:nvSpPr>
          <p:spPr>
            <a:xfrm flipH="1" flipV="1">
              <a:off x="2852280" y="1578240"/>
              <a:ext cx="320400" cy="79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3" name="Freeform 29"/>
            <p:cNvSpPr/>
            <p:nvPr/>
          </p:nvSpPr>
          <p:spPr>
            <a:xfrm>
              <a:off x="2850840" y="1552320"/>
              <a:ext cx="324720" cy="109440"/>
            </a:xfrm>
            <a:custGeom>
              <a:avLst/>
              <a:gdLst>
                <a:gd name="textAreaLeft" fmla="*/ 0 w 324720"/>
                <a:gd name="textAreaRight" fmla="*/ 325080 w 32472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461" h="168">
                  <a:moveTo>
                    <a:pt x="443" y="147"/>
                  </a:moveTo>
                  <a:lnTo>
                    <a:pt x="461" y="163"/>
                  </a:lnTo>
                  <a:lnTo>
                    <a:pt x="457" y="168"/>
                  </a:lnTo>
                  <a:lnTo>
                    <a:pt x="71" y="101"/>
                  </a:lnTo>
                  <a:lnTo>
                    <a:pt x="0" y="40"/>
                  </a:lnTo>
                  <a:lnTo>
                    <a:pt x="28" y="0"/>
                  </a:lnTo>
                  <a:lnTo>
                    <a:pt x="443" y="14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4" name="Line 30"/>
            <p:cNvSpPr/>
            <p:nvPr/>
          </p:nvSpPr>
          <p:spPr>
            <a:xfrm flipH="1" flipV="1">
              <a:off x="3039480" y="1438560"/>
              <a:ext cx="136080" cy="219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5" name="Line 31"/>
            <p:cNvSpPr/>
            <p:nvPr/>
          </p:nvSpPr>
          <p:spPr>
            <a:xfrm flipH="1">
              <a:off x="2679120" y="1402200"/>
              <a:ext cx="266760" cy="63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6" name="Line 32"/>
            <p:cNvSpPr/>
            <p:nvPr/>
          </p:nvSpPr>
          <p:spPr>
            <a:xfrm flipH="1" flipV="1">
              <a:off x="2356200" y="1386360"/>
              <a:ext cx="323280" cy="79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7" name="Line 33"/>
            <p:cNvSpPr/>
            <p:nvPr/>
          </p:nvSpPr>
          <p:spPr>
            <a:xfrm flipH="1" flipV="1">
              <a:off x="2344680" y="1112040"/>
              <a:ext cx="11160" cy="273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8" name="Line 34"/>
            <p:cNvSpPr/>
            <p:nvPr/>
          </p:nvSpPr>
          <p:spPr>
            <a:xfrm flipH="1" flipV="1">
              <a:off x="2197080" y="1576080"/>
              <a:ext cx="327240" cy="82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9" name="Line 35"/>
            <p:cNvSpPr/>
            <p:nvPr/>
          </p:nvSpPr>
          <p:spPr>
            <a:xfrm>
              <a:off x="2850840" y="1578600"/>
              <a:ext cx="238680" cy="22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0" name="Line 36"/>
            <p:cNvSpPr/>
            <p:nvPr/>
          </p:nvSpPr>
          <p:spPr>
            <a:xfrm flipH="1" flipV="1">
              <a:off x="2509560" y="1193040"/>
              <a:ext cx="169920" cy="27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1" name="Line 51"/>
            <p:cNvSpPr/>
            <p:nvPr/>
          </p:nvSpPr>
          <p:spPr>
            <a:xfrm>
              <a:off x="3175560" y="1658160"/>
              <a:ext cx="292320" cy="157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2" name="Line 52"/>
            <p:cNvSpPr/>
            <p:nvPr/>
          </p:nvSpPr>
          <p:spPr>
            <a:xfrm flipH="1" flipV="1">
              <a:off x="3899880" y="1848600"/>
              <a:ext cx="169920" cy="27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3" name="Line 53"/>
            <p:cNvSpPr/>
            <p:nvPr/>
          </p:nvSpPr>
          <p:spPr>
            <a:xfrm flipV="1">
              <a:off x="3899880" y="2120040"/>
              <a:ext cx="169920" cy="27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4" name="Line 54"/>
            <p:cNvSpPr/>
            <p:nvPr/>
          </p:nvSpPr>
          <p:spPr>
            <a:xfrm flipH="1" flipV="1">
              <a:off x="3574800" y="1830600"/>
              <a:ext cx="324720" cy="18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5" name="Line 55"/>
            <p:cNvSpPr/>
            <p:nvPr/>
          </p:nvSpPr>
          <p:spPr>
            <a:xfrm>
              <a:off x="4069800" y="2120040"/>
              <a:ext cx="338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6" name="Line 56"/>
            <p:cNvSpPr/>
            <p:nvPr/>
          </p:nvSpPr>
          <p:spPr>
            <a:xfrm>
              <a:off x="3899880" y="2391480"/>
              <a:ext cx="238680" cy="22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7" name="Rectangle 57"/>
            <p:cNvSpPr/>
            <p:nvPr/>
          </p:nvSpPr>
          <p:spPr>
            <a:xfrm>
              <a:off x="3454200" y="174024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8" name="Rectangle 58"/>
            <p:cNvSpPr/>
            <p:nvPr/>
          </p:nvSpPr>
          <p:spPr>
            <a:xfrm>
              <a:off x="4431240" y="201312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9" name="Rectangle 59"/>
            <p:cNvSpPr/>
            <p:nvPr/>
          </p:nvSpPr>
          <p:spPr>
            <a:xfrm>
              <a:off x="4561920" y="2013120"/>
              <a:ext cx="136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0" name="Rectangle 60"/>
            <p:cNvSpPr/>
            <p:nvPr/>
          </p:nvSpPr>
          <p:spPr>
            <a:xfrm>
              <a:off x="4721040" y="2013120"/>
              <a:ext cx="67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141" name="Group 65"/>
            <p:cNvGrpSpPr/>
            <p:nvPr/>
          </p:nvGrpSpPr>
          <p:grpSpPr>
            <a:xfrm>
              <a:off x="4144320" y="2556000"/>
              <a:ext cx="358560" cy="182880"/>
              <a:chOff x="4144320" y="2556000"/>
              <a:chExt cx="358560" cy="182880"/>
            </a:xfrm>
          </p:grpSpPr>
          <p:sp>
            <p:nvSpPr>
              <p:cNvPr id="1142" name="Rectangle 61"/>
              <p:cNvSpPr/>
              <p:nvPr/>
            </p:nvSpPr>
            <p:spPr>
              <a:xfrm>
                <a:off x="4144320" y="2556000"/>
                <a:ext cx="110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O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3" name="Rectangle 62"/>
              <p:cNvSpPr/>
              <p:nvPr/>
            </p:nvSpPr>
            <p:spPr>
              <a:xfrm>
                <a:off x="4273200" y="2556000"/>
                <a:ext cx="136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M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4" name="Rectangle 63"/>
              <p:cNvSpPr/>
              <p:nvPr/>
            </p:nvSpPr>
            <p:spPr>
              <a:xfrm>
                <a:off x="4435200" y="2556000"/>
                <a:ext cx="67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145" name="Line 64"/>
            <p:cNvSpPr/>
            <p:nvPr/>
          </p:nvSpPr>
          <p:spPr>
            <a:xfrm flipV="1">
              <a:off x="3899880" y="1573920"/>
              <a:ext cx="169920" cy="27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146" name="Group 66"/>
            <p:cNvGrpSpPr/>
            <p:nvPr/>
          </p:nvGrpSpPr>
          <p:grpSpPr>
            <a:xfrm>
              <a:off x="4417200" y="1478160"/>
              <a:ext cx="358560" cy="182880"/>
              <a:chOff x="4417200" y="1478160"/>
              <a:chExt cx="358560" cy="182880"/>
            </a:xfrm>
          </p:grpSpPr>
          <p:sp>
            <p:nvSpPr>
              <p:cNvPr id="1147" name="Rectangle 67"/>
              <p:cNvSpPr/>
              <p:nvPr/>
            </p:nvSpPr>
            <p:spPr>
              <a:xfrm>
                <a:off x="4417200" y="1478160"/>
                <a:ext cx="110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O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8" name="Rectangle 68"/>
              <p:cNvSpPr/>
              <p:nvPr/>
            </p:nvSpPr>
            <p:spPr>
              <a:xfrm>
                <a:off x="4546440" y="1478160"/>
                <a:ext cx="136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M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9" name="Rectangle 69"/>
              <p:cNvSpPr/>
              <p:nvPr/>
            </p:nvSpPr>
            <p:spPr>
              <a:xfrm>
                <a:off x="4708080" y="1478160"/>
                <a:ext cx="67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150" name="Text Box 70"/>
            <p:cNvSpPr/>
            <p:nvPr/>
          </p:nvSpPr>
          <p:spPr>
            <a:xfrm>
              <a:off x="2953080" y="17233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1" name="Text Box 71"/>
            <p:cNvSpPr/>
            <p:nvPr/>
          </p:nvSpPr>
          <p:spPr>
            <a:xfrm>
              <a:off x="2351520" y="969120"/>
              <a:ext cx="74916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H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OM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2" name="Text Box 72"/>
            <p:cNvSpPr/>
            <p:nvPr/>
          </p:nvSpPr>
          <p:spPr>
            <a:xfrm>
              <a:off x="1984680" y="898920"/>
              <a:ext cx="49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Me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3" name="Text Box 73"/>
            <p:cNvSpPr/>
            <p:nvPr/>
          </p:nvSpPr>
          <p:spPr>
            <a:xfrm>
              <a:off x="1778400" y="1414800"/>
              <a:ext cx="49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Me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4" name="Text Box 74"/>
            <p:cNvSpPr/>
            <p:nvPr/>
          </p:nvSpPr>
          <p:spPr>
            <a:xfrm>
              <a:off x="3220920" y="2030040"/>
              <a:ext cx="47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=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5" name="Text Box 75"/>
            <p:cNvSpPr/>
            <p:nvPr/>
          </p:nvSpPr>
          <p:spPr>
            <a:xfrm>
              <a:off x="3233880" y="235512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6" name="Text Box 76"/>
            <p:cNvSpPr/>
            <p:nvPr/>
          </p:nvSpPr>
          <p:spPr>
            <a:xfrm>
              <a:off x="2670120" y="205236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7" name="Line 79"/>
            <p:cNvSpPr/>
            <p:nvPr/>
          </p:nvSpPr>
          <p:spPr>
            <a:xfrm flipH="1">
              <a:off x="2936880" y="1955880"/>
              <a:ext cx="108000" cy="191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8" name="Line 80"/>
            <p:cNvSpPr/>
            <p:nvPr/>
          </p:nvSpPr>
          <p:spPr>
            <a:xfrm>
              <a:off x="3139200" y="1944000"/>
              <a:ext cx="195120" cy="161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9" name="Line 81"/>
            <p:cNvSpPr/>
            <p:nvPr/>
          </p:nvSpPr>
          <p:spPr>
            <a:xfrm flipH="1" flipV="1">
              <a:off x="3372120" y="2246760"/>
              <a:ext cx="11160" cy="192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0" name="Line 83"/>
            <p:cNvSpPr/>
            <p:nvPr/>
          </p:nvSpPr>
          <p:spPr>
            <a:xfrm flipV="1">
              <a:off x="3749400" y="678960"/>
              <a:ext cx="0" cy="1341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1" name="Line 84"/>
            <p:cNvSpPr/>
            <p:nvPr/>
          </p:nvSpPr>
          <p:spPr>
            <a:xfrm flipV="1">
              <a:off x="3747960" y="339480"/>
              <a:ext cx="349920" cy="335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2" name="Line 87"/>
            <p:cNvSpPr/>
            <p:nvPr/>
          </p:nvSpPr>
          <p:spPr>
            <a:xfrm flipV="1">
              <a:off x="3362760" y="541800"/>
              <a:ext cx="0" cy="1341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3" name="Line 88"/>
            <p:cNvSpPr/>
            <p:nvPr/>
          </p:nvSpPr>
          <p:spPr>
            <a:xfrm flipH="1" flipV="1">
              <a:off x="3011400" y="202680"/>
              <a:ext cx="349920" cy="335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4" name="Text Box 89"/>
            <p:cNvSpPr/>
            <p:nvPr/>
          </p:nvSpPr>
          <p:spPr>
            <a:xfrm>
              <a:off x="2940120" y="502920"/>
              <a:ext cx="40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6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5" name="Text Box 90"/>
            <p:cNvSpPr/>
            <p:nvPr/>
          </p:nvSpPr>
          <p:spPr>
            <a:xfrm>
              <a:off x="3708000" y="648360"/>
              <a:ext cx="40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47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166" name="ZoneTexte 1131"/>
          <p:cNvSpPr/>
          <p:nvPr/>
        </p:nvSpPr>
        <p:spPr>
          <a:xfrm>
            <a:off x="1644480" y="2066760"/>
            <a:ext cx="881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 = 423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7" name="ZoneTexte 1132"/>
          <p:cNvSpPr/>
          <p:nvPr/>
        </p:nvSpPr>
        <p:spPr>
          <a:xfrm>
            <a:off x="5728320" y="3809880"/>
            <a:ext cx="73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[M + H]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8" name="ZoneTexte 1133"/>
          <p:cNvSpPr/>
          <p:nvPr/>
        </p:nvSpPr>
        <p:spPr>
          <a:xfrm>
            <a:off x="5757480" y="5553000"/>
            <a:ext cx="92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[M + NH4]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9" name="Line 55"/>
          <p:cNvSpPr/>
          <p:nvPr/>
        </p:nvSpPr>
        <p:spPr>
          <a:xfrm>
            <a:off x="4065480" y="1569960"/>
            <a:ext cx="338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0" name=""/>
          <p:cNvSpPr/>
          <p:nvPr/>
        </p:nvSpPr>
        <p:spPr>
          <a:xfrm>
            <a:off x="303840" y="290520"/>
            <a:ext cx="123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Times New Roman"/>
              </a:rPr>
              <a:t>Suppl. Fig. 4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7T14:37:38Z</dcterms:created>
  <dc:creator>Institut Pasteur</dc:creator>
  <dc:description/>
  <dc:language>en-US</dc:language>
  <cp:lastModifiedBy>Institut Pasteur</cp:lastModifiedBy>
  <dcterms:modified xsi:type="dcterms:W3CDTF">2011-09-08T07:25:43Z</dcterms:modified>
  <cp:revision>16</cp:revision>
  <dc:subject/>
  <dc:title>Diapositive 1</dc:title>
</cp:coreProperties>
</file>